
<file path=[Content_Types].xml><?xml version="1.0" encoding="utf-8"?>
<Types xmlns="http://schemas.openxmlformats.org/package/2006/content-types">
  <Default Extension="xml" ContentType="application/xml"/>
  <Default Extension="JPG" ContentType="image/jpeg"/>
  <Default Extension="tiff" ContentType="image/tiff"/>
  <Default Extension="jpeg" ContentType="image/jpeg"/>
  <Default Extension="rels" ContentType="application/vnd.openxmlformats-package.relationships+xml"/>
  <Default Extension="tif" ContentType="image/tiff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handoutMasterIdLst>
    <p:handoutMasterId r:id="rId8"/>
  </p:handoutMasterIdLst>
  <p:sldIdLst>
    <p:sldId id="269" r:id="rId2"/>
    <p:sldId id="277" r:id="rId3"/>
    <p:sldId id="265" r:id="rId4"/>
    <p:sldId id="279" r:id="rId5"/>
    <p:sldId id="273" r:id="rId6"/>
    <p:sldId id="274" r:id="rId7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snapVertSplitter="1" vertBarState="minimized" horzBarState="maximized">
    <p:restoredLeft sz="14681" autoAdjust="0"/>
    <p:restoredTop sz="94660"/>
  </p:normalViewPr>
  <p:slideViewPr>
    <p:cSldViewPr snapToGrid="0">
      <p:cViewPr>
        <p:scale>
          <a:sx n="75" d="100"/>
          <a:sy n="75" d="100"/>
        </p:scale>
        <p:origin x="-1360" y="-80"/>
      </p:cViewPr>
      <p:guideLst>
        <p:guide orient="horz" pos="2776"/>
        <p:guide pos="216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viewProps" Target="viewProps.xml"/><Relationship Id="rId12" Type="http://schemas.openxmlformats.org/officeDocument/2006/relationships/theme" Target="theme/theme1.xml"/><Relationship Id="rId13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handoutMaster" Target="handoutMasters/handoutMaster1.xml"/><Relationship Id="rId9" Type="http://schemas.openxmlformats.org/officeDocument/2006/relationships/printerSettings" Target="printerSettings/printerSettings1.bin"/><Relationship Id="rId10" Type="http://schemas.openxmlformats.org/officeDocument/2006/relationships/presProps" Target="pres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829DE40F-0B71-482A-8BFF-38D160771AFD}" type="doc">
      <dgm:prSet loTypeId="urn:microsoft.com/office/officeart/2005/8/layout/cycle1" loCatId="cycle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US"/>
        </a:p>
      </dgm:t>
    </dgm:pt>
    <dgm:pt modelId="{B195BA57-80AB-4DAF-BABE-EECD84C10BAC}">
      <dgm:prSet phldrT="[Text]" custT="1"/>
      <dgm:spPr/>
      <dgm:t>
        <a:bodyPr/>
        <a:lstStyle/>
        <a:p>
          <a:r>
            <a:rPr lang="en-US" sz="18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extract </a:t>
          </a:r>
          <a:r>
            <a:rPr lang="en-US" sz="1800" dirty="0" err="1" smtClean="0">
              <a:latin typeface="Times New Roman" panose="02020603050405020304" pitchFamily="18" charset="0"/>
              <a:cs typeface="Times New Roman" panose="02020603050405020304" pitchFamily="18" charset="0"/>
            </a:rPr>
            <a:t>gDNA</a:t>
          </a:r>
          <a:endParaRPr lang="en-US" sz="18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FB8525AE-F944-4F62-91BA-B71E4A9920F1}" type="parTrans" cxnId="{BFE00F47-BAF2-42A2-891A-11EF4E30EF44}">
      <dgm:prSet/>
      <dgm:spPr/>
      <dgm:t>
        <a:bodyPr/>
        <a:lstStyle/>
        <a:p>
          <a:endParaRPr lang="en-US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3CFA59DC-D5B9-48B6-A59E-F9BE7C14D192}" type="sibTrans" cxnId="{BFE00F47-BAF2-42A2-891A-11EF4E30EF44}">
      <dgm:prSet/>
      <dgm:spPr/>
      <dgm:t>
        <a:bodyPr/>
        <a:lstStyle/>
        <a:p>
          <a:endParaRPr lang="en-US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C912FCB4-C38A-4821-BCEE-914DB83C7D3A}">
      <dgm:prSet phldrT="[Text]" custT="1"/>
      <dgm:spPr/>
      <dgm:t>
        <a:bodyPr/>
        <a:lstStyle/>
        <a:p>
          <a:pPr algn="l"/>
          <a:r>
            <a:rPr lang="en-US" sz="18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amplify</a:t>
          </a:r>
          <a:r>
            <a:rPr lang="en-US" sz="16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</a:p>
        <a:p>
          <a:pPr algn="l"/>
          <a:r>
            <a:rPr lang="en-US" sz="16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target region</a:t>
          </a:r>
          <a:endParaRPr lang="en-US" sz="16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F3FEFC86-9779-4BFE-B737-6442763DDDB6}" type="parTrans" cxnId="{AD845657-8780-4A48-AEC9-263931D0FE67}">
      <dgm:prSet/>
      <dgm:spPr/>
      <dgm:t>
        <a:bodyPr/>
        <a:lstStyle/>
        <a:p>
          <a:endParaRPr lang="en-US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ED6F4A1C-C071-4789-9AD2-2FF507794EBD}" type="sibTrans" cxnId="{AD845657-8780-4A48-AEC9-263931D0FE67}">
      <dgm:prSet/>
      <dgm:spPr/>
      <dgm:t>
        <a:bodyPr/>
        <a:lstStyle/>
        <a:p>
          <a:endParaRPr lang="en-US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6FF2FD8C-5594-43CA-ABB9-FB40AF17F57C}">
      <dgm:prSet phldrT="[Text]" custT="1"/>
      <dgm:spPr/>
      <dgm:t>
        <a:bodyPr/>
        <a:lstStyle/>
        <a:p>
          <a:r>
            <a:rPr lang="en-US" sz="18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1</a:t>
          </a:r>
          <a:r>
            <a:rPr lang="en-US" sz="1800" baseline="300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st</a:t>
          </a:r>
          <a:r>
            <a:rPr lang="en-US" sz="18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 sequence PCR products</a:t>
          </a:r>
          <a:endParaRPr lang="en-US" sz="18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4B4732F9-10D6-46AD-85BB-B688005DB28E}" type="parTrans" cxnId="{A7B11573-36DD-49DE-A505-54E845071652}">
      <dgm:prSet/>
      <dgm:spPr/>
      <dgm:t>
        <a:bodyPr/>
        <a:lstStyle/>
        <a:p>
          <a:endParaRPr lang="en-US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693A0E74-2374-4DFC-B5D9-8ADF8F3CCBFA}" type="sibTrans" cxnId="{A7B11573-36DD-49DE-A505-54E845071652}">
      <dgm:prSet/>
      <dgm:spPr/>
      <dgm:t>
        <a:bodyPr/>
        <a:lstStyle/>
        <a:p>
          <a:endParaRPr lang="en-US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55432547-6A2D-4976-88F7-D2CD965D02EA}">
      <dgm:prSet phldrT="[Text]" custT="1"/>
      <dgm:spPr/>
      <dgm:t>
        <a:bodyPr/>
        <a:lstStyle/>
        <a:p>
          <a:r>
            <a:rPr lang="en-US" sz="18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re-amplify </a:t>
          </a:r>
          <a:r>
            <a:rPr lang="en-US" sz="16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target region</a:t>
          </a:r>
          <a:endParaRPr lang="en-US" sz="18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3EB36E1D-CBF6-4281-B059-2A9C6A6DF8DD}" type="parTrans" cxnId="{084BDCFE-AB65-4E76-B5D1-97E146321D72}">
      <dgm:prSet/>
      <dgm:spPr/>
      <dgm:t>
        <a:bodyPr/>
        <a:lstStyle/>
        <a:p>
          <a:endParaRPr lang="en-US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F3AA2BCF-B610-408C-9C58-34FE52A0D947}" type="sibTrans" cxnId="{084BDCFE-AB65-4E76-B5D1-97E146321D72}">
      <dgm:prSet/>
      <dgm:spPr/>
      <dgm:t>
        <a:bodyPr/>
        <a:lstStyle/>
        <a:p>
          <a:endParaRPr lang="en-US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688C78F4-69F8-40B3-9F91-CCADCF09DE0E}">
      <dgm:prSet phldrT="[Text]" custT="1"/>
      <dgm:spPr/>
      <dgm:t>
        <a:bodyPr/>
        <a:lstStyle/>
        <a:p>
          <a:r>
            <a:rPr lang="en-US" sz="18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clone into a TA cloning vector</a:t>
          </a:r>
          <a:endParaRPr lang="en-US" sz="18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D3B125AD-F6CE-4534-A318-F4622E3C1473}" type="parTrans" cxnId="{2F3327DC-ABB6-4FAF-8B89-8F93E2F8ADA4}">
      <dgm:prSet/>
      <dgm:spPr/>
      <dgm:t>
        <a:bodyPr/>
        <a:lstStyle/>
        <a:p>
          <a:endParaRPr lang="en-US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CEC20785-E9CE-4C49-B875-1B5FBEEC1271}" type="sibTrans" cxnId="{2F3327DC-ABB6-4FAF-8B89-8F93E2F8ADA4}">
      <dgm:prSet/>
      <dgm:spPr/>
      <dgm:t>
        <a:bodyPr/>
        <a:lstStyle/>
        <a:p>
          <a:endParaRPr lang="en-US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ED003100-C260-4C83-B41A-C285B0E5B909}">
      <dgm:prSet phldrT="[Text]" custT="1"/>
      <dgm:spPr/>
      <dgm:t>
        <a:bodyPr/>
        <a:lstStyle/>
        <a:p>
          <a:pPr algn="r"/>
          <a:r>
            <a:rPr lang="en-US" sz="18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2</a:t>
          </a:r>
          <a:r>
            <a:rPr lang="en-US" sz="1800" baseline="300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nd</a:t>
          </a:r>
          <a:r>
            <a:rPr lang="en-US" sz="18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 sequence plasmid DNA</a:t>
          </a:r>
          <a:endParaRPr lang="en-US" sz="18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FC71B348-83CB-458A-BAAD-D1544F69801E}" type="parTrans" cxnId="{03355EAA-1FB3-4455-9213-EBB325ED1994}">
      <dgm:prSet/>
      <dgm:spPr/>
      <dgm:t>
        <a:bodyPr/>
        <a:lstStyle/>
        <a:p>
          <a:endParaRPr lang="en-US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1C3475C8-2A2E-409B-8F83-E3C79101E344}" type="sibTrans" cxnId="{03355EAA-1FB3-4455-9213-EBB325ED1994}">
      <dgm:prSet/>
      <dgm:spPr/>
      <dgm:t>
        <a:bodyPr/>
        <a:lstStyle/>
        <a:p>
          <a:endParaRPr lang="en-US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53964EB1-5133-4805-9CD4-AFC5A93DF45A}">
      <dgm:prSet phldrT="[Text]"/>
      <dgm:spPr/>
      <dgm:t>
        <a:bodyPr/>
        <a:lstStyle/>
        <a:p>
          <a:endParaRPr lang="en-US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8A1D1DB6-3996-4F23-920D-59517B4327FA}" type="parTrans" cxnId="{9C7A59FF-324C-4AD3-8A36-B19520C918D3}">
      <dgm:prSet/>
      <dgm:spPr/>
      <dgm:t>
        <a:bodyPr/>
        <a:lstStyle/>
        <a:p>
          <a:endParaRPr lang="en-US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BAA585B9-9F9F-4D8C-8B14-BA5327B888BD}" type="sibTrans" cxnId="{9C7A59FF-324C-4AD3-8A36-B19520C918D3}">
      <dgm:prSet/>
      <dgm:spPr/>
      <dgm:t>
        <a:bodyPr/>
        <a:lstStyle/>
        <a:p>
          <a:endParaRPr lang="en-US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91A83D70-152C-48B8-8381-33E225FB96B4}" type="pres">
      <dgm:prSet presAssocID="{829DE40F-0B71-482A-8BFF-38D160771AFD}" presName="cycle" presStyleCnt="0">
        <dgm:presLayoutVars>
          <dgm:dir/>
          <dgm:resizeHandles val="exact"/>
        </dgm:presLayoutVars>
      </dgm:prSet>
      <dgm:spPr/>
      <dgm:t>
        <a:bodyPr/>
        <a:lstStyle/>
        <a:p>
          <a:endParaRPr lang="en-US"/>
        </a:p>
      </dgm:t>
    </dgm:pt>
    <dgm:pt modelId="{8B35330B-8A34-45F3-82FE-8CF151F00203}" type="pres">
      <dgm:prSet presAssocID="{B195BA57-80AB-4DAF-BABE-EECD84C10BAC}" presName="dummy" presStyleCnt="0"/>
      <dgm:spPr/>
    </dgm:pt>
    <dgm:pt modelId="{D8AF7D78-EF7B-4B4F-830F-EDA7A48E6988}" type="pres">
      <dgm:prSet presAssocID="{B195BA57-80AB-4DAF-BABE-EECD84C10BAC}" presName="node" presStyleLbl="revTx" presStyleIdx="0" presStyleCnt="7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E396E112-AD42-4402-906A-9BF8D9C1B5C3}" type="pres">
      <dgm:prSet presAssocID="{3CFA59DC-D5B9-48B6-A59E-F9BE7C14D192}" presName="sibTrans" presStyleLbl="node1" presStyleIdx="0" presStyleCnt="7"/>
      <dgm:spPr/>
      <dgm:t>
        <a:bodyPr/>
        <a:lstStyle/>
        <a:p>
          <a:endParaRPr lang="en-US"/>
        </a:p>
      </dgm:t>
    </dgm:pt>
    <dgm:pt modelId="{22546D3D-1984-4098-BAEC-4BCEFBB2B99A}" type="pres">
      <dgm:prSet presAssocID="{C912FCB4-C38A-4821-BCEE-914DB83C7D3A}" presName="dummy" presStyleCnt="0"/>
      <dgm:spPr/>
    </dgm:pt>
    <dgm:pt modelId="{85769088-2396-401B-8A59-900DA9B29D06}" type="pres">
      <dgm:prSet presAssocID="{C912FCB4-C38A-4821-BCEE-914DB83C7D3A}" presName="node" presStyleLbl="revTx" presStyleIdx="1" presStyleCnt="7" custScaleX="223575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9A27BE25-3115-4976-9402-055135CC2111}" type="pres">
      <dgm:prSet presAssocID="{ED6F4A1C-C071-4789-9AD2-2FF507794EBD}" presName="sibTrans" presStyleLbl="node1" presStyleIdx="1" presStyleCnt="7"/>
      <dgm:spPr/>
      <dgm:t>
        <a:bodyPr/>
        <a:lstStyle/>
        <a:p>
          <a:endParaRPr lang="en-US"/>
        </a:p>
      </dgm:t>
    </dgm:pt>
    <dgm:pt modelId="{75D2E842-4D95-4D57-AE0B-2C357AACFCC5}" type="pres">
      <dgm:prSet presAssocID="{6FF2FD8C-5594-43CA-ABB9-FB40AF17F57C}" presName="dummy" presStyleCnt="0"/>
      <dgm:spPr/>
    </dgm:pt>
    <dgm:pt modelId="{A0BA776B-AAAF-42BA-91E4-C797D2C31BC7}" type="pres">
      <dgm:prSet presAssocID="{6FF2FD8C-5594-43CA-ABB9-FB40AF17F57C}" presName="node" presStyleLbl="revTx" presStyleIdx="2" presStyleCnt="7" custScaleX="214796" custRadScaleRad="100109" custRadScaleInc="-15101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668F7DA1-54B4-4BB9-A8D7-2EA81B6CF9F1}" type="pres">
      <dgm:prSet presAssocID="{693A0E74-2374-4DFC-B5D9-8ADF8F3CCBFA}" presName="sibTrans" presStyleLbl="node1" presStyleIdx="2" presStyleCnt="7"/>
      <dgm:spPr/>
      <dgm:t>
        <a:bodyPr/>
        <a:lstStyle/>
        <a:p>
          <a:endParaRPr lang="en-US"/>
        </a:p>
      </dgm:t>
    </dgm:pt>
    <dgm:pt modelId="{3DA52A97-CC49-487D-8479-EB79F8216CA6}" type="pres">
      <dgm:prSet presAssocID="{55432547-6A2D-4976-88F7-D2CD965D02EA}" presName="dummy" presStyleCnt="0"/>
      <dgm:spPr/>
    </dgm:pt>
    <dgm:pt modelId="{77DDC04B-53F0-4ECC-83DD-B76AB267347B}" type="pres">
      <dgm:prSet presAssocID="{55432547-6A2D-4976-88F7-D2CD965D02EA}" presName="node" presStyleLbl="revTx" presStyleIdx="3" presStyleCnt="7" custScaleX="160175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091619CB-0FB6-49F6-9CBA-F9662C725438}" type="pres">
      <dgm:prSet presAssocID="{F3AA2BCF-B610-408C-9C58-34FE52A0D947}" presName="sibTrans" presStyleLbl="node1" presStyleIdx="3" presStyleCnt="7"/>
      <dgm:spPr/>
      <dgm:t>
        <a:bodyPr/>
        <a:lstStyle/>
        <a:p>
          <a:endParaRPr lang="en-US"/>
        </a:p>
      </dgm:t>
    </dgm:pt>
    <dgm:pt modelId="{30E9058E-96AE-4BFD-8D95-B5DB6C378F81}" type="pres">
      <dgm:prSet presAssocID="{688C78F4-69F8-40B3-9F91-CCADCF09DE0E}" presName="dummy" presStyleCnt="0"/>
      <dgm:spPr/>
    </dgm:pt>
    <dgm:pt modelId="{C80B09ED-79DA-464F-A0AB-00DC6E7C41B4}" type="pres">
      <dgm:prSet presAssocID="{688C78F4-69F8-40B3-9F91-CCADCF09DE0E}" presName="node" presStyleLbl="revTx" presStyleIdx="4" presStyleCnt="7" custScaleX="185047" custRadScaleRad="98554" custRadScaleInc="14220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A72F7A88-D928-4F1D-8BBC-C71C7E7D08E9}" type="pres">
      <dgm:prSet presAssocID="{CEC20785-E9CE-4C49-B875-1B5FBEEC1271}" presName="sibTrans" presStyleLbl="node1" presStyleIdx="4" presStyleCnt="7"/>
      <dgm:spPr/>
      <dgm:t>
        <a:bodyPr/>
        <a:lstStyle/>
        <a:p>
          <a:endParaRPr lang="en-US"/>
        </a:p>
      </dgm:t>
    </dgm:pt>
    <dgm:pt modelId="{F5764872-2EE0-428E-BEF2-81053217B8D9}" type="pres">
      <dgm:prSet presAssocID="{ED003100-C260-4C83-B41A-C285B0E5B909}" presName="dummy" presStyleCnt="0"/>
      <dgm:spPr/>
    </dgm:pt>
    <dgm:pt modelId="{2FBAA727-F079-496F-B72C-51EC63A1DD67}" type="pres">
      <dgm:prSet presAssocID="{ED003100-C260-4C83-B41A-C285B0E5B909}" presName="node" presStyleLbl="revTx" presStyleIdx="5" presStyleCnt="7" custScaleX="202562" custRadScaleRad="94915" custRadScaleInc="4096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C797E2E2-F610-4BE6-96E6-3FB2CA0FFEAA}" type="pres">
      <dgm:prSet presAssocID="{1C3475C8-2A2E-409B-8F83-E3C79101E344}" presName="sibTrans" presStyleLbl="node1" presStyleIdx="5" presStyleCnt="7"/>
      <dgm:spPr/>
      <dgm:t>
        <a:bodyPr/>
        <a:lstStyle/>
        <a:p>
          <a:endParaRPr lang="en-US"/>
        </a:p>
      </dgm:t>
    </dgm:pt>
    <dgm:pt modelId="{97261CE1-E3AA-409E-B812-23898E608A14}" type="pres">
      <dgm:prSet presAssocID="{53964EB1-5133-4805-9CD4-AFC5A93DF45A}" presName="dummy" presStyleCnt="0"/>
      <dgm:spPr/>
    </dgm:pt>
    <dgm:pt modelId="{A309CE42-A12B-4B19-BA66-4635B20889A3}" type="pres">
      <dgm:prSet presAssocID="{53964EB1-5133-4805-9CD4-AFC5A93DF45A}" presName="node" presStyleLbl="revTx" presStyleIdx="6" presStyleCnt="7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E572DE8C-C3B8-4502-B368-B71A8D5C2EB5}" type="pres">
      <dgm:prSet presAssocID="{BAA585B9-9F9F-4D8C-8B14-BA5327B888BD}" presName="sibTrans" presStyleLbl="node1" presStyleIdx="6" presStyleCnt="7"/>
      <dgm:spPr/>
      <dgm:t>
        <a:bodyPr/>
        <a:lstStyle/>
        <a:p>
          <a:endParaRPr lang="en-US"/>
        </a:p>
      </dgm:t>
    </dgm:pt>
  </dgm:ptLst>
  <dgm:cxnLst>
    <dgm:cxn modelId="{AE66E7C7-03BB-4B37-A191-23B7084E6F38}" type="presOf" srcId="{C912FCB4-C38A-4821-BCEE-914DB83C7D3A}" destId="{85769088-2396-401B-8A59-900DA9B29D06}" srcOrd="0" destOrd="0" presId="urn:microsoft.com/office/officeart/2005/8/layout/cycle1"/>
    <dgm:cxn modelId="{A7B11573-36DD-49DE-A505-54E845071652}" srcId="{829DE40F-0B71-482A-8BFF-38D160771AFD}" destId="{6FF2FD8C-5594-43CA-ABB9-FB40AF17F57C}" srcOrd="2" destOrd="0" parTransId="{4B4732F9-10D6-46AD-85BB-B688005DB28E}" sibTransId="{693A0E74-2374-4DFC-B5D9-8ADF8F3CCBFA}"/>
    <dgm:cxn modelId="{9C7A59FF-324C-4AD3-8A36-B19520C918D3}" srcId="{829DE40F-0B71-482A-8BFF-38D160771AFD}" destId="{53964EB1-5133-4805-9CD4-AFC5A93DF45A}" srcOrd="6" destOrd="0" parTransId="{8A1D1DB6-3996-4F23-920D-59517B4327FA}" sibTransId="{BAA585B9-9F9F-4D8C-8B14-BA5327B888BD}"/>
    <dgm:cxn modelId="{AD845657-8780-4A48-AEC9-263931D0FE67}" srcId="{829DE40F-0B71-482A-8BFF-38D160771AFD}" destId="{C912FCB4-C38A-4821-BCEE-914DB83C7D3A}" srcOrd="1" destOrd="0" parTransId="{F3FEFC86-9779-4BFE-B737-6442763DDDB6}" sibTransId="{ED6F4A1C-C071-4789-9AD2-2FF507794EBD}"/>
    <dgm:cxn modelId="{084BDCFE-AB65-4E76-B5D1-97E146321D72}" srcId="{829DE40F-0B71-482A-8BFF-38D160771AFD}" destId="{55432547-6A2D-4976-88F7-D2CD965D02EA}" srcOrd="3" destOrd="0" parTransId="{3EB36E1D-CBF6-4281-B059-2A9C6A6DF8DD}" sibTransId="{F3AA2BCF-B610-408C-9C58-34FE52A0D947}"/>
    <dgm:cxn modelId="{40D3910C-A7F8-45CD-9731-80ABA1C53E7C}" type="presOf" srcId="{BAA585B9-9F9F-4D8C-8B14-BA5327B888BD}" destId="{E572DE8C-C3B8-4502-B368-B71A8D5C2EB5}" srcOrd="0" destOrd="0" presId="urn:microsoft.com/office/officeart/2005/8/layout/cycle1"/>
    <dgm:cxn modelId="{BFE00F47-BAF2-42A2-891A-11EF4E30EF44}" srcId="{829DE40F-0B71-482A-8BFF-38D160771AFD}" destId="{B195BA57-80AB-4DAF-BABE-EECD84C10BAC}" srcOrd="0" destOrd="0" parTransId="{FB8525AE-F944-4F62-91BA-B71E4A9920F1}" sibTransId="{3CFA59DC-D5B9-48B6-A59E-F9BE7C14D192}"/>
    <dgm:cxn modelId="{F581A496-FE59-462E-A41E-75B68A369C46}" type="presOf" srcId="{829DE40F-0B71-482A-8BFF-38D160771AFD}" destId="{91A83D70-152C-48B8-8381-33E225FB96B4}" srcOrd="0" destOrd="0" presId="urn:microsoft.com/office/officeart/2005/8/layout/cycle1"/>
    <dgm:cxn modelId="{AF780DE3-539D-4F06-AB52-6C3076961F23}" type="presOf" srcId="{53964EB1-5133-4805-9CD4-AFC5A93DF45A}" destId="{A309CE42-A12B-4B19-BA66-4635B20889A3}" srcOrd="0" destOrd="0" presId="urn:microsoft.com/office/officeart/2005/8/layout/cycle1"/>
    <dgm:cxn modelId="{2F3327DC-ABB6-4FAF-8B89-8F93E2F8ADA4}" srcId="{829DE40F-0B71-482A-8BFF-38D160771AFD}" destId="{688C78F4-69F8-40B3-9F91-CCADCF09DE0E}" srcOrd="4" destOrd="0" parTransId="{D3B125AD-F6CE-4534-A318-F4622E3C1473}" sibTransId="{CEC20785-E9CE-4C49-B875-1B5FBEEC1271}"/>
    <dgm:cxn modelId="{7151BBF1-79FB-4447-BCB6-80876B0555E5}" type="presOf" srcId="{693A0E74-2374-4DFC-B5D9-8ADF8F3CCBFA}" destId="{668F7DA1-54B4-4BB9-A8D7-2EA81B6CF9F1}" srcOrd="0" destOrd="0" presId="urn:microsoft.com/office/officeart/2005/8/layout/cycle1"/>
    <dgm:cxn modelId="{0ABD9F07-D111-4407-B732-082664A5BE53}" type="presOf" srcId="{6FF2FD8C-5594-43CA-ABB9-FB40AF17F57C}" destId="{A0BA776B-AAAF-42BA-91E4-C797D2C31BC7}" srcOrd="0" destOrd="0" presId="urn:microsoft.com/office/officeart/2005/8/layout/cycle1"/>
    <dgm:cxn modelId="{099B8655-DA21-45BA-AF34-F2A35266D494}" type="presOf" srcId="{F3AA2BCF-B610-408C-9C58-34FE52A0D947}" destId="{091619CB-0FB6-49F6-9CBA-F9662C725438}" srcOrd="0" destOrd="0" presId="urn:microsoft.com/office/officeart/2005/8/layout/cycle1"/>
    <dgm:cxn modelId="{063E8B67-05A5-4131-8BE2-6D39F631C5C3}" type="presOf" srcId="{3CFA59DC-D5B9-48B6-A59E-F9BE7C14D192}" destId="{E396E112-AD42-4402-906A-9BF8D9C1B5C3}" srcOrd="0" destOrd="0" presId="urn:microsoft.com/office/officeart/2005/8/layout/cycle1"/>
    <dgm:cxn modelId="{654B1CF6-68FC-4FC9-A56D-7B7F5209F521}" type="presOf" srcId="{ED003100-C260-4C83-B41A-C285B0E5B909}" destId="{2FBAA727-F079-496F-B72C-51EC63A1DD67}" srcOrd="0" destOrd="0" presId="urn:microsoft.com/office/officeart/2005/8/layout/cycle1"/>
    <dgm:cxn modelId="{1FADDC99-BF0F-465A-9EA6-4396BB9666B6}" type="presOf" srcId="{55432547-6A2D-4976-88F7-D2CD965D02EA}" destId="{77DDC04B-53F0-4ECC-83DD-B76AB267347B}" srcOrd="0" destOrd="0" presId="urn:microsoft.com/office/officeart/2005/8/layout/cycle1"/>
    <dgm:cxn modelId="{0277AF34-DD8D-417B-8A18-BCF9282EF4BE}" type="presOf" srcId="{688C78F4-69F8-40B3-9F91-CCADCF09DE0E}" destId="{C80B09ED-79DA-464F-A0AB-00DC6E7C41B4}" srcOrd="0" destOrd="0" presId="urn:microsoft.com/office/officeart/2005/8/layout/cycle1"/>
    <dgm:cxn modelId="{65D85643-9165-4190-B271-D5E76A003F29}" type="presOf" srcId="{CEC20785-E9CE-4C49-B875-1B5FBEEC1271}" destId="{A72F7A88-D928-4F1D-8BBC-C71C7E7D08E9}" srcOrd="0" destOrd="0" presId="urn:microsoft.com/office/officeart/2005/8/layout/cycle1"/>
    <dgm:cxn modelId="{4378FAA6-9375-4B1A-9DB4-5A7C7F38AD24}" type="presOf" srcId="{B195BA57-80AB-4DAF-BABE-EECD84C10BAC}" destId="{D8AF7D78-EF7B-4B4F-830F-EDA7A48E6988}" srcOrd="0" destOrd="0" presId="urn:microsoft.com/office/officeart/2005/8/layout/cycle1"/>
    <dgm:cxn modelId="{7C821AB2-4E97-4BD4-B6E2-C7D727C644D2}" type="presOf" srcId="{ED6F4A1C-C071-4789-9AD2-2FF507794EBD}" destId="{9A27BE25-3115-4976-9402-055135CC2111}" srcOrd="0" destOrd="0" presId="urn:microsoft.com/office/officeart/2005/8/layout/cycle1"/>
    <dgm:cxn modelId="{03355EAA-1FB3-4455-9213-EBB325ED1994}" srcId="{829DE40F-0B71-482A-8BFF-38D160771AFD}" destId="{ED003100-C260-4C83-B41A-C285B0E5B909}" srcOrd="5" destOrd="0" parTransId="{FC71B348-83CB-458A-BAAD-D1544F69801E}" sibTransId="{1C3475C8-2A2E-409B-8F83-E3C79101E344}"/>
    <dgm:cxn modelId="{50171D2E-0BF7-4916-A5CC-303CE2B4AADB}" type="presOf" srcId="{1C3475C8-2A2E-409B-8F83-E3C79101E344}" destId="{C797E2E2-F610-4BE6-96E6-3FB2CA0FFEAA}" srcOrd="0" destOrd="0" presId="urn:microsoft.com/office/officeart/2005/8/layout/cycle1"/>
    <dgm:cxn modelId="{30637EFF-1C50-4414-B61E-3106ED3F2472}" type="presParOf" srcId="{91A83D70-152C-48B8-8381-33E225FB96B4}" destId="{8B35330B-8A34-45F3-82FE-8CF151F00203}" srcOrd="0" destOrd="0" presId="urn:microsoft.com/office/officeart/2005/8/layout/cycle1"/>
    <dgm:cxn modelId="{14167ADE-1232-47FB-B2D7-B1FD51B596BA}" type="presParOf" srcId="{91A83D70-152C-48B8-8381-33E225FB96B4}" destId="{D8AF7D78-EF7B-4B4F-830F-EDA7A48E6988}" srcOrd="1" destOrd="0" presId="urn:microsoft.com/office/officeart/2005/8/layout/cycle1"/>
    <dgm:cxn modelId="{34896628-6CD2-43C1-8172-57B21BB2BB80}" type="presParOf" srcId="{91A83D70-152C-48B8-8381-33E225FB96B4}" destId="{E396E112-AD42-4402-906A-9BF8D9C1B5C3}" srcOrd="2" destOrd="0" presId="urn:microsoft.com/office/officeart/2005/8/layout/cycle1"/>
    <dgm:cxn modelId="{0D7C359E-686C-4474-AB7B-2F930AF8FB61}" type="presParOf" srcId="{91A83D70-152C-48B8-8381-33E225FB96B4}" destId="{22546D3D-1984-4098-BAEC-4BCEFBB2B99A}" srcOrd="3" destOrd="0" presId="urn:microsoft.com/office/officeart/2005/8/layout/cycle1"/>
    <dgm:cxn modelId="{88679C8D-A91D-458F-8720-CFD8C9CF5FCC}" type="presParOf" srcId="{91A83D70-152C-48B8-8381-33E225FB96B4}" destId="{85769088-2396-401B-8A59-900DA9B29D06}" srcOrd="4" destOrd="0" presId="urn:microsoft.com/office/officeart/2005/8/layout/cycle1"/>
    <dgm:cxn modelId="{7DBEEA87-B3DF-4854-86F1-70E30218CB03}" type="presParOf" srcId="{91A83D70-152C-48B8-8381-33E225FB96B4}" destId="{9A27BE25-3115-4976-9402-055135CC2111}" srcOrd="5" destOrd="0" presId="urn:microsoft.com/office/officeart/2005/8/layout/cycle1"/>
    <dgm:cxn modelId="{582B39F1-F5C3-4972-8B76-E023D8B3651F}" type="presParOf" srcId="{91A83D70-152C-48B8-8381-33E225FB96B4}" destId="{75D2E842-4D95-4D57-AE0B-2C357AACFCC5}" srcOrd="6" destOrd="0" presId="urn:microsoft.com/office/officeart/2005/8/layout/cycle1"/>
    <dgm:cxn modelId="{6915624D-187C-4991-A13E-A1C424A69867}" type="presParOf" srcId="{91A83D70-152C-48B8-8381-33E225FB96B4}" destId="{A0BA776B-AAAF-42BA-91E4-C797D2C31BC7}" srcOrd="7" destOrd="0" presId="urn:microsoft.com/office/officeart/2005/8/layout/cycle1"/>
    <dgm:cxn modelId="{FDCC9253-B427-4B4F-B1F9-FA74B760EAFA}" type="presParOf" srcId="{91A83D70-152C-48B8-8381-33E225FB96B4}" destId="{668F7DA1-54B4-4BB9-A8D7-2EA81B6CF9F1}" srcOrd="8" destOrd="0" presId="urn:microsoft.com/office/officeart/2005/8/layout/cycle1"/>
    <dgm:cxn modelId="{F534F861-17E5-4189-A649-8CA719BE32BF}" type="presParOf" srcId="{91A83D70-152C-48B8-8381-33E225FB96B4}" destId="{3DA52A97-CC49-487D-8479-EB79F8216CA6}" srcOrd="9" destOrd="0" presId="urn:microsoft.com/office/officeart/2005/8/layout/cycle1"/>
    <dgm:cxn modelId="{60D4FA58-0F50-4B72-8C71-D08FE2A3AA17}" type="presParOf" srcId="{91A83D70-152C-48B8-8381-33E225FB96B4}" destId="{77DDC04B-53F0-4ECC-83DD-B76AB267347B}" srcOrd="10" destOrd="0" presId="urn:microsoft.com/office/officeart/2005/8/layout/cycle1"/>
    <dgm:cxn modelId="{CF545CAC-D525-45D9-A83F-2E8F61B1E55A}" type="presParOf" srcId="{91A83D70-152C-48B8-8381-33E225FB96B4}" destId="{091619CB-0FB6-49F6-9CBA-F9662C725438}" srcOrd="11" destOrd="0" presId="urn:microsoft.com/office/officeart/2005/8/layout/cycle1"/>
    <dgm:cxn modelId="{34812F8F-E83F-41A6-9537-381D75C0F307}" type="presParOf" srcId="{91A83D70-152C-48B8-8381-33E225FB96B4}" destId="{30E9058E-96AE-4BFD-8D95-B5DB6C378F81}" srcOrd="12" destOrd="0" presId="urn:microsoft.com/office/officeart/2005/8/layout/cycle1"/>
    <dgm:cxn modelId="{79734840-809C-43A8-9675-2560344E6561}" type="presParOf" srcId="{91A83D70-152C-48B8-8381-33E225FB96B4}" destId="{C80B09ED-79DA-464F-A0AB-00DC6E7C41B4}" srcOrd="13" destOrd="0" presId="urn:microsoft.com/office/officeart/2005/8/layout/cycle1"/>
    <dgm:cxn modelId="{998FF235-734F-4573-99FC-4EEC126BD6EE}" type="presParOf" srcId="{91A83D70-152C-48B8-8381-33E225FB96B4}" destId="{A72F7A88-D928-4F1D-8BBC-C71C7E7D08E9}" srcOrd="14" destOrd="0" presId="urn:microsoft.com/office/officeart/2005/8/layout/cycle1"/>
    <dgm:cxn modelId="{9129BCC3-F3AF-42B7-A472-D07A11B26718}" type="presParOf" srcId="{91A83D70-152C-48B8-8381-33E225FB96B4}" destId="{F5764872-2EE0-428E-BEF2-81053217B8D9}" srcOrd="15" destOrd="0" presId="urn:microsoft.com/office/officeart/2005/8/layout/cycle1"/>
    <dgm:cxn modelId="{27D890D7-6B89-4A0F-BCD1-B433DC8C89C9}" type="presParOf" srcId="{91A83D70-152C-48B8-8381-33E225FB96B4}" destId="{2FBAA727-F079-496F-B72C-51EC63A1DD67}" srcOrd="16" destOrd="0" presId="urn:microsoft.com/office/officeart/2005/8/layout/cycle1"/>
    <dgm:cxn modelId="{6E383D9B-FE0B-4F41-B8FB-14718AAA8D8D}" type="presParOf" srcId="{91A83D70-152C-48B8-8381-33E225FB96B4}" destId="{C797E2E2-F610-4BE6-96E6-3FB2CA0FFEAA}" srcOrd="17" destOrd="0" presId="urn:microsoft.com/office/officeart/2005/8/layout/cycle1"/>
    <dgm:cxn modelId="{55118DA1-DEED-43DC-9EE0-770FCCE2938F}" type="presParOf" srcId="{91A83D70-152C-48B8-8381-33E225FB96B4}" destId="{97261CE1-E3AA-409E-B812-23898E608A14}" srcOrd="18" destOrd="0" presId="urn:microsoft.com/office/officeart/2005/8/layout/cycle1"/>
    <dgm:cxn modelId="{5F821C9A-E807-40AF-AEF8-F3C3975ACEB3}" type="presParOf" srcId="{91A83D70-152C-48B8-8381-33E225FB96B4}" destId="{A309CE42-A12B-4B19-BA66-4635B20889A3}" srcOrd="19" destOrd="0" presId="urn:microsoft.com/office/officeart/2005/8/layout/cycle1"/>
    <dgm:cxn modelId="{B27F6E64-8AAF-4F71-8B3D-5B575AD7A5B7}" type="presParOf" srcId="{91A83D70-152C-48B8-8381-33E225FB96B4}" destId="{E572DE8C-C3B8-4502-B368-B71A8D5C2EB5}" srcOrd="20" destOrd="0" presId="urn:microsoft.com/office/officeart/2005/8/layout/cycle1"/>
  </dgm:cxnLst>
  <dgm:bg/>
  <dgm:whole/>
  <dgm:extLst>
    <a:ext uri="http://schemas.microsoft.com/office/drawing/2008/diagram">
      <dsp:dataModelExt xmlns:dsp="http://schemas.microsoft.com/office/drawing/2008/diagram" relId="rId8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D8AF7D78-EF7B-4B4F-830F-EDA7A48E6988}">
      <dsp:nvSpPr>
        <dsp:cNvPr id="0" name=""/>
        <dsp:cNvSpPr/>
      </dsp:nvSpPr>
      <dsp:spPr>
        <a:xfrm>
          <a:off x="3602892" y="1236"/>
          <a:ext cx="734616" cy="734616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22860" tIns="22860" rIns="22860" bIns="22860" numCol="1" spcCol="1270" anchor="ctr" anchorCtr="0">
          <a:noAutofit/>
        </a:bodyPr>
        <a:lstStyle/>
        <a:p>
          <a:pPr lvl="0" algn="ctr" defTabSz="8001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800" kern="12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extract </a:t>
          </a:r>
          <a:r>
            <a:rPr lang="en-US" sz="1800" kern="1200" dirty="0" err="1" smtClean="0">
              <a:latin typeface="Times New Roman" panose="02020603050405020304" pitchFamily="18" charset="0"/>
              <a:cs typeface="Times New Roman" panose="02020603050405020304" pitchFamily="18" charset="0"/>
            </a:rPr>
            <a:t>gDNA</a:t>
          </a:r>
          <a:endParaRPr lang="en-US" sz="1800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3602892" y="1236"/>
        <a:ext cx="734616" cy="734616"/>
      </dsp:txXfrm>
    </dsp:sp>
    <dsp:sp modelId="{E396E112-AD42-4402-906A-9BF8D9C1B5C3}">
      <dsp:nvSpPr>
        <dsp:cNvPr id="0" name=""/>
        <dsp:cNvSpPr/>
      </dsp:nvSpPr>
      <dsp:spPr>
        <a:xfrm>
          <a:off x="1305554" y="40041"/>
          <a:ext cx="3810601" cy="3810601"/>
        </a:xfrm>
        <a:prstGeom prst="circularArrow">
          <a:avLst>
            <a:gd name="adj1" fmla="val 3759"/>
            <a:gd name="adj2" fmla="val 234534"/>
            <a:gd name="adj3" fmla="val 19828277"/>
            <a:gd name="adj4" fmla="val 18604368"/>
            <a:gd name="adj5" fmla="val 4386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85769088-2396-401B-8A59-900DA9B29D06}">
      <dsp:nvSpPr>
        <dsp:cNvPr id="0" name=""/>
        <dsp:cNvSpPr/>
      </dsp:nvSpPr>
      <dsp:spPr>
        <a:xfrm>
          <a:off x="4095880" y="1188597"/>
          <a:ext cx="1642417" cy="734616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22860" tIns="22860" rIns="22860" bIns="22860" numCol="1" spcCol="1270" anchor="ctr" anchorCtr="0">
          <a:noAutofit/>
        </a:bodyPr>
        <a:lstStyle/>
        <a:p>
          <a:pPr lvl="0" algn="l" defTabSz="8001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800" kern="12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amplify</a:t>
          </a:r>
          <a:r>
            <a:rPr lang="en-US" sz="1600" kern="12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</a:p>
        <a:p>
          <a:pPr lvl="0" algn="l" defTabSz="8001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600" kern="12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target region</a:t>
          </a:r>
          <a:endParaRPr lang="en-US" sz="1600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4095880" y="1188597"/>
        <a:ext cx="1642417" cy="734616"/>
      </dsp:txXfrm>
    </dsp:sp>
    <dsp:sp modelId="{9A27BE25-3115-4976-9402-055135CC2111}">
      <dsp:nvSpPr>
        <dsp:cNvPr id="0" name=""/>
        <dsp:cNvSpPr/>
      </dsp:nvSpPr>
      <dsp:spPr>
        <a:xfrm>
          <a:off x="1305623" y="44936"/>
          <a:ext cx="3810601" cy="3810601"/>
        </a:xfrm>
        <a:prstGeom prst="circularArrow">
          <a:avLst>
            <a:gd name="adj1" fmla="val 3759"/>
            <a:gd name="adj2" fmla="val 234534"/>
            <a:gd name="adj3" fmla="val 1088807"/>
            <a:gd name="adj4" fmla="val 21546915"/>
            <a:gd name="adj5" fmla="val 4386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A0BA776B-AAAF-42BA-91E4-C797D2C31BC7}">
      <dsp:nvSpPr>
        <dsp:cNvPr id="0" name=""/>
        <dsp:cNvSpPr/>
      </dsp:nvSpPr>
      <dsp:spPr>
        <a:xfrm>
          <a:off x="3839618" y="2607417"/>
          <a:ext cx="1577925" cy="734616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22860" tIns="22860" rIns="22860" bIns="22860" numCol="1" spcCol="1270" anchor="ctr" anchorCtr="0">
          <a:noAutofit/>
        </a:bodyPr>
        <a:lstStyle/>
        <a:p>
          <a:pPr lvl="0" algn="ctr" defTabSz="8001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800" kern="12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1</a:t>
          </a:r>
          <a:r>
            <a:rPr lang="en-US" sz="1800" kern="1200" baseline="300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st</a:t>
          </a:r>
          <a:r>
            <a:rPr lang="en-US" sz="1800" kern="12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 sequence PCR products</a:t>
          </a:r>
          <a:endParaRPr lang="en-US" sz="1800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3839618" y="2607417"/>
        <a:ext cx="1577925" cy="734616"/>
      </dsp:txXfrm>
    </dsp:sp>
    <dsp:sp modelId="{668F7DA1-54B4-4BB9-A8D7-2EA81B6CF9F1}">
      <dsp:nvSpPr>
        <dsp:cNvPr id="0" name=""/>
        <dsp:cNvSpPr/>
      </dsp:nvSpPr>
      <dsp:spPr>
        <a:xfrm>
          <a:off x="1311533" y="37919"/>
          <a:ext cx="3810601" cy="3810601"/>
        </a:xfrm>
        <a:prstGeom prst="circularArrow">
          <a:avLst>
            <a:gd name="adj1" fmla="val 3759"/>
            <a:gd name="adj2" fmla="val 234534"/>
            <a:gd name="adj3" fmla="val 3999306"/>
            <a:gd name="adj4" fmla="val 3183629"/>
            <a:gd name="adj5" fmla="val 4386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77DDC04B-53F0-4ECC-83DD-B76AB267347B}">
      <dsp:nvSpPr>
        <dsp:cNvPr id="0" name=""/>
        <dsp:cNvSpPr/>
      </dsp:nvSpPr>
      <dsp:spPr>
        <a:xfrm>
          <a:off x="2622519" y="3328147"/>
          <a:ext cx="1176671" cy="734616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22860" tIns="22860" rIns="22860" bIns="22860" numCol="1" spcCol="1270" anchor="ctr" anchorCtr="0">
          <a:noAutofit/>
        </a:bodyPr>
        <a:lstStyle/>
        <a:p>
          <a:pPr lvl="0" algn="ctr" defTabSz="8001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800" kern="12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re-amplify </a:t>
          </a:r>
          <a:r>
            <a:rPr lang="en-US" sz="1600" kern="12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target region</a:t>
          </a:r>
          <a:endParaRPr lang="en-US" sz="1800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2622519" y="3328147"/>
        <a:ext cx="1176671" cy="734616"/>
      </dsp:txXfrm>
    </dsp:sp>
    <dsp:sp modelId="{091619CB-0FB6-49F6-9CBA-F9662C725438}">
      <dsp:nvSpPr>
        <dsp:cNvPr id="0" name=""/>
        <dsp:cNvSpPr/>
      </dsp:nvSpPr>
      <dsp:spPr>
        <a:xfrm>
          <a:off x="1386659" y="71282"/>
          <a:ext cx="3810601" cy="3810601"/>
        </a:xfrm>
        <a:prstGeom prst="circularArrow">
          <a:avLst>
            <a:gd name="adj1" fmla="val 3759"/>
            <a:gd name="adj2" fmla="val 234534"/>
            <a:gd name="adj3" fmla="val 7527098"/>
            <a:gd name="adj4" fmla="val 6749366"/>
            <a:gd name="adj5" fmla="val 4386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C80B09ED-79DA-464F-A0AB-00DC6E7C41B4}">
      <dsp:nvSpPr>
        <dsp:cNvPr id="0" name=""/>
        <dsp:cNvSpPr/>
      </dsp:nvSpPr>
      <dsp:spPr>
        <a:xfrm>
          <a:off x="1138134" y="2595103"/>
          <a:ext cx="1359385" cy="734616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22860" tIns="22860" rIns="22860" bIns="22860" numCol="1" spcCol="1270" anchor="ctr" anchorCtr="0">
          <a:noAutofit/>
        </a:bodyPr>
        <a:lstStyle/>
        <a:p>
          <a:pPr lvl="0" algn="ctr" defTabSz="8001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800" kern="12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clone into a TA cloning vector</a:t>
          </a:r>
          <a:endParaRPr lang="en-US" sz="1800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1138134" y="2595103"/>
        <a:ext cx="1359385" cy="734616"/>
      </dsp:txXfrm>
    </dsp:sp>
    <dsp:sp modelId="{A72F7A88-D928-4F1D-8BBC-C71C7E7D08E9}">
      <dsp:nvSpPr>
        <dsp:cNvPr id="0" name=""/>
        <dsp:cNvSpPr/>
      </dsp:nvSpPr>
      <dsp:spPr>
        <a:xfrm>
          <a:off x="1385918" y="192945"/>
          <a:ext cx="3810601" cy="3810601"/>
        </a:xfrm>
        <a:prstGeom prst="circularArrow">
          <a:avLst>
            <a:gd name="adj1" fmla="val 3759"/>
            <a:gd name="adj2" fmla="val 234534"/>
            <a:gd name="adj3" fmla="val 10909890"/>
            <a:gd name="adj4" fmla="val 9810413"/>
            <a:gd name="adj5" fmla="val 4386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2FBAA727-F079-496F-B72C-51EC63A1DD67}">
      <dsp:nvSpPr>
        <dsp:cNvPr id="0" name=""/>
        <dsp:cNvSpPr/>
      </dsp:nvSpPr>
      <dsp:spPr>
        <a:xfrm>
          <a:off x="852007" y="1188581"/>
          <a:ext cx="1488053" cy="734616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22860" tIns="22860" rIns="22860" bIns="22860" numCol="1" spcCol="1270" anchor="ctr" anchorCtr="0">
          <a:noAutofit/>
        </a:bodyPr>
        <a:lstStyle/>
        <a:p>
          <a:pPr lvl="0" algn="r" defTabSz="8001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800" kern="12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2</a:t>
          </a:r>
          <a:r>
            <a:rPr lang="en-US" sz="1800" kern="1200" baseline="300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nd</a:t>
          </a:r>
          <a:r>
            <a:rPr lang="en-US" sz="1800" kern="12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 sequence plasmid DNA</a:t>
          </a:r>
          <a:endParaRPr lang="en-US" sz="1800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852007" y="1188581"/>
        <a:ext cx="1488053" cy="734616"/>
      </dsp:txXfrm>
    </dsp:sp>
    <dsp:sp modelId="{C797E2E2-F610-4BE6-96E6-3FB2CA0FFEAA}">
      <dsp:nvSpPr>
        <dsp:cNvPr id="0" name=""/>
        <dsp:cNvSpPr/>
      </dsp:nvSpPr>
      <dsp:spPr>
        <a:xfrm>
          <a:off x="1472040" y="-119919"/>
          <a:ext cx="3810601" cy="3810601"/>
        </a:xfrm>
        <a:prstGeom prst="circularArrow">
          <a:avLst>
            <a:gd name="adj1" fmla="val 3759"/>
            <a:gd name="adj2" fmla="val 234534"/>
            <a:gd name="adj3" fmla="val 13107252"/>
            <a:gd name="adj4" fmla="val 11996292"/>
            <a:gd name="adj5" fmla="val 4386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A309CE42-A12B-4B19-BA66-4635B20889A3}">
      <dsp:nvSpPr>
        <dsp:cNvPr id="0" name=""/>
        <dsp:cNvSpPr/>
      </dsp:nvSpPr>
      <dsp:spPr>
        <a:xfrm>
          <a:off x="2084201" y="1236"/>
          <a:ext cx="734616" cy="734616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55880" tIns="55880" rIns="55880" bIns="55880" numCol="1" spcCol="1270" anchor="ctr" anchorCtr="0">
          <a:noAutofit/>
        </a:bodyPr>
        <a:lstStyle/>
        <a:p>
          <a:pPr lvl="0" algn="ctr" defTabSz="19558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4400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2084201" y="1236"/>
        <a:ext cx="734616" cy="734616"/>
      </dsp:txXfrm>
    </dsp:sp>
    <dsp:sp modelId="{E572DE8C-C3B8-4502-B368-B71A8D5C2EB5}">
      <dsp:nvSpPr>
        <dsp:cNvPr id="0" name=""/>
        <dsp:cNvSpPr/>
      </dsp:nvSpPr>
      <dsp:spPr>
        <a:xfrm>
          <a:off x="1305554" y="40041"/>
          <a:ext cx="3810601" cy="3810601"/>
        </a:xfrm>
        <a:prstGeom prst="circularArrow">
          <a:avLst>
            <a:gd name="adj1" fmla="val 3759"/>
            <a:gd name="adj2" fmla="val 234534"/>
            <a:gd name="adj3" fmla="val 16742136"/>
            <a:gd name="adj4" fmla="val 15423330"/>
            <a:gd name="adj5" fmla="val 4386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cycle1">
  <dgm:title val=""/>
  <dgm:desc val=""/>
  <dgm:catLst>
    <dgm:cat type="cycle" pri="2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3">
          <dgm:prSet phldr="1"/>
        </dgm:pt>
        <dgm:pt modelId="4">
          <dgm:prSet phldr="1"/>
        </dgm:pt>
        <dgm:pt modelId="5">
          <dgm:prSet phldr="1"/>
        </dgm:pt>
      </dgm:ptLst>
      <dgm:cxnLst>
        <dgm:cxn modelId="6" srcId="0" destId="1" srcOrd="0" destOrd="0"/>
        <dgm:cxn modelId="7" srcId="0" destId="2" srcOrd="1" destOrd="0"/>
        <dgm:cxn modelId="8" srcId="0" destId="3" srcOrd="2" destOrd="0"/>
        <dgm:cxn modelId="9" srcId="0" destId="4" srcOrd="3" destOrd="0"/>
        <dgm:cxn modelId="10" srcId="0" destId="5" srcOrd="4" destOrd="0"/>
      </dgm:cxnLst>
      <dgm:bg/>
      <dgm:whole/>
    </dgm:dataModel>
  </dgm:sampData>
  <dgm:styleData>
    <dgm:dataModel>
      <dgm:ptLst>
        <dgm:pt modelId="0" type="doc"/>
        <dgm:pt modelId="1"/>
        <dgm:pt modelId="2"/>
        <dgm:pt modelId="3"/>
      </dgm:ptLst>
      <dgm:cxnLst>
        <dgm:cxn modelId="4" srcId="0" destId="1" srcOrd="0" destOrd="0"/>
        <dgm:cxn modelId="5" srcId="0" destId="2" srcOrd="1" destOrd="0"/>
        <dgm:cxn modelId="6" srcId="0" destId="3" srcOrd="2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  <dgm:pt modelId="5"/>
        <dgm:pt modelId="6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  <dgm:cxn modelId="11" srcId="0" destId="5" srcOrd="4" destOrd="0"/>
        <dgm:cxn modelId="12" srcId="0" destId="6" srcOrd="5" destOrd="0"/>
      </dgm:cxnLst>
      <dgm:bg/>
      <dgm:whole/>
    </dgm:dataModel>
  </dgm:clrData>
  <dgm:layoutNode name="cycle">
    <dgm:varLst>
      <dgm:dir/>
      <dgm:resizeHandles val="exact"/>
    </dgm:varLst>
    <dgm:choose name="Name0">
      <dgm:if name="Name1" func="var" arg="dir" op="equ" val="norm">
        <dgm:alg type="cycle">
          <dgm:param type="stAng" val="0"/>
          <dgm:param type="spanAng" val="360"/>
        </dgm:alg>
      </dgm:if>
      <dgm:else name="Name2">
        <dgm:alg type="cycle">
          <dgm:param type="stAng" val="0"/>
          <dgm:param type="spanAng" val="-360"/>
        </dgm:alg>
      </dgm:else>
    </dgm:choose>
    <dgm:shape xmlns:r="http://schemas.openxmlformats.org/officeDocument/2006/relationships" r:blip="">
      <dgm:adjLst/>
    </dgm:shape>
    <dgm:presOf/>
    <dgm:choose name="Name3">
      <dgm:if name="Name4" func="var" arg="dir" op="equ" val="norm">
        <dgm:constrLst>
          <dgm:constr type="diam" val="1"/>
          <dgm:constr type="w" for="ch" forName="node" refType="w"/>
          <dgm:constr type="w" for="ch" ptType="sibTrans" refType="w" refFor="ch" refForName="node" fact="0.5"/>
          <dgm:constr type="h" for="ch" ptType="sibTrans" op="equ"/>
          <dgm:constr type="diam" for="ch" ptType="sibTrans" refType="diam" op="equ"/>
          <dgm:constr type="sibSp" refType="w" refFor="ch" refForName="node" fact="0.15"/>
          <dgm:constr type="w" for="ch" forName="dummy" refType="sibSp" fact="2.8"/>
          <dgm:constr type="primFontSz" for="ch" forName="node" op="equ" val="65"/>
        </dgm:constrLst>
      </dgm:if>
      <dgm:else name="Name5">
        <dgm:constrLst>
          <dgm:constr type="diam" val="1"/>
          <dgm:constr type="w" for="ch" forName="node" refType="w"/>
          <dgm:constr type="w" for="ch" ptType="sibTrans" refType="w" refFor="ch" refForName="node" fact="0.5"/>
          <dgm:constr type="h" for="ch" ptType="sibTrans" op="equ"/>
          <dgm:constr type="diam" for="ch" ptType="sibTrans" refType="diam" op="equ" fact="-1"/>
          <dgm:constr type="sibSp" refType="w" refFor="ch" refForName="node" fact="0.15"/>
          <dgm:constr type="w" for="ch" forName="dummy" refType="sibSp" fact="2.8"/>
          <dgm:constr type="primFontSz" for="ch" forName="node" op="equ" val="65"/>
        </dgm:constrLst>
      </dgm:else>
    </dgm:choose>
    <dgm:ruleLst>
      <dgm:rule type="diam" val="INF" fact="NaN" max="NaN"/>
    </dgm:ruleLst>
    <dgm:forEach name="nodesForEach" axis="ch" ptType="node">
      <dgm:choose name="Name6">
        <dgm:if name="Name7" axis="par ch" ptType="doc node" func="cnt" op="gt" val="1">
          <dgm:layoutNode name="dummy">
            <dgm:alg type="sp"/>
            <dgm:shape xmlns:r="http://schemas.openxmlformats.org/officeDocument/2006/relationships" r:blip="">
              <dgm:adjLst/>
            </dgm:shape>
            <dgm:presOf/>
            <dgm:constrLst>
              <dgm:constr type="h" refType="w"/>
            </dgm:constrLst>
            <dgm:ruleLst/>
          </dgm:layoutNode>
        </dgm:if>
        <dgm:else name="Name8"/>
      </dgm:choose>
      <dgm:layoutNode name="node" styleLbl="revTx">
        <dgm:varLst>
          <dgm:bulletEnabled val="1"/>
        </dgm:varLst>
        <dgm:alg type="tx">
          <dgm:param type="txAnchorVertCh" val="mid"/>
        </dgm:alg>
        <dgm:shape xmlns:r="http://schemas.openxmlformats.org/officeDocument/2006/relationships" type="rect" r:blip="">
          <dgm:adjLst/>
        </dgm:shape>
        <dgm:presOf axis="desOrSelf" ptType="node"/>
        <dgm:constrLst>
          <dgm:constr type="h" refType="w"/>
          <dgm:constr type="lMarg" refType="primFontSz" fact="0.1"/>
          <dgm:constr type="rMarg" refType="primFontSz" fact="0.1"/>
          <dgm:constr type="tMarg" refType="primFontSz" fact="0.1"/>
          <dgm:constr type="bMarg" refType="primFontSz" fact="0.1"/>
        </dgm:constrLst>
        <dgm:ruleLst>
          <dgm:rule type="primFontSz" val="5" fact="NaN" max="NaN"/>
        </dgm:ruleLst>
      </dgm:layoutNode>
      <dgm:choose name="Name9">
        <dgm:if name="Name10" axis="par ch" ptType="doc node" func="cnt" op="gt" val="1">
          <dgm:forEach name="Name11" axis="followSib" ptType="sibTrans" hideLastTrans="0" cnt="1">
            <dgm:layoutNode name="sibTrans" styleLbl="node1">
              <dgm:alg type="conn">
                <dgm:param type="connRout" val="curve"/>
                <dgm:param type="begPts" val="radial"/>
                <dgm:param type="endPts" val="radial"/>
              </dgm:alg>
              <dgm:shape xmlns:r="http://schemas.openxmlformats.org/officeDocument/2006/relationships" type="conn" r:blip="">
                <dgm:adjLst/>
              </dgm:shape>
              <dgm:presOf axis="self"/>
              <dgm:constrLst>
                <dgm:constr type="h" refType="w" fact="0.65"/>
                <dgm:constr type="begPad"/>
                <dgm:constr type="endPad"/>
              </dgm:constrLst>
              <dgm:ruleLst/>
            </dgm:layoutNode>
          </dgm:forEach>
        </dgm:if>
        <dgm:else name="Name12"/>
      </dgm:choose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49862" y="1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7BB2D31-3981-424C-849F-C2CFD1EF4056}" type="datetimeFigureOut">
              <a:rPr lang="en-US" smtClean="0"/>
              <a:t>6/13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8273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49862" y="9428273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C8351D7-3514-49D3-9647-83BB60F62D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651521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E65CD-9895-4203-96C5-5FC51E850358}" type="datetimeFigureOut">
              <a:rPr lang="en-US" smtClean="0"/>
              <a:t>6/1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18BF6-84F4-4229-9549-1496DD2DD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58067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E65CD-9895-4203-96C5-5FC51E850358}" type="datetimeFigureOut">
              <a:rPr lang="en-US" smtClean="0"/>
              <a:t>6/1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18BF6-84F4-4229-9549-1496DD2DD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30829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E65CD-9895-4203-96C5-5FC51E850358}" type="datetimeFigureOut">
              <a:rPr lang="en-US" smtClean="0"/>
              <a:t>6/1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18BF6-84F4-4229-9549-1496DD2DD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3685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E65CD-9895-4203-96C5-5FC51E850358}" type="datetimeFigureOut">
              <a:rPr lang="en-US" smtClean="0"/>
              <a:t>6/1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18BF6-84F4-4229-9549-1496DD2DD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0391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E65CD-9895-4203-96C5-5FC51E850358}" type="datetimeFigureOut">
              <a:rPr lang="en-US" smtClean="0"/>
              <a:t>6/1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18BF6-84F4-4229-9549-1496DD2DD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80377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E65CD-9895-4203-96C5-5FC51E850358}" type="datetimeFigureOut">
              <a:rPr lang="en-US" smtClean="0"/>
              <a:t>6/1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18BF6-84F4-4229-9549-1496DD2DD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02331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E65CD-9895-4203-96C5-5FC51E850358}" type="datetimeFigureOut">
              <a:rPr lang="en-US" smtClean="0"/>
              <a:t>6/13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18BF6-84F4-4229-9549-1496DD2DD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09816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E65CD-9895-4203-96C5-5FC51E850358}" type="datetimeFigureOut">
              <a:rPr lang="en-US" smtClean="0"/>
              <a:t>6/13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18BF6-84F4-4229-9549-1496DD2DD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94014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E65CD-9895-4203-96C5-5FC51E850358}" type="datetimeFigureOut">
              <a:rPr lang="en-US" smtClean="0"/>
              <a:t>6/13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18BF6-84F4-4229-9549-1496DD2DD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57457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E65CD-9895-4203-96C5-5FC51E850358}" type="datetimeFigureOut">
              <a:rPr lang="en-US" smtClean="0"/>
              <a:t>6/1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18BF6-84F4-4229-9549-1496DD2DD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10652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E65CD-9895-4203-96C5-5FC51E850358}" type="datetimeFigureOut">
              <a:rPr lang="en-US" smtClean="0"/>
              <a:t>6/1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18BF6-84F4-4229-9549-1496DD2DD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42090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BE65CD-9895-4203-96C5-5FC51E850358}" type="datetimeFigureOut">
              <a:rPr lang="en-US" smtClean="0"/>
              <a:t>6/1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618BF6-84F4-4229-9549-1496DD2DD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33684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.ti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11" Type="http://schemas.openxmlformats.org/officeDocument/2006/relationships/image" Target="../media/image8.tiff"/><Relationship Id="rId12" Type="http://schemas.openxmlformats.org/officeDocument/2006/relationships/image" Target="../media/image9.png"/><Relationship Id="rId13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.png"/><Relationship Id="rId3" Type="http://schemas.openxmlformats.org/officeDocument/2006/relationships/image" Target="../media/image5.png"/><Relationship Id="rId4" Type="http://schemas.openxmlformats.org/officeDocument/2006/relationships/diagramData" Target="../diagrams/data1.xml"/><Relationship Id="rId5" Type="http://schemas.openxmlformats.org/officeDocument/2006/relationships/diagramLayout" Target="../diagrams/layout1.xml"/><Relationship Id="rId6" Type="http://schemas.openxmlformats.org/officeDocument/2006/relationships/diagramQuickStyle" Target="../diagrams/quickStyle1.xml"/><Relationship Id="rId7" Type="http://schemas.openxmlformats.org/officeDocument/2006/relationships/diagramColors" Target="../diagrams/colors1.xml"/><Relationship Id="rId8" Type="http://schemas.microsoft.com/office/2007/relationships/diagramDrawing" Target="../diagrams/drawing1.xml"/><Relationship Id="rId9" Type="http://schemas.openxmlformats.org/officeDocument/2006/relationships/image" Target="../media/image6.png"/><Relationship Id="rId10" Type="http://schemas.openxmlformats.org/officeDocument/2006/relationships/image" Target="../media/image7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G"/><Relationship Id="rId4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1.JP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Box 23"/>
          <p:cNvSpPr txBox="1"/>
          <p:nvPr/>
        </p:nvSpPr>
        <p:spPr>
          <a:xfrm>
            <a:off x="288838" y="7394449"/>
            <a:ext cx="653209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</a:t>
            </a:r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le </a:t>
            </a:r>
            <a:r>
              <a:rPr lang="en-US" altLang="ko-KR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: Figure S1.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rotein sequence alignment between Pv4CL3a (Pavir.Da00296) and Pv4CL3b (Pavir.Db00533). </a:t>
            </a:r>
            <a:r>
              <a:rPr lang="en-US" sz="16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YSSGTTGMPKGV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MP- binding motif, </a:t>
            </a:r>
            <a:r>
              <a:rPr lang="en-US" sz="16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ICIRGR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otif, </a:t>
            </a:r>
            <a:r>
              <a:rPr lang="en-US" sz="16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PP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6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PL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otifs are in red boxes. </a:t>
            </a:r>
            <a:endParaRPr lang="en-US" sz="1600" dirty="0">
              <a:latin typeface="Times New Roman" panose="02020603050405020304" pitchFamily="18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grpSp>
        <p:nvGrpSpPr>
          <p:cNvPr id="29" name="Group 28"/>
          <p:cNvGrpSpPr/>
          <p:nvPr/>
        </p:nvGrpSpPr>
        <p:grpSpPr>
          <a:xfrm>
            <a:off x="292431" y="1824369"/>
            <a:ext cx="6166751" cy="5186337"/>
            <a:chOff x="292431" y="2343355"/>
            <a:chExt cx="6166751" cy="5186337"/>
          </a:xfrm>
        </p:grpSpPr>
        <p:grpSp>
          <p:nvGrpSpPr>
            <p:cNvPr id="23" name="Group 22"/>
            <p:cNvGrpSpPr/>
            <p:nvPr/>
          </p:nvGrpSpPr>
          <p:grpSpPr>
            <a:xfrm>
              <a:off x="292431" y="2343355"/>
              <a:ext cx="6166751" cy="5186337"/>
              <a:chOff x="453072" y="2343355"/>
              <a:chExt cx="6166751" cy="5186337"/>
            </a:xfrm>
          </p:grpSpPr>
          <p:pic>
            <p:nvPicPr>
              <p:cNvPr id="2" name="Picture 1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202003" y="2355712"/>
                <a:ext cx="5417820" cy="5173980"/>
              </a:xfrm>
              <a:prstGeom prst="rect">
                <a:avLst/>
              </a:prstGeom>
            </p:spPr>
          </p:pic>
          <p:sp>
            <p:nvSpPr>
              <p:cNvPr id="3" name="TextBox 2"/>
              <p:cNvSpPr txBox="1"/>
              <p:nvPr/>
            </p:nvSpPr>
            <p:spPr>
              <a:xfrm>
                <a:off x="453072" y="2343355"/>
                <a:ext cx="97618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/>
                  <a:t>Pv4CL3a</a:t>
                </a:r>
                <a:endParaRPr lang="en-US" sz="1400" dirty="0"/>
              </a:p>
            </p:txBody>
          </p:sp>
          <p:sp>
            <p:nvSpPr>
              <p:cNvPr id="4" name="TextBox 3"/>
              <p:cNvSpPr txBox="1"/>
              <p:nvPr/>
            </p:nvSpPr>
            <p:spPr>
              <a:xfrm>
                <a:off x="453072" y="2557540"/>
                <a:ext cx="97618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/>
                  <a:t>Pv4CL3b</a:t>
                </a:r>
                <a:endParaRPr lang="en-US" sz="1400" dirty="0"/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>
                <a:off x="453072" y="2854106"/>
                <a:ext cx="97618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/>
                  <a:t>Pv4CL3a</a:t>
                </a:r>
                <a:endParaRPr lang="en-US" sz="1400" dirty="0"/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453072" y="3068291"/>
                <a:ext cx="97618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/>
                  <a:t>Pv4CL3b</a:t>
                </a:r>
                <a:endParaRPr lang="en-US" sz="1400" dirty="0"/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453072" y="3385450"/>
                <a:ext cx="97618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/>
                  <a:t>Pv4CL3a</a:t>
                </a:r>
                <a:endParaRPr lang="en-US" sz="1400" dirty="0"/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453072" y="3599635"/>
                <a:ext cx="97618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/>
                  <a:t>Pv4CL3b</a:t>
                </a:r>
                <a:endParaRPr lang="en-US" sz="1400" dirty="0"/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453072" y="3896201"/>
                <a:ext cx="97618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/>
                  <a:t>Pv4CL3a</a:t>
                </a:r>
                <a:endParaRPr lang="en-US" sz="1400" dirty="0"/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453072" y="4110386"/>
                <a:ext cx="97618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/>
                  <a:t>Pv4CL3b</a:t>
                </a:r>
                <a:endParaRPr lang="en-US" sz="1400" dirty="0"/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453072" y="4398698"/>
                <a:ext cx="97618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/>
                  <a:t>Pv4CL3a</a:t>
                </a:r>
                <a:endParaRPr lang="en-US" sz="1400" dirty="0"/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453072" y="4612883"/>
                <a:ext cx="97618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/>
                  <a:t>Pv4CL3b</a:t>
                </a:r>
                <a:endParaRPr lang="en-US" sz="1400" dirty="0"/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453072" y="4909449"/>
                <a:ext cx="97618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/>
                  <a:t>Pv4CL3a</a:t>
                </a:r>
                <a:endParaRPr lang="en-US" sz="1400" dirty="0"/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453072" y="5123634"/>
                <a:ext cx="97618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/>
                  <a:t>Pv4CL3b</a:t>
                </a:r>
                <a:endParaRPr lang="en-US" sz="1400" dirty="0"/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453072" y="5440793"/>
                <a:ext cx="97618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/>
                  <a:t>Pv4CL3a</a:t>
                </a:r>
                <a:endParaRPr lang="en-US" sz="1400" dirty="0"/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453072" y="5654978"/>
                <a:ext cx="97618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/>
                  <a:t>Pv4CL3b</a:t>
                </a:r>
                <a:endParaRPr lang="en-US" sz="1400" dirty="0"/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453072" y="5951544"/>
                <a:ext cx="97618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/>
                  <a:t>Pv4CL3a</a:t>
                </a:r>
                <a:endParaRPr lang="en-US" sz="1400" dirty="0"/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453072" y="6165729"/>
                <a:ext cx="97618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/>
                  <a:t>Pv4CL3b</a:t>
                </a:r>
                <a:endParaRPr lang="en-US" sz="1400" dirty="0"/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453072" y="6458172"/>
                <a:ext cx="97618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/>
                  <a:t>Pv4CL3a</a:t>
                </a:r>
                <a:endParaRPr lang="en-US" sz="1400" dirty="0"/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453072" y="6672357"/>
                <a:ext cx="97618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/>
                  <a:t>Pv4CL3b</a:t>
                </a:r>
                <a:endParaRPr lang="en-US" sz="1400" dirty="0"/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453072" y="6968923"/>
                <a:ext cx="97618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/>
                  <a:t>Pv4CL3a</a:t>
                </a:r>
                <a:endParaRPr lang="en-US" sz="1400" dirty="0"/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453072" y="7183108"/>
                <a:ext cx="97618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/>
                  <a:t>Pv4CL3b</a:t>
                </a:r>
                <a:endParaRPr lang="en-US" sz="1400" dirty="0"/>
              </a:p>
            </p:txBody>
          </p:sp>
        </p:grpSp>
        <p:sp>
          <p:nvSpPr>
            <p:cNvPr id="25" name="Rectangle 24"/>
            <p:cNvSpPr/>
            <p:nvPr/>
          </p:nvSpPr>
          <p:spPr>
            <a:xfrm>
              <a:off x="2063578" y="3956840"/>
              <a:ext cx="976184" cy="36576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" name="Rectangle 25"/>
            <p:cNvSpPr/>
            <p:nvPr/>
          </p:nvSpPr>
          <p:spPr>
            <a:xfrm>
              <a:off x="3476372" y="5517922"/>
              <a:ext cx="603504" cy="36576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" name="Rectangle 26"/>
            <p:cNvSpPr/>
            <p:nvPr/>
          </p:nvSpPr>
          <p:spPr>
            <a:xfrm>
              <a:off x="4580245" y="4484068"/>
              <a:ext cx="246888" cy="36576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" name="Rectangle 27"/>
            <p:cNvSpPr/>
            <p:nvPr/>
          </p:nvSpPr>
          <p:spPr>
            <a:xfrm>
              <a:off x="4522576" y="4994818"/>
              <a:ext cx="246888" cy="36576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354887327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0496" y="1693027"/>
            <a:ext cx="5327904" cy="240792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511174" y="4495800"/>
            <a:ext cx="58356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dentities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ong Pv4CL1 and its 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omologous proteins.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7751523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0" name="Group 39"/>
          <p:cNvGrpSpPr/>
          <p:nvPr/>
        </p:nvGrpSpPr>
        <p:grpSpPr>
          <a:xfrm rot="16200000">
            <a:off x="-1098661" y="3843469"/>
            <a:ext cx="8857396" cy="1743666"/>
            <a:chOff x="-1152389" y="2856094"/>
            <a:chExt cx="8857396" cy="1743666"/>
          </a:xfrm>
        </p:grpSpPr>
        <p:pic>
          <p:nvPicPr>
            <p:cNvPr id="2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91" t="35967" r="55062" b="46821"/>
            <a:stretch/>
          </p:blipFill>
          <p:spPr bwMode="auto">
            <a:xfrm>
              <a:off x="-73398" y="3126127"/>
              <a:ext cx="7778405" cy="1458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" name="Rectangle 2"/>
            <p:cNvSpPr/>
            <p:nvPr/>
          </p:nvSpPr>
          <p:spPr>
            <a:xfrm>
              <a:off x="3837187" y="3527850"/>
              <a:ext cx="1524000" cy="9951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-1150136" y="3424176"/>
              <a:ext cx="1143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v4CL1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-1150136" y="3585145"/>
              <a:ext cx="1143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v4CL2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-1150136" y="3102238"/>
              <a:ext cx="1143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v4CL3a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-1150136" y="3263207"/>
              <a:ext cx="1143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v4CL3b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-1152389" y="4161792"/>
              <a:ext cx="1143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v4CL1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-1152389" y="4322761"/>
              <a:ext cx="1143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v4CL2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-1152389" y="3839854"/>
              <a:ext cx="1143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v4CL3a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-1152389" y="4000823"/>
              <a:ext cx="1143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v4CL3b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Rectangle 11"/>
            <p:cNvSpPr/>
            <p:nvPr/>
          </p:nvSpPr>
          <p:spPr>
            <a:xfrm>
              <a:off x="5361187" y="3527849"/>
              <a:ext cx="202020" cy="99511"/>
            </a:xfrm>
            <a:prstGeom prst="rect">
              <a:avLst/>
            </a:prstGeom>
            <a:noFill/>
            <a:ln>
              <a:solidFill>
                <a:srgbClr val="00B0F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5199108" y="2919028"/>
              <a:ext cx="78156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AM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3777285" y="2856094"/>
              <a:ext cx="137624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target site </a:t>
              </a:r>
              <a:endParaRPr lang="en-US" dirty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6" name="TextBox 35"/>
          <p:cNvSpPr txBox="1"/>
          <p:nvPr/>
        </p:nvSpPr>
        <p:spPr>
          <a:xfrm rot="16200000">
            <a:off x="1419334" y="4019201"/>
            <a:ext cx="7783159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rget region in the coding sequence of Pv4CL1s by CRISPR/Cas9. a) Blue letters: a target site; dark red letters: SNPs. b) Pv4CL1 (Pavir.Fa01395), Pv4CL2 (Pavir.J20148), Pv4CL3a (Pavir.Da00296) and Pv4CL3b (Pavir.Db00533) coding sequences were from Panicum virgatum v1.1. Red box: target site of Pv4CL1. Blue box: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ospacer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djacent motif (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M)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en-US" sz="1600" dirty="0">
              <a:latin typeface="Times New Roman" panose="02020603050405020304" pitchFamily="18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grpSp>
        <p:nvGrpSpPr>
          <p:cNvPr id="19" name="Group 18"/>
          <p:cNvGrpSpPr/>
          <p:nvPr/>
        </p:nvGrpSpPr>
        <p:grpSpPr>
          <a:xfrm>
            <a:off x="1044892" y="224613"/>
            <a:ext cx="427450" cy="7827882"/>
            <a:chOff x="1044892" y="224613"/>
            <a:chExt cx="427450" cy="7827882"/>
          </a:xfrm>
        </p:grpSpPr>
        <p:sp>
          <p:nvSpPr>
            <p:cNvPr id="17" name="Rectangle 16"/>
            <p:cNvSpPr/>
            <p:nvPr/>
          </p:nvSpPr>
          <p:spPr>
            <a:xfrm rot="16200000">
              <a:off x="-2740439" y="4013248"/>
              <a:ext cx="7824578" cy="25391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50" b="1" dirty="0">
                  <a:latin typeface="Calibri" panose="020F050202020403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 </a:t>
              </a:r>
              <a:r>
                <a:rPr lang="en-US" sz="1000" b="1" dirty="0">
                  <a:latin typeface="Calibri" panose="020F050202020403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· · · · </a:t>
              </a:r>
              <a:r>
                <a:rPr lang="en-US" sz="1000" b="1" dirty="0" smtClean="0">
                  <a:latin typeface="Calibri" panose="020F050202020403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A</a:t>
              </a:r>
              <a:r>
                <a:rPr lang="en-US" sz="1000" b="1" dirty="0">
                  <a:latin typeface="Calibri" panose="020F050202020403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 </a:t>
              </a:r>
              <a:r>
                <a:rPr lang="en-US" sz="900" b="1" dirty="0">
                  <a:latin typeface="Calibri" panose="020F050202020403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· · · · · · · · · · · · · · · · · · · · · · · · · · · · · · · </a:t>
              </a:r>
              <a:r>
                <a:rPr lang="en-US" sz="1000" b="1" dirty="0" smtClean="0">
                  <a:latin typeface="Calibri" panose="020F050202020403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T</a:t>
              </a:r>
              <a:r>
                <a:rPr lang="en-US" sz="900" b="1" dirty="0">
                  <a:latin typeface="Calibri" panose="020F050202020403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 · · · · · · </a:t>
              </a:r>
              <a:r>
                <a:rPr lang="en-US" sz="900" dirty="0" smtClean="0">
                  <a:latin typeface="Calibri" panose="020F050202020403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TGGGCGCGGCGCG</a:t>
              </a:r>
              <a:r>
                <a:rPr lang="en-US" sz="1000" b="1" dirty="0" smtClean="0">
                  <a:solidFill>
                    <a:srgbClr val="00B0F0"/>
                  </a:solidFill>
                  <a:latin typeface="Calibri" panose="020F050202020403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GCTGGGCGCCGCCACCACCA</a:t>
              </a:r>
              <a:r>
                <a:rPr lang="en-US" sz="900" dirty="0" smtClean="0">
                  <a:solidFill>
                    <a:srgbClr val="FF0000"/>
                  </a:solidFill>
                  <a:latin typeface="Calibri" panose="020F050202020403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CGG</a:t>
              </a:r>
              <a:r>
                <a:rPr lang="en-US" sz="900" dirty="0" smtClean="0">
                  <a:latin typeface="Calibri" panose="020F050202020403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CGAACCCGTT</a:t>
              </a:r>
              <a:r>
                <a:rPr lang="en-US" sz="900" b="1" dirty="0">
                  <a:latin typeface="Calibri" panose="020F050202020403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 · · · · · · </a:t>
              </a:r>
              <a:r>
                <a:rPr lang="en-US" sz="1000" b="1" dirty="0" smtClean="0">
                  <a:latin typeface="Calibri" panose="020F050202020403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C</a:t>
              </a:r>
              <a:r>
                <a:rPr lang="en-US" sz="900" b="1" dirty="0" smtClean="0">
                  <a:latin typeface="Calibri" panose="020F050202020403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 </a:t>
              </a:r>
              <a:r>
                <a:rPr lang="en-US" sz="900" b="1" dirty="0">
                  <a:latin typeface="Calibri" panose="020F050202020403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· · · · · · · · · · · · · · · · · · · · </a:t>
              </a:r>
              <a:r>
                <a:rPr lang="en-US" sz="1000" b="1" dirty="0" smtClean="0">
                  <a:latin typeface="Calibri" panose="020F050202020403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G </a:t>
              </a:r>
              <a:r>
                <a:rPr lang="en-US" sz="900" b="1" dirty="0" smtClean="0">
                  <a:latin typeface="Calibri" panose="020F050202020403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· ·</a:t>
              </a:r>
              <a:r>
                <a:rPr lang="en-US" sz="900" b="1" dirty="0">
                  <a:latin typeface="Calibri" panose="020F050202020403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 · · </a:t>
              </a:r>
              <a:endParaRPr lang="en-US" sz="900" dirty="0"/>
            </a:p>
          </p:txBody>
        </p:sp>
        <p:sp>
          <p:nvSpPr>
            <p:cNvPr id="18" name="Rectangle 17"/>
            <p:cNvSpPr/>
            <p:nvPr/>
          </p:nvSpPr>
          <p:spPr>
            <a:xfrm rot="16200000">
              <a:off x="-2560653" y="4011387"/>
              <a:ext cx="7819769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900" b="1" dirty="0">
                  <a:latin typeface="Calibri" panose="020F050202020403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 · · · · </a:t>
              </a:r>
              <a:r>
                <a:rPr lang="en-US" sz="1000" b="1" dirty="0" smtClean="0">
                  <a:solidFill>
                    <a:srgbClr val="C00000"/>
                  </a:solidFill>
                  <a:latin typeface="Calibri" panose="020F050202020403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G</a:t>
              </a:r>
              <a:r>
                <a:rPr lang="en-US" sz="900" b="1" dirty="0">
                  <a:latin typeface="Calibri" panose="020F050202020403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 · · · · · · · · · · · · · · · · · · · · · · · · · · · · · · · </a:t>
              </a:r>
              <a:r>
                <a:rPr lang="en-US" sz="1000" b="1" dirty="0" smtClean="0">
                  <a:solidFill>
                    <a:srgbClr val="C00000"/>
                  </a:solidFill>
                  <a:latin typeface="Calibri" panose="020F050202020403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G</a:t>
              </a:r>
              <a:r>
                <a:rPr lang="en-US" sz="900" b="1" dirty="0">
                  <a:latin typeface="Calibri" panose="020F050202020403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 · · · · · · </a:t>
              </a:r>
              <a:r>
                <a:rPr lang="en-US" sz="900" dirty="0" smtClean="0">
                  <a:latin typeface="Calibri" panose="020F050202020403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TGGGCGCGGCGCG</a:t>
              </a:r>
              <a:r>
                <a:rPr lang="en-US" sz="1000" b="1" dirty="0" smtClean="0">
                  <a:solidFill>
                    <a:srgbClr val="00B0F0"/>
                  </a:solidFill>
                  <a:latin typeface="Calibri" panose="020F050202020403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GCTGGGCGCCGCCACCACCA</a:t>
              </a:r>
              <a:r>
                <a:rPr lang="en-US" sz="900" dirty="0" smtClean="0">
                  <a:solidFill>
                    <a:srgbClr val="FF0000"/>
                  </a:solidFill>
                  <a:latin typeface="Calibri" panose="020F050202020403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CGG</a:t>
              </a:r>
              <a:r>
                <a:rPr lang="en-US" sz="900" dirty="0" smtClean="0">
                  <a:latin typeface="Calibri" panose="020F050202020403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CGAACCCGTT</a:t>
              </a:r>
              <a:r>
                <a:rPr lang="en-US" sz="900" b="1" dirty="0">
                  <a:latin typeface="Calibri" panose="020F050202020403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 · · · · · · </a:t>
              </a:r>
              <a:r>
                <a:rPr lang="en-US" sz="1000" b="1" dirty="0" smtClean="0">
                  <a:solidFill>
                    <a:srgbClr val="C00000"/>
                  </a:solidFill>
                  <a:latin typeface="Calibri" panose="020F050202020403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G</a:t>
              </a:r>
              <a:r>
                <a:rPr lang="en-US" sz="900" b="1" dirty="0" smtClean="0">
                  <a:latin typeface="Calibri" panose="020F050202020403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 </a:t>
              </a:r>
              <a:r>
                <a:rPr lang="en-US" sz="900" b="1" dirty="0">
                  <a:latin typeface="Calibri" panose="020F050202020403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· · · · · · · · · · · · · · · · · · · </a:t>
              </a:r>
              <a:r>
                <a:rPr lang="en-US" sz="900" b="1" dirty="0" smtClean="0">
                  <a:latin typeface="Calibri" panose="020F050202020403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· </a:t>
              </a:r>
              <a:r>
                <a:rPr lang="en-US" sz="1000" b="1" dirty="0" smtClean="0">
                  <a:solidFill>
                    <a:srgbClr val="C00000"/>
                  </a:solidFill>
                  <a:latin typeface="Calibri" panose="020F050202020403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A</a:t>
              </a:r>
              <a:r>
                <a:rPr lang="en-US" sz="900" b="1" dirty="0" smtClean="0">
                  <a:solidFill>
                    <a:srgbClr val="C00000"/>
                  </a:solidFill>
                  <a:latin typeface="Calibri" panose="020F050202020403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 </a:t>
              </a:r>
              <a:r>
                <a:rPr lang="en-US" sz="900" b="1" dirty="0">
                  <a:latin typeface="Calibri" panose="020F050202020403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· · · · </a:t>
              </a:r>
              <a:endParaRPr lang="en-US" sz="900" dirty="0"/>
            </a:p>
          </p:txBody>
        </p:sp>
      </p:grpSp>
      <p:sp>
        <p:nvSpPr>
          <p:cNvPr id="16" name="TextBox 15"/>
          <p:cNvSpPr txBox="1"/>
          <p:nvPr/>
        </p:nvSpPr>
        <p:spPr>
          <a:xfrm rot="16200000">
            <a:off x="642431" y="8119582"/>
            <a:ext cx="1034967" cy="307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v4CL1a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 rot="16200000">
            <a:off x="865169" y="8119583"/>
            <a:ext cx="1034967" cy="307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v4CL1b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 rot="16200000">
            <a:off x="258097" y="3892901"/>
            <a:ext cx="1376240" cy="3357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  target site </a:t>
            </a:r>
            <a:endParaRPr lang="en-US" dirty="0">
              <a:solidFill>
                <a:sysClr val="windowText" lastClr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 rot="16200000">
            <a:off x="173975" y="8222007"/>
            <a:ext cx="6216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 rot="16200000">
            <a:off x="1873824" y="8222008"/>
            <a:ext cx="6216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 rot="16200000">
            <a:off x="296197" y="2657359"/>
            <a:ext cx="13762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  PAM</a:t>
            </a:r>
            <a:endParaRPr lang="en-US" sz="1200" dirty="0">
              <a:solidFill>
                <a:sysClr val="windowText" lastClr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009068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89270" y="3021565"/>
            <a:ext cx="682208" cy="494584"/>
          </a:xfrm>
          <a:prstGeom prst="rect">
            <a:avLst/>
          </a:prstGeom>
        </p:spPr>
      </p:pic>
      <p:sp>
        <p:nvSpPr>
          <p:cNvPr id="4" name="Rounded Rectangle 3"/>
          <p:cNvSpPr/>
          <p:nvPr/>
        </p:nvSpPr>
        <p:spPr>
          <a:xfrm>
            <a:off x="527539" y="5120987"/>
            <a:ext cx="1656358" cy="412305"/>
          </a:xfrm>
          <a:prstGeom prst="roundRect">
            <a:avLst/>
          </a:prstGeom>
          <a:noFill/>
          <a:ln w="2857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68568" y="2104708"/>
            <a:ext cx="929518" cy="929518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6260017" y="2930734"/>
            <a:ext cx="10987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v4CL1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255595" y="3119591"/>
            <a:ext cx="120681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v4CL2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252466" y="3314382"/>
            <a:ext cx="12099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v4CL3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0" name="Diagram 9"/>
          <p:cNvGraphicFramePr/>
          <p:nvPr>
            <p:extLst>
              <p:ext uri="{D42A27DB-BD31-4B8C-83A1-F6EECF244321}">
                <p14:modId xmlns:p14="http://schemas.microsoft.com/office/powerpoint/2010/main" val="1965780532"/>
              </p:ext>
            </p:extLst>
          </p:nvPr>
        </p:nvGraphicFramePr>
        <p:xfrm>
          <a:off x="587370" y="1664765"/>
          <a:ext cx="6498893" cy="406400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4" r:lo="rId5" r:qs="rId6" r:cs="rId7"/>
          </a:graphicData>
        </a:graphic>
      </p:graphicFrame>
      <p:sp>
        <p:nvSpPr>
          <p:cNvPr id="11" name="Rectangle 10"/>
          <p:cNvSpPr/>
          <p:nvPr/>
        </p:nvSpPr>
        <p:spPr>
          <a:xfrm rot="2696693">
            <a:off x="2159309" y="1863468"/>
            <a:ext cx="647700" cy="107879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Circular Arrow 11"/>
          <p:cNvSpPr/>
          <p:nvPr/>
        </p:nvSpPr>
        <p:spPr>
          <a:xfrm rot="256480" flipH="1">
            <a:off x="890323" y="2125573"/>
            <a:ext cx="1352550" cy="1342034"/>
          </a:xfrm>
          <a:prstGeom prst="circularArrow">
            <a:avLst>
              <a:gd name="adj1" fmla="val 9968"/>
              <a:gd name="adj2" fmla="val 1142319"/>
              <a:gd name="adj3" fmla="val 19907120"/>
              <a:gd name="adj4" fmla="val 10783752"/>
              <a:gd name="adj5" fmla="val 13738"/>
            </a:avLst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806964" y="1094721"/>
            <a:ext cx="444007" cy="814485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10"/>
          <a:srcRect l="17707"/>
          <a:stretch/>
        </p:blipFill>
        <p:spPr>
          <a:xfrm>
            <a:off x="3645637" y="3665489"/>
            <a:ext cx="1346333" cy="675779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741" t="64596" r="36494" b="20756"/>
          <a:stretch/>
        </p:blipFill>
        <p:spPr>
          <a:xfrm>
            <a:off x="3316166" y="5665015"/>
            <a:ext cx="762000" cy="228600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4046063" y="5623853"/>
            <a:ext cx="11682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v4CL1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446706" y="1925789"/>
            <a:ext cx="12096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nsgenic plantlets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-17376" y="3266907"/>
            <a:ext cx="2133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gnin analysis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9" name="Picture 18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90480" y="2067551"/>
            <a:ext cx="562558" cy="1216342"/>
          </a:xfrm>
          <a:prstGeom prst="rect">
            <a:avLst/>
          </a:prstGeom>
        </p:spPr>
      </p:pic>
      <p:sp>
        <p:nvSpPr>
          <p:cNvPr id="20" name="Freeform 19"/>
          <p:cNvSpPr/>
          <p:nvPr/>
        </p:nvSpPr>
        <p:spPr>
          <a:xfrm>
            <a:off x="639938" y="2851502"/>
            <a:ext cx="530369" cy="428604"/>
          </a:xfrm>
          <a:custGeom>
            <a:avLst/>
            <a:gdLst>
              <a:gd name="connsiteX0" fmla="*/ 0 w 3218688"/>
              <a:gd name="connsiteY0" fmla="*/ 1701972 h 1756836"/>
              <a:gd name="connsiteX1" fmla="*/ 1197864 w 3218688"/>
              <a:gd name="connsiteY1" fmla="*/ 1711116 h 1756836"/>
              <a:gd name="connsiteX2" fmla="*/ 1463040 w 3218688"/>
              <a:gd name="connsiteY2" fmla="*/ 1592244 h 1756836"/>
              <a:gd name="connsiteX3" fmla="*/ 1527048 w 3218688"/>
              <a:gd name="connsiteY3" fmla="*/ 1345356 h 1756836"/>
              <a:gd name="connsiteX4" fmla="*/ 1545336 w 3218688"/>
              <a:gd name="connsiteY4" fmla="*/ 815004 h 1756836"/>
              <a:gd name="connsiteX5" fmla="*/ 1618488 w 3218688"/>
              <a:gd name="connsiteY5" fmla="*/ 1592244 h 1756836"/>
              <a:gd name="connsiteX6" fmla="*/ 1947672 w 3218688"/>
              <a:gd name="connsiteY6" fmla="*/ 1692828 h 1756836"/>
              <a:gd name="connsiteX7" fmla="*/ 2203704 w 3218688"/>
              <a:gd name="connsiteY7" fmla="*/ 1665396 h 1756836"/>
              <a:gd name="connsiteX8" fmla="*/ 2286000 w 3218688"/>
              <a:gd name="connsiteY8" fmla="*/ 1308780 h 1756836"/>
              <a:gd name="connsiteX9" fmla="*/ 2340864 w 3218688"/>
              <a:gd name="connsiteY9" fmla="*/ 458388 h 1756836"/>
              <a:gd name="connsiteX10" fmla="*/ 2340864 w 3218688"/>
              <a:gd name="connsiteY10" fmla="*/ 10332 h 1756836"/>
              <a:gd name="connsiteX11" fmla="*/ 2386584 w 3218688"/>
              <a:gd name="connsiteY11" fmla="*/ 879012 h 1756836"/>
              <a:gd name="connsiteX12" fmla="*/ 2423160 w 3218688"/>
              <a:gd name="connsiteY12" fmla="*/ 1491660 h 1756836"/>
              <a:gd name="connsiteX13" fmla="*/ 2542032 w 3218688"/>
              <a:gd name="connsiteY13" fmla="*/ 1583100 h 1756836"/>
              <a:gd name="connsiteX14" fmla="*/ 2798064 w 3218688"/>
              <a:gd name="connsiteY14" fmla="*/ 1683684 h 1756836"/>
              <a:gd name="connsiteX15" fmla="*/ 3218688 w 3218688"/>
              <a:gd name="connsiteY15" fmla="*/ 1756836 h 175683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</a:cxnLst>
            <a:rect l="l" t="t" r="r" b="b"/>
            <a:pathLst>
              <a:path w="3218688" h="1756836">
                <a:moveTo>
                  <a:pt x="0" y="1701972"/>
                </a:moveTo>
                <a:cubicBezTo>
                  <a:pt x="477012" y="1715688"/>
                  <a:pt x="954024" y="1729404"/>
                  <a:pt x="1197864" y="1711116"/>
                </a:cubicBezTo>
                <a:cubicBezTo>
                  <a:pt x="1441704" y="1692828"/>
                  <a:pt x="1408176" y="1653204"/>
                  <a:pt x="1463040" y="1592244"/>
                </a:cubicBezTo>
                <a:cubicBezTo>
                  <a:pt x="1517904" y="1531284"/>
                  <a:pt x="1513332" y="1474896"/>
                  <a:pt x="1527048" y="1345356"/>
                </a:cubicBezTo>
                <a:cubicBezTo>
                  <a:pt x="1540764" y="1215816"/>
                  <a:pt x="1530096" y="773856"/>
                  <a:pt x="1545336" y="815004"/>
                </a:cubicBezTo>
                <a:cubicBezTo>
                  <a:pt x="1560576" y="856152"/>
                  <a:pt x="1551432" y="1445940"/>
                  <a:pt x="1618488" y="1592244"/>
                </a:cubicBezTo>
                <a:cubicBezTo>
                  <a:pt x="1685544" y="1738548"/>
                  <a:pt x="1850136" y="1680636"/>
                  <a:pt x="1947672" y="1692828"/>
                </a:cubicBezTo>
                <a:cubicBezTo>
                  <a:pt x="2045208" y="1705020"/>
                  <a:pt x="2147316" y="1729404"/>
                  <a:pt x="2203704" y="1665396"/>
                </a:cubicBezTo>
                <a:cubicBezTo>
                  <a:pt x="2260092" y="1601388"/>
                  <a:pt x="2263140" y="1509948"/>
                  <a:pt x="2286000" y="1308780"/>
                </a:cubicBezTo>
                <a:cubicBezTo>
                  <a:pt x="2308860" y="1107612"/>
                  <a:pt x="2331720" y="674796"/>
                  <a:pt x="2340864" y="458388"/>
                </a:cubicBezTo>
                <a:cubicBezTo>
                  <a:pt x="2350008" y="241980"/>
                  <a:pt x="2333244" y="-59772"/>
                  <a:pt x="2340864" y="10332"/>
                </a:cubicBezTo>
                <a:cubicBezTo>
                  <a:pt x="2348484" y="80436"/>
                  <a:pt x="2372868" y="632124"/>
                  <a:pt x="2386584" y="879012"/>
                </a:cubicBezTo>
                <a:cubicBezTo>
                  <a:pt x="2400300" y="1125900"/>
                  <a:pt x="2397252" y="1374312"/>
                  <a:pt x="2423160" y="1491660"/>
                </a:cubicBezTo>
                <a:cubicBezTo>
                  <a:pt x="2449068" y="1609008"/>
                  <a:pt x="2479548" y="1551096"/>
                  <a:pt x="2542032" y="1583100"/>
                </a:cubicBezTo>
                <a:cubicBezTo>
                  <a:pt x="2604516" y="1615104"/>
                  <a:pt x="2685288" y="1654728"/>
                  <a:pt x="2798064" y="1683684"/>
                </a:cubicBezTo>
                <a:cubicBezTo>
                  <a:pt x="2910840" y="1712640"/>
                  <a:pt x="3064764" y="1734738"/>
                  <a:pt x="3218688" y="1756836"/>
                </a:cubicBezTo>
              </a:path>
            </a:pathLst>
          </a:custGeom>
          <a:solidFill>
            <a:schemeClr val="tx1"/>
          </a:solidFill>
          <a:ln>
            <a:solidFill>
              <a:srgbClr val="0AD4CA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89982" y="6682219"/>
            <a:ext cx="6532092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hematic diagram of 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CR/sequencing for screening of edited </a:t>
            </a:r>
            <a:r>
              <a:rPr lang="en-US" sz="16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v4CLs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Steps in clockwise direction: 1)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are transgenic plants; 2) extract of genomic DNA; 3) amplify the target region of </a:t>
            </a:r>
            <a:r>
              <a:rPr lang="en-US" sz="16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v4CL1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6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v4CL2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6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v4CL3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 4) sequence the PCR products; 5) sort-out edited lines; 6) re-amplify the target region of the edited lines; 7) clone the PCR products into a TA vector; 8) re-sequence inserts in a TA vector; 9) analyze lignin phenotype.   </a:t>
            </a:r>
            <a:endParaRPr lang="en-US" sz="1600" dirty="0">
              <a:latin typeface="Times New Roman" panose="02020603050405020304" pitchFamily="18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pic>
        <p:nvPicPr>
          <p:cNvPr id="24" name="Picture 23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617851" y="4835595"/>
            <a:ext cx="1476653" cy="6941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689494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139699" y="6835676"/>
            <a:ext cx="6641162" cy="175432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ults of 2nd PCR/sequencing. pv4cl1-25 had four different mutation patterns, -29/+18, -27, -32 and -213; pv4cl1-26 had two different mutation patterns, -27 and -32/+16; pv4cl1-28 had two different mutation patterns, -27 and -1; pv4cl1-29 had three different mutation patterns, -44, -22 and -14/+7 in Pv4CL1. Red box: target site of Pv4CL1. Blue box: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M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4" name="Group 43"/>
          <p:cNvGrpSpPr/>
          <p:nvPr/>
        </p:nvGrpSpPr>
        <p:grpSpPr>
          <a:xfrm>
            <a:off x="5677" y="0"/>
            <a:ext cx="6835698" cy="6724473"/>
            <a:chOff x="5677" y="0"/>
            <a:chExt cx="6835698" cy="6724473"/>
          </a:xfrm>
        </p:grpSpPr>
        <p:grpSp>
          <p:nvGrpSpPr>
            <p:cNvPr id="36" name="Group 35"/>
            <p:cNvGrpSpPr/>
            <p:nvPr/>
          </p:nvGrpSpPr>
          <p:grpSpPr>
            <a:xfrm>
              <a:off x="17689" y="0"/>
              <a:ext cx="6823686" cy="6724315"/>
              <a:chOff x="28575" y="0"/>
              <a:chExt cx="6823686" cy="6724315"/>
            </a:xfrm>
          </p:grpSpPr>
          <p:pic>
            <p:nvPicPr>
              <p:cNvPr id="33" name="Picture 32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60"/>
              <a:stretch/>
            </p:blipFill>
            <p:spPr>
              <a:xfrm>
                <a:off x="32657" y="0"/>
                <a:ext cx="6819604" cy="4766672"/>
              </a:xfrm>
              <a:prstGeom prst="rect">
                <a:avLst/>
              </a:prstGeom>
            </p:spPr>
          </p:pic>
          <p:pic>
            <p:nvPicPr>
              <p:cNvPr id="35" name="Picture 34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8575" y="2252702"/>
                <a:ext cx="6804633" cy="4471613"/>
              </a:xfrm>
              <a:prstGeom prst="rect">
                <a:avLst/>
              </a:prstGeom>
            </p:spPr>
          </p:pic>
        </p:grpSp>
        <p:sp>
          <p:nvSpPr>
            <p:cNvPr id="31" name="Rectangle 30"/>
            <p:cNvSpPr/>
            <p:nvPr/>
          </p:nvSpPr>
          <p:spPr>
            <a:xfrm>
              <a:off x="5677" y="260728"/>
              <a:ext cx="1025135" cy="646358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40" name="Picture 39"/>
            <p:cNvPicPr>
              <a:picLocks noChangeAspect="1"/>
            </p:cNvPicPr>
            <p:nvPr/>
          </p:nvPicPr>
          <p:blipFill rotWithShape="1">
            <a:blip r:embed="rId4"/>
            <a:srcRect l="492" t="3648" r="93492"/>
            <a:stretch/>
          </p:blipFill>
          <p:spPr>
            <a:xfrm>
              <a:off x="602431" y="245330"/>
              <a:ext cx="412595" cy="6479143"/>
            </a:xfrm>
            <a:prstGeom prst="rect">
              <a:avLst/>
            </a:prstGeom>
          </p:spPr>
        </p:pic>
        <p:sp>
          <p:nvSpPr>
            <p:cNvPr id="43" name="Rectangle 42"/>
            <p:cNvSpPr/>
            <p:nvPr/>
          </p:nvSpPr>
          <p:spPr>
            <a:xfrm>
              <a:off x="3711680" y="260728"/>
              <a:ext cx="493776" cy="162059"/>
            </a:xfrm>
            <a:prstGeom prst="rect">
              <a:avLst/>
            </a:prstGeom>
            <a:noFill/>
            <a:ln>
              <a:solidFill>
                <a:srgbClr val="00B0F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2" name="Rectangle 41"/>
            <p:cNvSpPr/>
            <p:nvPr/>
          </p:nvSpPr>
          <p:spPr>
            <a:xfrm>
              <a:off x="2934929" y="260728"/>
              <a:ext cx="781665" cy="16205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87743157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0632" y="2265891"/>
            <a:ext cx="5495511" cy="4388776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1936766" y="6781284"/>
            <a:ext cx="55816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ith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" name="Straight Arrow Connector 3"/>
          <p:cNvCxnSpPr/>
          <p:nvPr/>
        </p:nvCxnSpPr>
        <p:spPr>
          <a:xfrm flipV="1">
            <a:off x="2283128" y="6423023"/>
            <a:ext cx="762580" cy="416842"/>
          </a:xfrm>
          <a:prstGeom prst="straightConnector1">
            <a:avLst/>
          </a:prstGeom>
          <a:ln>
            <a:solidFill>
              <a:schemeClr val="accent6">
                <a:lumMod val="20000"/>
                <a:lumOff val="8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Rectangle 4"/>
          <p:cNvSpPr/>
          <p:nvPr/>
        </p:nvSpPr>
        <p:spPr>
          <a:xfrm>
            <a:off x="1749394" y="1786649"/>
            <a:ext cx="174740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scular bundles</a:t>
            </a:r>
          </a:p>
        </p:txBody>
      </p:sp>
      <p:cxnSp>
        <p:nvCxnSpPr>
          <p:cNvPr id="6" name="Straight Arrow Connector 5"/>
          <p:cNvCxnSpPr/>
          <p:nvPr/>
        </p:nvCxnSpPr>
        <p:spPr>
          <a:xfrm flipH="1">
            <a:off x="2155749" y="2107171"/>
            <a:ext cx="254758" cy="2343127"/>
          </a:xfrm>
          <a:prstGeom prst="straightConnector1">
            <a:avLst/>
          </a:prstGeom>
          <a:ln>
            <a:solidFill>
              <a:schemeClr val="accent6">
                <a:lumMod val="20000"/>
                <a:lumOff val="8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Rectangle 6"/>
          <p:cNvSpPr/>
          <p:nvPr/>
        </p:nvSpPr>
        <p:spPr>
          <a:xfrm>
            <a:off x="4334583" y="1449519"/>
            <a:ext cx="215866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erfascicular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gion</a:t>
            </a:r>
          </a:p>
        </p:txBody>
      </p:sp>
      <p:cxnSp>
        <p:nvCxnSpPr>
          <p:cNvPr id="8" name="Straight Arrow Connector 7"/>
          <p:cNvCxnSpPr/>
          <p:nvPr/>
        </p:nvCxnSpPr>
        <p:spPr>
          <a:xfrm>
            <a:off x="1266825" y="2987729"/>
            <a:ext cx="224990" cy="314841"/>
          </a:xfrm>
          <a:prstGeom prst="straightConnector1">
            <a:avLst/>
          </a:prstGeom>
          <a:ln>
            <a:solidFill>
              <a:schemeClr val="accent6">
                <a:lumMod val="20000"/>
                <a:lumOff val="8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Rectangle 8"/>
          <p:cNvSpPr/>
          <p:nvPr/>
        </p:nvSpPr>
        <p:spPr>
          <a:xfrm>
            <a:off x="722326" y="2521262"/>
            <a:ext cx="111921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pidermis</a:t>
            </a:r>
          </a:p>
        </p:txBody>
      </p:sp>
      <p:sp>
        <p:nvSpPr>
          <p:cNvPr id="10" name="TextBox 9"/>
          <p:cNvSpPr txBox="1"/>
          <p:nvPr/>
        </p:nvSpPr>
        <p:spPr>
          <a:xfrm rot="21430324">
            <a:off x="1780353" y="4608328"/>
            <a:ext cx="4466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 smtClean="0">
                <a:solidFill>
                  <a:srgbClr val="FF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h</a:t>
            </a:r>
            <a:endParaRPr lang="en-US" sz="1600" dirty="0">
              <a:solidFill>
                <a:srgbClr val="FFFF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 rot="21121300">
            <a:off x="1863541" y="5172950"/>
            <a:ext cx="6539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rgbClr val="FF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</a:t>
            </a:r>
            <a:r>
              <a:rPr lang="en-US" sz="1600" dirty="0" smtClean="0">
                <a:solidFill>
                  <a:srgbClr val="FF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endParaRPr lang="en-US" sz="1600" dirty="0">
              <a:solidFill>
                <a:srgbClr val="FFFF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 rot="17573750">
            <a:off x="1413420" y="4922453"/>
            <a:ext cx="413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rgbClr val="FF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v</a:t>
            </a:r>
            <a:endParaRPr lang="en-US" dirty="0">
              <a:solidFill>
                <a:srgbClr val="FFFF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 rot="4761069">
            <a:off x="2067061" y="4961975"/>
            <a:ext cx="745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rgbClr val="FF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v</a:t>
            </a:r>
            <a:endParaRPr lang="en-US" dirty="0">
              <a:solidFill>
                <a:srgbClr val="FFFF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592647" y="6008336"/>
            <a:ext cx="161222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clerenchyma fiber</a:t>
            </a:r>
            <a:endParaRPr lang="en-US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5" name="Straight Arrow Connector 14"/>
          <p:cNvCxnSpPr/>
          <p:nvPr/>
        </p:nvCxnSpPr>
        <p:spPr>
          <a:xfrm flipH="1" flipV="1">
            <a:off x="5295900" y="5634060"/>
            <a:ext cx="219076" cy="351520"/>
          </a:xfrm>
          <a:prstGeom prst="straightConnector1">
            <a:avLst/>
          </a:prstGeom>
          <a:ln>
            <a:solidFill>
              <a:schemeClr val="accent6">
                <a:lumMod val="20000"/>
                <a:lumOff val="8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1841543" y="4848374"/>
            <a:ext cx="4763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P</a:t>
            </a:r>
            <a:endParaRPr lang="en-US" sz="1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Freeform 16"/>
          <p:cNvSpPr/>
          <p:nvPr/>
        </p:nvSpPr>
        <p:spPr>
          <a:xfrm>
            <a:off x="1369311" y="4414630"/>
            <a:ext cx="1286353" cy="1340829"/>
          </a:xfrm>
          <a:custGeom>
            <a:avLst/>
            <a:gdLst>
              <a:gd name="connsiteX0" fmla="*/ 246435 w 1286353"/>
              <a:gd name="connsiteY0" fmla="*/ 222305 h 1340829"/>
              <a:gd name="connsiteX1" fmla="*/ 321694 w 1286353"/>
              <a:gd name="connsiteY1" fmla="*/ 207253 h 1340829"/>
              <a:gd name="connsiteX2" fmla="*/ 381901 w 1286353"/>
              <a:gd name="connsiteY2" fmla="*/ 162097 h 1340829"/>
              <a:gd name="connsiteX3" fmla="*/ 408242 w 1286353"/>
              <a:gd name="connsiteY3" fmla="*/ 64260 h 1340829"/>
              <a:gd name="connsiteX4" fmla="*/ 438346 w 1286353"/>
              <a:gd name="connsiteY4" fmla="*/ 4053 h 1340829"/>
              <a:gd name="connsiteX5" fmla="*/ 528657 w 1286353"/>
              <a:gd name="connsiteY5" fmla="*/ 7816 h 1340829"/>
              <a:gd name="connsiteX6" fmla="*/ 618968 w 1286353"/>
              <a:gd name="connsiteY6" fmla="*/ 26631 h 1340829"/>
              <a:gd name="connsiteX7" fmla="*/ 713042 w 1286353"/>
              <a:gd name="connsiteY7" fmla="*/ 52971 h 1340829"/>
              <a:gd name="connsiteX8" fmla="*/ 795827 w 1286353"/>
              <a:gd name="connsiteY8" fmla="*/ 37919 h 1340829"/>
              <a:gd name="connsiteX9" fmla="*/ 814642 w 1286353"/>
              <a:gd name="connsiteY9" fmla="*/ 124468 h 1340829"/>
              <a:gd name="connsiteX10" fmla="*/ 840983 w 1286353"/>
              <a:gd name="connsiteY10" fmla="*/ 165860 h 1340829"/>
              <a:gd name="connsiteX11" fmla="*/ 920005 w 1286353"/>
              <a:gd name="connsiteY11" fmla="*/ 150808 h 1340829"/>
              <a:gd name="connsiteX12" fmla="*/ 950109 w 1286353"/>
              <a:gd name="connsiteY12" fmla="*/ 259934 h 1340829"/>
              <a:gd name="connsiteX13" fmla="*/ 1044183 w 1286353"/>
              <a:gd name="connsiteY13" fmla="*/ 244882 h 1340829"/>
              <a:gd name="connsiteX14" fmla="*/ 1111916 w 1286353"/>
              <a:gd name="connsiteY14" fmla="*/ 237356 h 1340829"/>
              <a:gd name="connsiteX15" fmla="*/ 1217279 w 1286353"/>
              <a:gd name="connsiteY15" fmla="*/ 308853 h 1340829"/>
              <a:gd name="connsiteX16" fmla="*/ 1198464 w 1286353"/>
              <a:gd name="connsiteY16" fmla="*/ 380349 h 1340829"/>
              <a:gd name="connsiteX17" fmla="*/ 1232331 w 1286353"/>
              <a:gd name="connsiteY17" fmla="*/ 459371 h 1340829"/>
              <a:gd name="connsiteX18" fmla="*/ 1285013 w 1286353"/>
              <a:gd name="connsiteY18" fmla="*/ 512053 h 1340829"/>
              <a:gd name="connsiteX19" fmla="*/ 1269961 w 1286353"/>
              <a:gd name="connsiteY19" fmla="*/ 583549 h 1340829"/>
              <a:gd name="connsiteX20" fmla="*/ 1262435 w 1286353"/>
              <a:gd name="connsiteY20" fmla="*/ 658808 h 1340829"/>
              <a:gd name="connsiteX21" fmla="*/ 1269961 w 1286353"/>
              <a:gd name="connsiteY21" fmla="*/ 715253 h 1340829"/>
              <a:gd name="connsiteX22" fmla="*/ 1217279 w 1286353"/>
              <a:gd name="connsiteY22" fmla="*/ 782986 h 1340829"/>
              <a:gd name="connsiteX23" fmla="*/ 1164598 w 1286353"/>
              <a:gd name="connsiteY23" fmla="*/ 880823 h 1340829"/>
              <a:gd name="connsiteX24" fmla="*/ 1149546 w 1286353"/>
              <a:gd name="connsiteY24" fmla="*/ 956082 h 1340829"/>
              <a:gd name="connsiteX25" fmla="*/ 1021605 w 1286353"/>
              <a:gd name="connsiteY25" fmla="*/ 997475 h 1340829"/>
              <a:gd name="connsiteX26" fmla="*/ 991501 w 1286353"/>
              <a:gd name="connsiteY26" fmla="*/ 1035105 h 1340829"/>
              <a:gd name="connsiteX27" fmla="*/ 976450 w 1286353"/>
              <a:gd name="connsiteY27" fmla="*/ 1117890 h 1340829"/>
              <a:gd name="connsiteX28" fmla="*/ 957635 w 1286353"/>
              <a:gd name="connsiteY28" fmla="*/ 1223253 h 1340829"/>
              <a:gd name="connsiteX29" fmla="*/ 882375 w 1286353"/>
              <a:gd name="connsiteY29" fmla="*/ 1275934 h 1340829"/>
              <a:gd name="connsiteX30" fmla="*/ 863561 w 1286353"/>
              <a:gd name="connsiteY30" fmla="*/ 1324853 h 1340829"/>
              <a:gd name="connsiteX31" fmla="*/ 792064 w 1286353"/>
              <a:gd name="connsiteY31" fmla="*/ 1321090 h 1340829"/>
              <a:gd name="connsiteX32" fmla="*/ 682938 w 1286353"/>
              <a:gd name="connsiteY32" fmla="*/ 1339905 h 1340829"/>
              <a:gd name="connsiteX33" fmla="*/ 547472 w 1286353"/>
              <a:gd name="connsiteY33" fmla="*/ 1287223 h 1340829"/>
              <a:gd name="connsiteX34" fmla="*/ 498553 w 1286353"/>
              <a:gd name="connsiteY34" fmla="*/ 1253356 h 1340829"/>
              <a:gd name="connsiteX35" fmla="*/ 427057 w 1286353"/>
              <a:gd name="connsiteY35" fmla="*/ 1193149 h 1340829"/>
              <a:gd name="connsiteX36" fmla="*/ 351798 w 1286353"/>
              <a:gd name="connsiteY36" fmla="*/ 1170571 h 1340829"/>
              <a:gd name="connsiteX37" fmla="*/ 336746 w 1286353"/>
              <a:gd name="connsiteY37" fmla="*/ 1125416 h 1340829"/>
              <a:gd name="connsiteX38" fmla="*/ 306642 w 1286353"/>
              <a:gd name="connsiteY38" fmla="*/ 1076497 h 1340829"/>
              <a:gd name="connsiteX39" fmla="*/ 193753 w 1286353"/>
              <a:gd name="connsiteY39" fmla="*/ 1046394 h 1340829"/>
              <a:gd name="connsiteX40" fmla="*/ 137309 w 1286353"/>
              <a:gd name="connsiteY40" fmla="*/ 982423 h 1340829"/>
              <a:gd name="connsiteX41" fmla="*/ 54524 w 1286353"/>
              <a:gd name="connsiteY41" fmla="*/ 978660 h 1340829"/>
              <a:gd name="connsiteX42" fmla="*/ 1842 w 1286353"/>
              <a:gd name="connsiteY42" fmla="*/ 910927 h 1340829"/>
              <a:gd name="connsiteX43" fmla="*/ 13131 w 1286353"/>
              <a:gd name="connsiteY43" fmla="*/ 737831 h 1340829"/>
              <a:gd name="connsiteX44" fmla="*/ 24420 w 1286353"/>
              <a:gd name="connsiteY44" fmla="*/ 606127 h 1340829"/>
              <a:gd name="connsiteX45" fmla="*/ 5605 w 1286353"/>
              <a:gd name="connsiteY45" fmla="*/ 481949 h 1340829"/>
              <a:gd name="connsiteX46" fmla="*/ 65813 w 1286353"/>
              <a:gd name="connsiteY46" fmla="*/ 417979 h 1340829"/>
              <a:gd name="connsiteX47" fmla="*/ 174938 w 1286353"/>
              <a:gd name="connsiteY47" fmla="*/ 346482 h 1340829"/>
              <a:gd name="connsiteX48" fmla="*/ 212568 w 1286353"/>
              <a:gd name="connsiteY48" fmla="*/ 308853 h 1340829"/>
              <a:gd name="connsiteX49" fmla="*/ 246435 w 1286353"/>
              <a:gd name="connsiteY49" fmla="*/ 222305 h 1340829"/>
              <a:gd name="connsiteX0" fmla="*/ 246435 w 1286353"/>
              <a:gd name="connsiteY0" fmla="*/ 222305 h 1340829"/>
              <a:gd name="connsiteX1" fmla="*/ 321694 w 1286353"/>
              <a:gd name="connsiteY1" fmla="*/ 207253 h 1340829"/>
              <a:gd name="connsiteX2" fmla="*/ 381901 w 1286353"/>
              <a:gd name="connsiteY2" fmla="*/ 162097 h 1340829"/>
              <a:gd name="connsiteX3" fmla="*/ 408242 w 1286353"/>
              <a:gd name="connsiteY3" fmla="*/ 64260 h 1340829"/>
              <a:gd name="connsiteX4" fmla="*/ 438346 w 1286353"/>
              <a:gd name="connsiteY4" fmla="*/ 4053 h 1340829"/>
              <a:gd name="connsiteX5" fmla="*/ 528657 w 1286353"/>
              <a:gd name="connsiteY5" fmla="*/ 7816 h 1340829"/>
              <a:gd name="connsiteX6" fmla="*/ 618968 w 1286353"/>
              <a:gd name="connsiteY6" fmla="*/ 26631 h 1340829"/>
              <a:gd name="connsiteX7" fmla="*/ 713042 w 1286353"/>
              <a:gd name="connsiteY7" fmla="*/ 52971 h 1340829"/>
              <a:gd name="connsiteX8" fmla="*/ 795827 w 1286353"/>
              <a:gd name="connsiteY8" fmla="*/ 37919 h 1340829"/>
              <a:gd name="connsiteX9" fmla="*/ 814642 w 1286353"/>
              <a:gd name="connsiteY9" fmla="*/ 124468 h 1340829"/>
              <a:gd name="connsiteX10" fmla="*/ 840983 w 1286353"/>
              <a:gd name="connsiteY10" fmla="*/ 165860 h 1340829"/>
              <a:gd name="connsiteX11" fmla="*/ 920005 w 1286353"/>
              <a:gd name="connsiteY11" fmla="*/ 150808 h 1340829"/>
              <a:gd name="connsiteX12" fmla="*/ 950109 w 1286353"/>
              <a:gd name="connsiteY12" fmla="*/ 259934 h 1340829"/>
              <a:gd name="connsiteX13" fmla="*/ 1044183 w 1286353"/>
              <a:gd name="connsiteY13" fmla="*/ 244882 h 1340829"/>
              <a:gd name="connsiteX14" fmla="*/ 1111916 w 1286353"/>
              <a:gd name="connsiteY14" fmla="*/ 237356 h 1340829"/>
              <a:gd name="connsiteX15" fmla="*/ 1217279 w 1286353"/>
              <a:gd name="connsiteY15" fmla="*/ 308853 h 1340829"/>
              <a:gd name="connsiteX16" fmla="*/ 1198464 w 1286353"/>
              <a:gd name="connsiteY16" fmla="*/ 380349 h 1340829"/>
              <a:gd name="connsiteX17" fmla="*/ 1232331 w 1286353"/>
              <a:gd name="connsiteY17" fmla="*/ 459371 h 1340829"/>
              <a:gd name="connsiteX18" fmla="*/ 1285013 w 1286353"/>
              <a:gd name="connsiteY18" fmla="*/ 512053 h 1340829"/>
              <a:gd name="connsiteX19" fmla="*/ 1269961 w 1286353"/>
              <a:gd name="connsiteY19" fmla="*/ 583549 h 1340829"/>
              <a:gd name="connsiteX20" fmla="*/ 1262435 w 1286353"/>
              <a:gd name="connsiteY20" fmla="*/ 658808 h 1340829"/>
              <a:gd name="connsiteX21" fmla="*/ 1269961 w 1286353"/>
              <a:gd name="connsiteY21" fmla="*/ 715253 h 1340829"/>
              <a:gd name="connsiteX22" fmla="*/ 1217279 w 1286353"/>
              <a:gd name="connsiteY22" fmla="*/ 782986 h 1340829"/>
              <a:gd name="connsiteX23" fmla="*/ 1164598 w 1286353"/>
              <a:gd name="connsiteY23" fmla="*/ 880823 h 1340829"/>
              <a:gd name="connsiteX24" fmla="*/ 1149546 w 1286353"/>
              <a:gd name="connsiteY24" fmla="*/ 956082 h 1340829"/>
              <a:gd name="connsiteX25" fmla="*/ 1078249 w 1286353"/>
              <a:gd name="connsiteY25" fmla="*/ 1041982 h 1340829"/>
              <a:gd name="connsiteX26" fmla="*/ 991501 w 1286353"/>
              <a:gd name="connsiteY26" fmla="*/ 1035105 h 1340829"/>
              <a:gd name="connsiteX27" fmla="*/ 976450 w 1286353"/>
              <a:gd name="connsiteY27" fmla="*/ 1117890 h 1340829"/>
              <a:gd name="connsiteX28" fmla="*/ 957635 w 1286353"/>
              <a:gd name="connsiteY28" fmla="*/ 1223253 h 1340829"/>
              <a:gd name="connsiteX29" fmla="*/ 882375 w 1286353"/>
              <a:gd name="connsiteY29" fmla="*/ 1275934 h 1340829"/>
              <a:gd name="connsiteX30" fmla="*/ 863561 w 1286353"/>
              <a:gd name="connsiteY30" fmla="*/ 1324853 h 1340829"/>
              <a:gd name="connsiteX31" fmla="*/ 792064 w 1286353"/>
              <a:gd name="connsiteY31" fmla="*/ 1321090 h 1340829"/>
              <a:gd name="connsiteX32" fmla="*/ 682938 w 1286353"/>
              <a:gd name="connsiteY32" fmla="*/ 1339905 h 1340829"/>
              <a:gd name="connsiteX33" fmla="*/ 547472 w 1286353"/>
              <a:gd name="connsiteY33" fmla="*/ 1287223 h 1340829"/>
              <a:gd name="connsiteX34" fmla="*/ 498553 w 1286353"/>
              <a:gd name="connsiteY34" fmla="*/ 1253356 h 1340829"/>
              <a:gd name="connsiteX35" fmla="*/ 427057 w 1286353"/>
              <a:gd name="connsiteY35" fmla="*/ 1193149 h 1340829"/>
              <a:gd name="connsiteX36" fmla="*/ 351798 w 1286353"/>
              <a:gd name="connsiteY36" fmla="*/ 1170571 h 1340829"/>
              <a:gd name="connsiteX37" fmla="*/ 336746 w 1286353"/>
              <a:gd name="connsiteY37" fmla="*/ 1125416 h 1340829"/>
              <a:gd name="connsiteX38" fmla="*/ 306642 w 1286353"/>
              <a:gd name="connsiteY38" fmla="*/ 1076497 h 1340829"/>
              <a:gd name="connsiteX39" fmla="*/ 193753 w 1286353"/>
              <a:gd name="connsiteY39" fmla="*/ 1046394 h 1340829"/>
              <a:gd name="connsiteX40" fmla="*/ 137309 w 1286353"/>
              <a:gd name="connsiteY40" fmla="*/ 982423 h 1340829"/>
              <a:gd name="connsiteX41" fmla="*/ 54524 w 1286353"/>
              <a:gd name="connsiteY41" fmla="*/ 978660 h 1340829"/>
              <a:gd name="connsiteX42" fmla="*/ 1842 w 1286353"/>
              <a:gd name="connsiteY42" fmla="*/ 910927 h 1340829"/>
              <a:gd name="connsiteX43" fmla="*/ 13131 w 1286353"/>
              <a:gd name="connsiteY43" fmla="*/ 737831 h 1340829"/>
              <a:gd name="connsiteX44" fmla="*/ 24420 w 1286353"/>
              <a:gd name="connsiteY44" fmla="*/ 606127 h 1340829"/>
              <a:gd name="connsiteX45" fmla="*/ 5605 w 1286353"/>
              <a:gd name="connsiteY45" fmla="*/ 481949 h 1340829"/>
              <a:gd name="connsiteX46" fmla="*/ 65813 w 1286353"/>
              <a:gd name="connsiteY46" fmla="*/ 417979 h 1340829"/>
              <a:gd name="connsiteX47" fmla="*/ 174938 w 1286353"/>
              <a:gd name="connsiteY47" fmla="*/ 346482 h 1340829"/>
              <a:gd name="connsiteX48" fmla="*/ 212568 w 1286353"/>
              <a:gd name="connsiteY48" fmla="*/ 308853 h 1340829"/>
              <a:gd name="connsiteX49" fmla="*/ 246435 w 1286353"/>
              <a:gd name="connsiteY49" fmla="*/ 222305 h 1340829"/>
              <a:gd name="connsiteX0" fmla="*/ 246435 w 1286353"/>
              <a:gd name="connsiteY0" fmla="*/ 222305 h 1340829"/>
              <a:gd name="connsiteX1" fmla="*/ 321694 w 1286353"/>
              <a:gd name="connsiteY1" fmla="*/ 207253 h 1340829"/>
              <a:gd name="connsiteX2" fmla="*/ 381901 w 1286353"/>
              <a:gd name="connsiteY2" fmla="*/ 162097 h 1340829"/>
              <a:gd name="connsiteX3" fmla="*/ 408242 w 1286353"/>
              <a:gd name="connsiteY3" fmla="*/ 64260 h 1340829"/>
              <a:gd name="connsiteX4" fmla="*/ 438346 w 1286353"/>
              <a:gd name="connsiteY4" fmla="*/ 4053 h 1340829"/>
              <a:gd name="connsiteX5" fmla="*/ 528657 w 1286353"/>
              <a:gd name="connsiteY5" fmla="*/ 7816 h 1340829"/>
              <a:gd name="connsiteX6" fmla="*/ 618968 w 1286353"/>
              <a:gd name="connsiteY6" fmla="*/ 26631 h 1340829"/>
              <a:gd name="connsiteX7" fmla="*/ 713042 w 1286353"/>
              <a:gd name="connsiteY7" fmla="*/ 52971 h 1340829"/>
              <a:gd name="connsiteX8" fmla="*/ 795827 w 1286353"/>
              <a:gd name="connsiteY8" fmla="*/ 37919 h 1340829"/>
              <a:gd name="connsiteX9" fmla="*/ 814642 w 1286353"/>
              <a:gd name="connsiteY9" fmla="*/ 124468 h 1340829"/>
              <a:gd name="connsiteX10" fmla="*/ 840983 w 1286353"/>
              <a:gd name="connsiteY10" fmla="*/ 165860 h 1340829"/>
              <a:gd name="connsiteX11" fmla="*/ 920005 w 1286353"/>
              <a:gd name="connsiteY11" fmla="*/ 150808 h 1340829"/>
              <a:gd name="connsiteX12" fmla="*/ 950109 w 1286353"/>
              <a:gd name="connsiteY12" fmla="*/ 259934 h 1340829"/>
              <a:gd name="connsiteX13" fmla="*/ 1044183 w 1286353"/>
              <a:gd name="connsiteY13" fmla="*/ 244882 h 1340829"/>
              <a:gd name="connsiteX14" fmla="*/ 1111916 w 1286353"/>
              <a:gd name="connsiteY14" fmla="*/ 237356 h 1340829"/>
              <a:gd name="connsiteX15" fmla="*/ 1217279 w 1286353"/>
              <a:gd name="connsiteY15" fmla="*/ 308853 h 1340829"/>
              <a:gd name="connsiteX16" fmla="*/ 1198464 w 1286353"/>
              <a:gd name="connsiteY16" fmla="*/ 380349 h 1340829"/>
              <a:gd name="connsiteX17" fmla="*/ 1232331 w 1286353"/>
              <a:gd name="connsiteY17" fmla="*/ 459371 h 1340829"/>
              <a:gd name="connsiteX18" fmla="*/ 1285013 w 1286353"/>
              <a:gd name="connsiteY18" fmla="*/ 512053 h 1340829"/>
              <a:gd name="connsiteX19" fmla="*/ 1269961 w 1286353"/>
              <a:gd name="connsiteY19" fmla="*/ 583549 h 1340829"/>
              <a:gd name="connsiteX20" fmla="*/ 1262435 w 1286353"/>
              <a:gd name="connsiteY20" fmla="*/ 658808 h 1340829"/>
              <a:gd name="connsiteX21" fmla="*/ 1269961 w 1286353"/>
              <a:gd name="connsiteY21" fmla="*/ 715253 h 1340829"/>
              <a:gd name="connsiteX22" fmla="*/ 1217279 w 1286353"/>
              <a:gd name="connsiteY22" fmla="*/ 782986 h 1340829"/>
              <a:gd name="connsiteX23" fmla="*/ 1164598 w 1286353"/>
              <a:gd name="connsiteY23" fmla="*/ 880823 h 1340829"/>
              <a:gd name="connsiteX24" fmla="*/ 1149546 w 1286353"/>
              <a:gd name="connsiteY24" fmla="*/ 956082 h 1340829"/>
              <a:gd name="connsiteX25" fmla="*/ 1078249 w 1286353"/>
              <a:gd name="connsiteY25" fmla="*/ 1041982 h 1340829"/>
              <a:gd name="connsiteX26" fmla="*/ 1036007 w 1286353"/>
              <a:gd name="connsiteY26" fmla="*/ 1067473 h 1340829"/>
              <a:gd name="connsiteX27" fmla="*/ 976450 w 1286353"/>
              <a:gd name="connsiteY27" fmla="*/ 1117890 h 1340829"/>
              <a:gd name="connsiteX28" fmla="*/ 957635 w 1286353"/>
              <a:gd name="connsiteY28" fmla="*/ 1223253 h 1340829"/>
              <a:gd name="connsiteX29" fmla="*/ 882375 w 1286353"/>
              <a:gd name="connsiteY29" fmla="*/ 1275934 h 1340829"/>
              <a:gd name="connsiteX30" fmla="*/ 863561 w 1286353"/>
              <a:gd name="connsiteY30" fmla="*/ 1324853 h 1340829"/>
              <a:gd name="connsiteX31" fmla="*/ 792064 w 1286353"/>
              <a:gd name="connsiteY31" fmla="*/ 1321090 h 1340829"/>
              <a:gd name="connsiteX32" fmla="*/ 682938 w 1286353"/>
              <a:gd name="connsiteY32" fmla="*/ 1339905 h 1340829"/>
              <a:gd name="connsiteX33" fmla="*/ 547472 w 1286353"/>
              <a:gd name="connsiteY33" fmla="*/ 1287223 h 1340829"/>
              <a:gd name="connsiteX34" fmla="*/ 498553 w 1286353"/>
              <a:gd name="connsiteY34" fmla="*/ 1253356 h 1340829"/>
              <a:gd name="connsiteX35" fmla="*/ 427057 w 1286353"/>
              <a:gd name="connsiteY35" fmla="*/ 1193149 h 1340829"/>
              <a:gd name="connsiteX36" fmla="*/ 351798 w 1286353"/>
              <a:gd name="connsiteY36" fmla="*/ 1170571 h 1340829"/>
              <a:gd name="connsiteX37" fmla="*/ 336746 w 1286353"/>
              <a:gd name="connsiteY37" fmla="*/ 1125416 h 1340829"/>
              <a:gd name="connsiteX38" fmla="*/ 306642 w 1286353"/>
              <a:gd name="connsiteY38" fmla="*/ 1076497 h 1340829"/>
              <a:gd name="connsiteX39" fmla="*/ 193753 w 1286353"/>
              <a:gd name="connsiteY39" fmla="*/ 1046394 h 1340829"/>
              <a:gd name="connsiteX40" fmla="*/ 137309 w 1286353"/>
              <a:gd name="connsiteY40" fmla="*/ 982423 h 1340829"/>
              <a:gd name="connsiteX41" fmla="*/ 54524 w 1286353"/>
              <a:gd name="connsiteY41" fmla="*/ 978660 h 1340829"/>
              <a:gd name="connsiteX42" fmla="*/ 1842 w 1286353"/>
              <a:gd name="connsiteY42" fmla="*/ 910927 h 1340829"/>
              <a:gd name="connsiteX43" fmla="*/ 13131 w 1286353"/>
              <a:gd name="connsiteY43" fmla="*/ 737831 h 1340829"/>
              <a:gd name="connsiteX44" fmla="*/ 24420 w 1286353"/>
              <a:gd name="connsiteY44" fmla="*/ 606127 h 1340829"/>
              <a:gd name="connsiteX45" fmla="*/ 5605 w 1286353"/>
              <a:gd name="connsiteY45" fmla="*/ 481949 h 1340829"/>
              <a:gd name="connsiteX46" fmla="*/ 65813 w 1286353"/>
              <a:gd name="connsiteY46" fmla="*/ 417979 h 1340829"/>
              <a:gd name="connsiteX47" fmla="*/ 174938 w 1286353"/>
              <a:gd name="connsiteY47" fmla="*/ 346482 h 1340829"/>
              <a:gd name="connsiteX48" fmla="*/ 212568 w 1286353"/>
              <a:gd name="connsiteY48" fmla="*/ 308853 h 1340829"/>
              <a:gd name="connsiteX49" fmla="*/ 246435 w 1286353"/>
              <a:gd name="connsiteY49" fmla="*/ 222305 h 1340829"/>
              <a:gd name="connsiteX0" fmla="*/ 246435 w 1286353"/>
              <a:gd name="connsiteY0" fmla="*/ 222305 h 1340829"/>
              <a:gd name="connsiteX1" fmla="*/ 321694 w 1286353"/>
              <a:gd name="connsiteY1" fmla="*/ 207253 h 1340829"/>
              <a:gd name="connsiteX2" fmla="*/ 381901 w 1286353"/>
              <a:gd name="connsiteY2" fmla="*/ 162097 h 1340829"/>
              <a:gd name="connsiteX3" fmla="*/ 408242 w 1286353"/>
              <a:gd name="connsiteY3" fmla="*/ 64260 h 1340829"/>
              <a:gd name="connsiteX4" fmla="*/ 438346 w 1286353"/>
              <a:gd name="connsiteY4" fmla="*/ 4053 h 1340829"/>
              <a:gd name="connsiteX5" fmla="*/ 528657 w 1286353"/>
              <a:gd name="connsiteY5" fmla="*/ 7816 h 1340829"/>
              <a:gd name="connsiteX6" fmla="*/ 618968 w 1286353"/>
              <a:gd name="connsiteY6" fmla="*/ 26631 h 1340829"/>
              <a:gd name="connsiteX7" fmla="*/ 713042 w 1286353"/>
              <a:gd name="connsiteY7" fmla="*/ 52971 h 1340829"/>
              <a:gd name="connsiteX8" fmla="*/ 795827 w 1286353"/>
              <a:gd name="connsiteY8" fmla="*/ 37919 h 1340829"/>
              <a:gd name="connsiteX9" fmla="*/ 814642 w 1286353"/>
              <a:gd name="connsiteY9" fmla="*/ 124468 h 1340829"/>
              <a:gd name="connsiteX10" fmla="*/ 840983 w 1286353"/>
              <a:gd name="connsiteY10" fmla="*/ 165860 h 1340829"/>
              <a:gd name="connsiteX11" fmla="*/ 920005 w 1286353"/>
              <a:gd name="connsiteY11" fmla="*/ 150808 h 1340829"/>
              <a:gd name="connsiteX12" fmla="*/ 950109 w 1286353"/>
              <a:gd name="connsiteY12" fmla="*/ 259934 h 1340829"/>
              <a:gd name="connsiteX13" fmla="*/ 1044183 w 1286353"/>
              <a:gd name="connsiteY13" fmla="*/ 244882 h 1340829"/>
              <a:gd name="connsiteX14" fmla="*/ 1111916 w 1286353"/>
              <a:gd name="connsiteY14" fmla="*/ 237356 h 1340829"/>
              <a:gd name="connsiteX15" fmla="*/ 1217279 w 1286353"/>
              <a:gd name="connsiteY15" fmla="*/ 308853 h 1340829"/>
              <a:gd name="connsiteX16" fmla="*/ 1198464 w 1286353"/>
              <a:gd name="connsiteY16" fmla="*/ 380349 h 1340829"/>
              <a:gd name="connsiteX17" fmla="*/ 1232331 w 1286353"/>
              <a:gd name="connsiteY17" fmla="*/ 459371 h 1340829"/>
              <a:gd name="connsiteX18" fmla="*/ 1285013 w 1286353"/>
              <a:gd name="connsiteY18" fmla="*/ 512053 h 1340829"/>
              <a:gd name="connsiteX19" fmla="*/ 1269961 w 1286353"/>
              <a:gd name="connsiteY19" fmla="*/ 583549 h 1340829"/>
              <a:gd name="connsiteX20" fmla="*/ 1262435 w 1286353"/>
              <a:gd name="connsiteY20" fmla="*/ 658808 h 1340829"/>
              <a:gd name="connsiteX21" fmla="*/ 1269961 w 1286353"/>
              <a:gd name="connsiteY21" fmla="*/ 715253 h 1340829"/>
              <a:gd name="connsiteX22" fmla="*/ 1217279 w 1286353"/>
              <a:gd name="connsiteY22" fmla="*/ 782986 h 1340829"/>
              <a:gd name="connsiteX23" fmla="*/ 1164598 w 1286353"/>
              <a:gd name="connsiteY23" fmla="*/ 880823 h 1340829"/>
              <a:gd name="connsiteX24" fmla="*/ 1149546 w 1286353"/>
              <a:gd name="connsiteY24" fmla="*/ 956082 h 1340829"/>
              <a:gd name="connsiteX25" fmla="*/ 1078249 w 1286353"/>
              <a:gd name="connsiteY25" fmla="*/ 1058166 h 1340829"/>
              <a:gd name="connsiteX26" fmla="*/ 1036007 w 1286353"/>
              <a:gd name="connsiteY26" fmla="*/ 1067473 h 1340829"/>
              <a:gd name="connsiteX27" fmla="*/ 976450 w 1286353"/>
              <a:gd name="connsiteY27" fmla="*/ 1117890 h 1340829"/>
              <a:gd name="connsiteX28" fmla="*/ 957635 w 1286353"/>
              <a:gd name="connsiteY28" fmla="*/ 1223253 h 1340829"/>
              <a:gd name="connsiteX29" fmla="*/ 882375 w 1286353"/>
              <a:gd name="connsiteY29" fmla="*/ 1275934 h 1340829"/>
              <a:gd name="connsiteX30" fmla="*/ 863561 w 1286353"/>
              <a:gd name="connsiteY30" fmla="*/ 1324853 h 1340829"/>
              <a:gd name="connsiteX31" fmla="*/ 792064 w 1286353"/>
              <a:gd name="connsiteY31" fmla="*/ 1321090 h 1340829"/>
              <a:gd name="connsiteX32" fmla="*/ 682938 w 1286353"/>
              <a:gd name="connsiteY32" fmla="*/ 1339905 h 1340829"/>
              <a:gd name="connsiteX33" fmla="*/ 547472 w 1286353"/>
              <a:gd name="connsiteY33" fmla="*/ 1287223 h 1340829"/>
              <a:gd name="connsiteX34" fmla="*/ 498553 w 1286353"/>
              <a:gd name="connsiteY34" fmla="*/ 1253356 h 1340829"/>
              <a:gd name="connsiteX35" fmla="*/ 427057 w 1286353"/>
              <a:gd name="connsiteY35" fmla="*/ 1193149 h 1340829"/>
              <a:gd name="connsiteX36" fmla="*/ 351798 w 1286353"/>
              <a:gd name="connsiteY36" fmla="*/ 1170571 h 1340829"/>
              <a:gd name="connsiteX37" fmla="*/ 336746 w 1286353"/>
              <a:gd name="connsiteY37" fmla="*/ 1125416 h 1340829"/>
              <a:gd name="connsiteX38" fmla="*/ 306642 w 1286353"/>
              <a:gd name="connsiteY38" fmla="*/ 1076497 h 1340829"/>
              <a:gd name="connsiteX39" fmla="*/ 193753 w 1286353"/>
              <a:gd name="connsiteY39" fmla="*/ 1046394 h 1340829"/>
              <a:gd name="connsiteX40" fmla="*/ 137309 w 1286353"/>
              <a:gd name="connsiteY40" fmla="*/ 982423 h 1340829"/>
              <a:gd name="connsiteX41" fmla="*/ 54524 w 1286353"/>
              <a:gd name="connsiteY41" fmla="*/ 978660 h 1340829"/>
              <a:gd name="connsiteX42" fmla="*/ 1842 w 1286353"/>
              <a:gd name="connsiteY42" fmla="*/ 910927 h 1340829"/>
              <a:gd name="connsiteX43" fmla="*/ 13131 w 1286353"/>
              <a:gd name="connsiteY43" fmla="*/ 737831 h 1340829"/>
              <a:gd name="connsiteX44" fmla="*/ 24420 w 1286353"/>
              <a:gd name="connsiteY44" fmla="*/ 606127 h 1340829"/>
              <a:gd name="connsiteX45" fmla="*/ 5605 w 1286353"/>
              <a:gd name="connsiteY45" fmla="*/ 481949 h 1340829"/>
              <a:gd name="connsiteX46" fmla="*/ 65813 w 1286353"/>
              <a:gd name="connsiteY46" fmla="*/ 417979 h 1340829"/>
              <a:gd name="connsiteX47" fmla="*/ 174938 w 1286353"/>
              <a:gd name="connsiteY47" fmla="*/ 346482 h 1340829"/>
              <a:gd name="connsiteX48" fmla="*/ 212568 w 1286353"/>
              <a:gd name="connsiteY48" fmla="*/ 308853 h 1340829"/>
              <a:gd name="connsiteX49" fmla="*/ 246435 w 1286353"/>
              <a:gd name="connsiteY49" fmla="*/ 222305 h 1340829"/>
              <a:gd name="connsiteX0" fmla="*/ 246435 w 1286353"/>
              <a:gd name="connsiteY0" fmla="*/ 222305 h 1340829"/>
              <a:gd name="connsiteX1" fmla="*/ 321694 w 1286353"/>
              <a:gd name="connsiteY1" fmla="*/ 207253 h 1340829"/>
              <a:gd name="connsiteX2" fmla="*/ 381901 w 1286353"/>
              <a:gd name="connsiteY2" fmla="*/ 162097 h 1340829"/>
              <a:gd name="connsiteX3" fmla="*/ 408242 w 1286353"/>
              <a:gd name="connsiteY3" fmla="*/ 64260 h 1340829"/>
              <a:gd name="connsiteX4" fmla="*/ 438346 w 1286353"/>
              <a:gd name="connsiteY4" fmla="*/ 4053 h 1340829"/>
              <a:gd name="connsiteX5" fmla="*/ 528657 w 1286353"/>
              <a:gd name="connsiteY5" fmla="*/ 7816 h 1340829"/>
              <a:gd name="connsiteX6" fmla="*/ 618968 w 1286353"/>
              <a:gd name="connsiteY6" fmla="*/ 26631 h 1340829"/>
              <a:gd name="connsiteX7" fmla="*/ 713042 w 1286353"/>
              <a:gd name="connsiteY7" fmla="*/ 52971 h 1340829"/>
              <a:gd name="connsiteX8" fmla="*/ 795827 w 1286353"/>
              <a:gd name="connsiteY8" fmla="*/ 37919 h 1340829"/>
              <a:gd name="connsiteX9" fmla="*/ 814642 w 1286353"/>
              <a:gd name="connsiteY9" fmla="*/ 124468 h 1340829"/>
              <a:gd name="connsiteX10" fmla="*/ 840983 w 1286353"/>
              <a:gd name="connsiteY10" fmla="*/ 165860 h 1340829"/>
              <a:gd name="connsiteX11" fmla="*/ 920005 w 1286353"/>
              <a:gd name="connsiteY11" fmla="*/ 150808 h 1340829"/>
              <a:gd name="connsiteX12" fmla="*/ 950109 w 1286353"/>
              <a:gd name="connsiteY12" fmla="*/ 259934 h 1340829"/>
              <a:gd name="connsiteX13" fmla="*/ 1044183 w 1286353"/>
              <a:gd name="connsiteY13" fmla="*/ 244882 h 1340829"/>
              <a:gd name="connsiteX14" fmla="*/ 1111916 w 1286353"/>
              <a:gd name="connsiteY14" fmla="*/ 237356 h 1340829"/>
              <a:gd name="connsiteX15" fmla="*/ 1217279 w 1286353"/>
              <a:gd name="connsiteY15" fmla="*/ 308853 h 1340829"/>
              <a:gd name="connsiteX16" fmla="*/ 1198464 w 1286353"/>
              <a:gd name="connsiteY16" fmla="*/ 380349 h 1340829"/>
              <a:gd name="connsiteX17" fmla="*/ 1232331 w 1286353"/>
              <a:gd name="connsiteY17" fmla="*/ 459371 h 1340829"/>
              <a:gd name="connsiteX18" fmla="*/ 1285013 w 1286353"/>
              <a:gd name="connsiteY18" fmla="*/ 512053 h 1340829"/>
              <a:gd name="connsiteX19" fmla="*/ 1269961 w 1286353"/>
              <a:gd name="connsiteY19" fmla="*/ 583549 h 1340829"/>
              <a:gd name="connsiteX20" fmla="*/ 1262435 w 1286353"/>
              <a:gd name="connsiteY20" fmla="*/ 658808 h 1340829"/>
              <a:gd name="connsiteX21" fmla="*/ 1269961 w 1286353"/>
              <a:gd name="connsiteY21" fmla="*/ 715253 h 1340829"/>
              <a:gd name="connsiteX22" fmla="*/ 1217279 w 1286353"/>
              <a:gd name="connsiteY22" fmla="*/ 782986 h 1340829"/>
              <a:gd name="connsiteX23" fmla="*/ 1164598 w 1286353"/>
              <a:gd name="connsiteY23" fmla="*/ 880823 h 1340829"/>
              <a:gd name="connsiteX24" fmla="*/ 1149546 w 1286353"/>
              <a:gd name="connsiteY24" fmla="*/ 956082 h 1340829"/>
              <a:gd name="connsiteX25" fmla="*/ 1078249 w 1286353"/>
              <a:gd name="connsiteY25" fmla="*/ 1058166 h 1340829"/>
              <a:gd name="connsiteX26" fmla="*/ 1015777 w 1286353"/>
              <a:gd name="connsiteY26" fmla="*/ 1071519 h 1340829"/>
              <a:gd name="connsiteX27" fmla="*/ 976450 w 1286353"/>
              <a:gd name="connsiteY27" fmla="*/ 1117890 h 1340829"/>
              <a:gd name="connsiteX28" fmla="*/ 957635 w 1286353"/>
              <a:gd name="connsiteY28" fmla="*/ 1223253 h 1340829"/>
              <a:gd name="connsiteX29" fmla="*/ 882375 w 1286353"/>
              <a:gd name="connsiteY29" fmla="*/ 1275934 h 1340829"/>
              <a:gd name="connsiteX30" fmla="*/ 863561 w 1286353"/>
              <a:gd name="connsiteY30" fmla="*/ 1324853 h 1340829"/>
              <a:gd name="connsiteX31" fmla="*/ 792064 w 1286353"/>
              <a:gd name="connsiteY31" fmla="*/ 1321090 h 1340829"/>
              <a:gd name="connsiteX32" fmla="*/ 682938 w 1286353"/>
              <a:gd name="connsiteY32" fmla="*/ 1339905 h 1340829"/>
              <a:gd name="connsiteX33" fmla="*/ 547472 w 1286353"/>
              <a:gd name="connsiteY33" fmla="*/ 1287223 h 1340829"/>
              <a:gd name="connsiteX34" fmla="*/ 498553 w 1286353"/>
              <a:gd name="connsiteY34" fmla="*/ 1253356 h 1340829"/>
              <a:gd name="connsiteX35" fmla="*/ 427057 w 1286353"/>
              <a:gd name="connsiteY35" fmla="*/ 1193149 h 1340829"/>
              <a:gd name="connsiteX36" fmla="*/ 351798 w 1286353"/>
              <a:gd name="connsiteY36" fmla="*/ 1170571 h 1340829"/>
              <a:gd name="connsiteX37" fmla="*/ 336746 w 1286353"/>
              <a:gd name="connsiteY37" fmla="*/ 1125416 h 1340829"/>
              <a:gd name="connsiteX38" fmla="*/ 306642 w 1286353"/>
              <a:gd name="connsiteY38" fmla="*/ 1076497 h 1340829"/>
              <a:gd name="connsiteX39" fmla="*/ 193753 w 1286353"/>
              <a:gd name="connsiteY39" fmla="*/ 1046394 h 1340829"/>
              <a:gd name="connsiteX40" fmla="*/ 137309 w 1286353"/>
              <a:gd name="connsiteY40" fmla="*/ 982423 h 1340829"/>
              <a:gd name="connsiteX41" fmla="*/ 54524 w 1286353"/>
              <a:gd name="connsiteY41" fmla="*/ 978660 h 1340829"/>
              <a:gd name="connsiteX42" fmla="*/ 1842 w 1286353"/>
              <a:gd name="connsiteY42" fmla="*/ 910927 h 1340829"/>
              <a:gd name="connsiteX43" fmla="*/ 13131 w 1286353"/>
              <a:gd name="connsiteY43" fmla="*/ 737831 h 1340829"/>
              <a:gd name="connsiteX44" fmla="*/ 24420 w 1286353"/>
              <a:gd name="connsiteY44" fmla="*/ 606127 h 1340829"/>
              <a:gd name="connsiteX45" fmla="*/ 5605 w 1286353"/>
              <a:gd name="connsiteY45" fmla="*/ 481949 h 1340829"/>
              <a:gd name="connsiteX46" fmla="*/ 65813 w 1286353"/>
              <a:gd name="connsiteY46" fmla="*/ 417979 h 1340829"/>
              <a:gd name="connsiteX47" fmla="*/ 174938 w 1286353"/>
              <a:gd name="connsiteY47" fmla="*/ 346482 h 1340829"/>
              <a:gd name="connsiteX48" fmla="*/ 212568 w 1286353"/>
              <a:gd name="connsiteY48" fmla="*/ 308853 h 1340829"/>
              <a:gd name="connsiteX49" fmla="*/ 246435 w 1286353"/>
              <a:gd name="connsiteY49" fmla="*/ 222305 h 1340829"/>
              <a:gd name="connsiteX0" fmla="*/ 246435 w 1286353"/>
              <a:gd name="connsiteY0" fmla="*/ 222305 h 1340829"/>
              <a:gd name="connsiteX1" fmla="*/ 321694 w 1286353"/>
              <a:gd name="connsiteY1" fmla="*/ 207253 h 1340829"/>
              <a:gd name="connsiteX2" fmla="*/ 381901 w 1286353"/>
              <a:gd name="connsiteY2" fmla="*/ 162097 h 1340829"/>
              <a:gd name="connsiteX3" fmla="*/ 408242 w 1286353"/>
              <a:gd name="connsiteY3" fmla="*/ 64260 h 1340829"/>
              <a:gd name="connsiteX4" fmla="*/ 438346 w 1286353"/>
              <a:gd name="connsiteY4" fmla="*/ 4053 h 1340829"/>
              <a:gd name="connsiteX5" fmla="*/ 528657 w 1286353"/>
              <a:gd name="connsiteY5" fmla="*/ 7816 h 1340829"/>
              <a:gd name="connsiteX6" fmla="*/ 618968 w 1286353"/>
              <a:gd name="connsiteY6" fmla="*/ 26631 h 1340829"/>
              <a:gd name="connsiteX7" fmla="*/ 713042 w 1286353"/>
              <a:gd name="connsiteY7" fmla="*/ 52971 h 1340829"/>
              <a:gd name="connsiteX8" fmla="*/ 795827 w 1286353"/>
              <a:gd name="connsiteY8" fmla="*/ 37919 h 1340829"/>
              <a:gd name="connsiteX9" fmla="*/ 814642 w 1286353"/>
              <a:gd name="connsiteY9" fmla="*/ 124468 h 1340829"/>
              <a:gd name="connsiteX10" fmla="*/ 840983 w 1286353"/>
              <a:gd name="connsiteY10" fmla="*/ 165860 h 1340829"/>
              <a:gd name="connsiteX11" fmla="*/ 920005 w 1286353"/>
              <a:gd name="connsiteY11" fmla="*/ 150808 h 1340829"/>
              <a:gd name="connsiteX12" fmla="*/ 950109 w 1286353"/>
              <a:gd name="connsiteY12" fmla="*/ 259934 h 1340829"/>
              <a:gd name="connsiteX13" fmla="*/ 1044183 w 1286353"/>
              <a:gd name="connsiteY13" fmla="*/ 244882 h 1340829"/>
              <a:gd name="connsiteX14" fmla="*/ 1111916 w 1286353"/>
              <a:gd name="connsiteY14" fmla="*/ 237356 h 1340829"/>
              <a:gd name="connsiteX15" fmla="*/ 1217279 w 1286353"/>
              <a:gd name="connsiteY15" fmla="*/ 308853 h 1340829"/>
              <a:gd name="connsiteX16" fmla="*/ 1198464 w 1286353"/>
              <a:gd name="connsiteY16" fmla="*/ 380349 h 1340829"/>
              <a:gd name="connsiteX17" fmla="*/ 1232331 w 1286353"/>
              <a:gd name="connsiteY17" fmla="*/ 459371 h 1340829"/>
              <a:gd name="connsiteX18" fmla="*/ 1285013 w 1286353"/>
              <a:gd name="connsiteY18" fmla="*/ 512053 h 1340829"/>
              <a:gd name="connsiteX19" fmla="*/ 1269961 w 1286353"/>
              <a:gd name="connsiteY19" fmla="*/ 583549 h 1340829"/>
              <a:gd name="connsiteX20" fmla="*/ 1262435 w 1286353"/>
              <a:gd name="connsiteY20" fmla="*/ 658808 h 1340829"/>
              <a:gd name="connsiteX21" fmla="*/ 1269961 w 1286353"/>
              <a:gd name="connsiteY21" fmla="*/ 715253 h 1340829"/>
              <a:gd name="connsiteX22" fmla="*/ 1217279 w 1286353"/>
              <a:gd name="connsiteY22" fmla="*/ 782986 h 1340829"/>
              <a:gd name="connsiteX23" fmla="*/ 1164598 w 1286353"/>
              <a:gd name="connsiteY23" fmla="*/ 880823 h 1340829"/>
              <a:gd name="connsiteX24" fmla="*/ 1149546 w 1286353"/>
              <a:gd name="connsiteY24" fmla="*/ 956082 h 1340829"/>
              <a:gd name="connsiteX25" fmla="*/ 1078249 w 1286353"/>
              <a:gd name="connsiteY25" fmla="*/ 1058166 h 1340829"/>
              <a:gd name="connsiteX26" fmla="*/ 1015777 w 1286353"/>
              <a:gd name="connsiteY26" fmla="*/ 1071519 h 1340829"/>
              <a:gd name="connsiteX27" fmla="*/ 976450 w 1286353"/>
              <a:gd name="connsiteY27" fmla="*/ 1117890 h 1340829"/>
              <a:gd name="connsiteX28" fmla="*/ 957635 w 1286353"/>
              <a:gd name="connsiteY28" fmla="*/ 1223253 h 1340829"/>
              <a:gd name="connsiteX29" fmla="*/ 882375 w 1286353"/>
              <a:gd name="connsiteY29" fmla="*/ 1275934 h 1340829"/>
              <a:gd name="connsiteX30" fmla="*/ 863561 w 1286353"/>
              <a:gd name="connsiteY30" fmla="*/ 1324853 h 1340829"/>
              <a:gd name="connsiteX31" fmla="*/ 792064 w 1286353"/>
              <a:gd name="connsiteY31" fmla="*/ 1321090 h 1340829"/>
              <a:gd name="connsiteX32" fmla="*/ 682938 w 1286353"/>
              <a:gd name="connsiteY32" fmla="*/ 1339905 h 1340829"/>
              <a:gd name="connsiteX33" fmla="*/ 547472 w 1286353"/>
              <a:gd name="connsiteY33" fmla="*/ 1287223 h 1340829"/>
              <a:gd name="connsiteX34" fmla="*/ 498553 w 1286353"/>
              <a:gd name="connsiteY34" fmla="*/ 1253356 h 1340829"/>
              <a:gd name="connsiteX35" fmla="*/ 427057 w 1286353"/>
              <a:gd name="connsiteY35" fmla="*/ 1193149 h 1340829"/>
              <a:gd name="connsiteX36" fmla="*/ 351798 w 1286353"/>
              <a:gd name="connsiteY36" fmla="*/ 1170571 h 1340829"/>
              <a:gd name="connsiteX37" fmla="*/ 336746 w 1286353"/>
              <a:gd name="connsiteY37" fmla="*/ 1125416 h 1340829"/>
              <a:gd name="connsiteX38" fmla="*/ 306642 w 1286353"/>
              <a:gd name="connsiteY38" fmla="*/ 1076497 h 1340829"/>
              <a:gd name="connsiteX39" fmla="*/ 193753 w 1286353"/>
              <a:gd name="connsiteY39" fmla="*/ 1046394 h 1340829"/>
              <a:gd name="connsiteX40" fmla="*/ 137309 w 1286353"/>
              <a:gd name="connsiteY40" fmla="*/ 982423 h 1340829"/>
              <a:gd name="connsiteX41" fmla="*/ 54524 w 1286353"/>
              <a:gd name="connsiteY41" fmla="*/ 978660 h 1340829"/>
              <a:gd name="connsiteX42" fmla="*/ 1842 w 1286353"/>
              <a:gd name="connsiteY42" fmla="*/ 910927 h 1340829"/>
              <a:gd name="connsiteX43" fmla="*/ 13131 w 1286353"/>
              <a:gd name="connsiteY43" fmla="*/ 737831 h 1340829"/>
              <a:gd name="connsiteX44" fmla="*/ 24420 w 1286353"/>
              <a:gd name="connsiteY44" fmla="*/ 606127 h 1340829"/>
              <a:gd name="connsiteX45" fmla="*/ 5605 w 1286353"/>
              <a:gd name="connsiteY45" fmla="*/ 481949 h 1340829"/>
              <a:gd name="connsiteX46" fmla="*/ 57931 w 1286353"/>
              <a:gd name="connsiteY46" fmla="*/ 390389 h 1340829"/>
              <a:gd name="connsiteX47" fmla="*/ 174938 w 1286353"/>
              <a:gd name="connsiteY47" fmla="*/ 346482 h 1340829"/>
              <a:gd name="connsiteX48" fmla="*/ 212568 w 1286353"/>
              <a:gd name="connsiteY48" fmla="*/ 308853 h 1340829"/>
              <a:gd name="connsiteX49" fmla="*/ 246435 w 1286353"/>
              <a:gd name="connsiteY49" fmla="*/ 222305 h 1340829"/>
              <a:gd name="connsiteX0" fmla="*/ 246435 w 1286353"/>
              <a:gd name="connsiteY0" fmla="*/ 222305 h 1340829"/>
              <a:gd name="connsiteX1" fmla="*/ 321694 w 1286353"/>
              <a:gd name="connsiteY1" fmla="*/ 207253 h 1340829"/>
              <a:gd name="connsiteX2" fmla="*/ 381901 w 1286353"/>
              <a:gd name="connsiteY2" fmla="*/ 162097 h 1340829"/>
              <a:gd name="connsiteX3" fmla="*/ 408242 w 1286353"/>
              <a:gd name="connsiteY3" fmla="*/ 64260 h 1340829"/>
              <a:gd name="connsiteX4" fmla="*/ 438346 w 1286353"/>
              <a:gd name="connsiteY4" fmla="*/ 4053 h 1340829"/>
              <a:gd name="connsiteX5" fmla="*/ 528657 w 1286353"/>
              <a:gd name="connsiteY5" fmla="*/ 7816 h 1340829"/>
              <a:gd name="connsiteX6" fmla="*/ 618968 w 1286353"/>
              <a:gd name="connsiteY6" fmla="*/ 26631 h 1340829"/>
              <a:gd name="connsiteX7" fmla="*/ 713042 w 1286353"/>
              <a:gd name="connsiteY7" fmla="*/ 52971 h 1340829"/>
              <a:gd name="connsiteX8" fmla="*/ 795827 w 1286353"/>
              <a:gd name="connsiteY8" fmla="*/ 37919 h 1340829"/>
              <a:gd name="connsiteX9" fmla="*/ 814642 w 1286353"/>
              <a:gd name="connsiteY9" fmla="*/ 124468 h 1340829"/>
              <a:gd name="connsiteX10" fmla="*/ 840983 w 1286353"/>
              <a:gd name="connsiteY10" fmla="*/ 165860 h 1340829"/>
              <a:gd name="connsiteX11" fmla="*/ 920005 w 1286353"/>
              <a:gd name="connsiteY11" fmla="*/ 150808 h 1340829"/>
              <a:gd name="connsiteX12" fmla="*/ 950109 w 1286353"/>
              <a:gd name="connsiteY12" fmla="*/ 259934 h 1340829"/>
              <a:gd name="connsiteX13" fmla="*/ 1044183 w 1286353"/>
              <a:gd name="connsiteY13" fmla="*/ 244882 h 1340829"/>
              <a:gd name="connsiteX14" fmla="*/ 1111916 w 1286353"/>
              <a:gd name="connsiteY14" fmla="*/ 237356 h 1340829"/>
              <a:gd name="connsiteX15" fmla="*/ 1217279 w 1286353"/>
              <a:gd name="connsiteY15" fmla="*/ 308853 h 1340829"/>
              <a:gd name="connsiteX16" fmla="*/ 1198464 w 1286353"/>
              <a:gd name="connsiteY16" fmla="*/ 380349 h 1340829"/>
              <a:gd name="connsiteX17" fmla="*/ 1232331 w 1286353"/>
              <a:gd name="connsiteY17" fmla="*/ 459371 h 1340829"/>
              <a:gd name="connsiteX18" fmla="*/ 1285013 w 1286353"/>
              <a:gd name="connsiteY18" fmla="*/ 512053 h 1340829"/>
              <a:gd name="connsiteX19" fmla="*/ 1269961 w 1286353"/>
              <a:gd name="connsiteY19" fmla="*/ 583549 h 1340829"/>
              <a:gd name="connsiteX20" fmla="*/ 1262435 w 1286353"/>
              <a:gd name="connsiteY20" fmla="*/ 658808 h 1340829"/>
              <a:gd name="connsiteX21" fmla="*/ 1269961 w 1286353"/>
              <a:gd name="connsiteY21" fmla="*/ 715253 h 1340829"/>
              <a:gd name="connsiteX22" fmla="*/ 1217279 w 1286353"/>
              <a:gd name="connsiteY22" fmla="*/ 782986 h 1340829"/>
              <a:gd name="connsiteX23" fmla="*/ 1164598 w 1286353"/>
              <a:gd name="connsiteY23" fmla="*/ 880823 h 1340829"/>
              <a:gd name="connsiteX24" fmla="*/ 1149546 w 1286353"/>
              <a:gd name="connsiteY24" fmla="*/ 956082 h 1340829"/>
              <a:gd name="connsiteX25" fmla="*/ 1078249 w 1286353"/>
              <a:gd name="connsiteY25" fmla="*/ 1058166 h 1340829"/>
              <a:gd name="connsiteX26" fmla="*/ 1015777 w 1286353"/>
              <a:gd name="connsiteY26" fmla="*/ 1071519 h 1340829"/>
              <a:gd name="connsiteX27" fmla="*/ 976450 w 1286353"/>
              <a:gd name="connsiteY27" fmla="*/ 1117890 h 1340829"/>
              <a:gd name="connsiteX28" fmla="*/ 957635 w 1286353"/>
              <a:gd name="connsiteY28" fmla="*/ 1223253 h 1340829"/>
              <a:gd name="connsiteX29" fmla="*/ 882375 w 1286353"/>
              <a:gd name="connsiteY29" fmla="*/ 1275934 h 1340829"/>
              <a:gd name="connsiteX30" fmla="*/ 863561 w 1286353"/>
              <a:gd name="connsiteY30" fmla="*/ 1324853 h 1340829"/>
              <a:gd name="connsiteX31" fmla="*/ 792064 w 1286353"/>
              <a:gd name="connsiteY31" fmla="*/ 1321090 h 1340829"/>
              <a:gd name="connsiteX32" fmla="*/ 682938 w 1286353"/>
              <a:gd name="connsiteY32" fmla="*/ 1339905 h 1340829"/>
              <a:gd name="connsiteX33" fmla="*/ 547472 w 1286353"/>
              <a:gd name="connsiteY33" fmla="*/ 1287223 h 1340829"/>
              <a:gd name="connsiteX34" fmla="*/ 498553 w 1286353"/>
              <a:gd name="connsiteY34" fmla="*/ 1253356 h 1340829"/>
              <a:gd name="connsiteX35" fmla="*/ 427057 w 1286353"/>
              <a:gd name="connsiteY35" fmla="*/ 1193149 h 1340829"/>
              <a:gd name="connsiteX36" fmla="*/ 351798 w 1286353"/>
              <a:gd name="connsiteY36" fmla="*/ 1170571 h 1340829"/>
              <a:gd name="connsiteX37" fmla="*/ 336746 w 1286353"/>
              <a:gd name="connsiteY37" fmla="*/ 1125416 h 1340829"/>
              <a:gd name="connsiteX38" fmla="*/ 306642 w 1286353"/>
              <a:gd name="connsiteY38" fmla="*/ 1076497 h 1340829"/>
              <a:gd name="connsiteX39" fmla="*/ 193753 w 1286353"/>
              <a:gd name="connsiteY39" fmla="*/ 1046394 h 1340829"/>
              <a:gd name="connsiteX40" fmla="*/ 137309 w 1286353"/>
              <a:gd name="connsiteY40" fmla="*/ 982423 h 1340829"/>
              <a:gd name="connsiteX41" fmla="*/ 54524 w 1286353"/>
              <a:gd name="connsiteY41" fmla="*/ 978660 h 1340829"/>
              <a:gd name="connsiteX42" fmla="*/ 1842 w 1286353"/>
              <a:gd name="connsiteY42" fmla="*/ 910927 h 1340829"/>
              <a:gd name="connsiteX43" fmla="*/ 13131 w 1286353"/>
              <a:gd name="connsiteY43" fmla="*/ 737831 h 1340829"/>
              <a:gd name="connsiteX44" fmla="*/ 24420 w 1286353"/>
              <a:gd name="connsiteY44" fmla="*/ 606127 h 1340829"/>
              <a:gd name="connsiteX45" fmla="*/ 5605 w 1286353"/>
              <a:gd name="connsiteY45" fmla="*/ 481949 h 1340829"/>
              <a:gd name="connsiteX46" fmla="*/ 57931 w 1286353"/>
              <a:gd name="connsiteY46" fmla="*/ 390389 h 1340829"/>
              <a:gd name="connsiteX47" fmla="*/ 174938 w 1286353"/>
              <a:gd name="connsiteY47" fmla="*/ 346482 h 1340829"/>
              <a:gd name="connsiteX48" fmla="*/ 212568 w 1286353"/>
              <a:gd name="connsiteY48" fmla="*/ 308853 h 1340829"/>
              <a:gd name="connsiteX49" fmla="*/ 246435 w 1286353"/>
              <a:gd name="connsiteY49" fmla="*/ 222305 h 134082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</a:cxnLst>
            <a:rect l="l" t="t" r="r" b="b"/>
            <a:pathLst>
              <a:path w="1286353" h="1340829">
                <a:moveTo>
                  <a:pt x="246435" y="222305"/>
                </a:moveTo>
                <a:cubicBezTo>
                  <a:pt x="264623" y="205372"/>
                  <a:pt x="299116" y="217288"/>
                  <a:pt x="321694" y="207253"/>
                </a:cubicBezTo>
                <a:cubicBezTo>
                  <a:pt x="344272" y="197218"/>
                  <a:pt x="367476" y="185929"/>
                  <a:pt x="381901" y="162097"/>
                </a:cubicBezTo>
                <a:cubicBezTo>
                  <a:pt x="396326" y="138265"/>
                  <a:pt x="398835" y="90601"/>
                  <a:pt x="408242" y="64260"/>
                </a:cubicBezTo>
                <a:cubicBezTo>
                  <a:pt x="417649" y="37919"/>
                  <a:pt x="418277" y="13460"/>
                  <a:pt x="438346" y="4053"/>
                </a:cubicBezTo>
                <a:cubicBezTo>
                  <a:pt x="458415" y="-5354"/>
                  <a:pt x="498553" y="4053"/>
                  <a:pt x="528657" y="7816"/>
                </a:cubicBezTo>
                <a:cubicBezTo>
                  <a:pt x="558761" y="11579"/>
                  <a:pt x="588237" y="19105"/>
                  <a:pt x="618968" y="26631"/>
                </a:cubicBezTo>
                <a:cubicBezTo>
                  <a:pt x="649699" y="34157"/>
                  <a:pt x="683566" y="51090"/>
                  <a:pt x="713042" y="52971"/>
                </a:cubicBezTo>
                <a:cubicBezTo>
                  <a:pt x="742518" y="54852"/>
                  <a:pt x="778894" y="26003"/>
                  <a:pt x="795827" y="37919"/>
                </a:cubicBezTo>
                <a:cubicBezTo>
                  <a:pt x="812760" y="49835"/>
                  <a:pt x="807116" y="103145"/>
                  <a:pt x="814642" y="124468"/>
                </a:cubicBezTo>
                <a:cubicBezTo>
                  <a:pt x="822168" y="145791"/>
                  <a:pt x="823423" y="161470"/>
                  <a:pt x="840983" y="165860"/>
                </a:cubicBezTo>
                <a:cubicBezTo>
                  <a:pt x="858544" y="170250"/>
                  <a:pt x="901817" y="135129"/>
                  <a:pt x="920005" y="150808"/>
                </a:cubicBezTo>
                <a:cubicBezTo>
                  <a:pt x="938193" y="166487"/>
                  <a:pt x="929413" y="244255"/>
                  <a:pt x="950109" y="259934"/>
                </a:cubicBezTo>
                <a:cubicBezTo>
                  <a:pt x="970805" y="275613"/>
                  <a:pt x="1017215" y="248645"/>
                  <a:pt x="1044183" y="244882"/>
                </a:cubicBezTo>
                <a:cubicBezTo>
                  <a:pt x="1071151" y="241119"/>
                  <a:pt x="1083067" y="226694"/>
                  <a:pt x="1111916" y="237356"/>
                </a:cubicBezTo>
                <a:cubicBezTo>
                  <a:pt x="1140765" y="248018"/>
                  <a:pt x="1202854" y="285021"/>
                  <a:pt x="1217279" y="308853"/>
                </a:cubicBezTo>
                <a:cubicBezTo>
                  <a:pt x="1231704" y="332685"/>
                  <a:pt x="1195955" y="355263"/>
                  <a:pt x="1198464" y="380349"/>
                </a:cubicBezTo>
                <a:cubicBezTo>
                  <a:pt x="1200973" y="405435"/>
                  <a:pt x="1217906" y="437420"/>
                  <a:pt x="1232331" y="459371"/>
                </a:cubicBezTo>
                <a:cubicBezTo>
                  <a:pt x="1246756" y="481322"/>
                  <a:pt x="1278741" y="491357"/>
                  <a:pt x="1285013" y="512053"/>
                </a:cubicBezTo>
                <a:cubicBezTo>
                  <a:pt x="1291285" y="532749"/>
                  <a:pt x="1273724" y="559090"/>
                  <a:pt x="1269961" y="583549"/>
                </a:cubicBezTo>
                <a:cubicBezTo>
                  <a:pt x="1266198" y="608008"/>
                  <a:pt x="1262435" y="636857"/>
                  <a:pt x="1262435" y="658808"/>
                </a:cubicBezTo>
                <a:cubicBezTo>
                  <a:pt x="1262435" y="680759"/>
                  <a:pt x="1277487" y="694557"/>
                  <a:pt x="1269961" y="715253"/>
                </a:cubicBezTo>
                <a:cubicBezTo>
                  <a:pt x="1262435" y="735949"/>
                  <a:pt x="1234839" y="755391"/>
                  <a:pt x="1217279" y="782986"/>
                </a:cubicBezTo>
                <a:cubicBezTo>
                  <a:pt x="1199719" y="810581"/>
                  <a:pt x="1175887" y="851974"/>
                  <a:pt x="1164598" y="880823"/>
                </a:cubicBezTo>
                <a:cubicBezTo>
                  <a:pt x="1153309" y="909672"/>
                  <a:pt x="1163938" y="926525"/>
                  <a:pt x="1149546" y="956082"/>
                </a:cubicBezTo>
                <a:cubicBezTo>
                  <a:pt x="1135154" y="985639"/>
                  <a:pt x="1100544" y="1038927"/>
                  <a:pt x="1078249" y="1058166"/>
                </a:cubicBezTo>
                <a:cubicBezTo>
                  <a:pt x="1055954" y="1077406"/>
                  <a:pt x="1032743" y="1061565"/>
                  <a:pt x="1015777" y="1071519"/>
                </a:cubicBezTo>
                <a:cubicBezTo>
                  <a:pt x="998811" y="1081473"/>
                  <a:pt x="986140" y="1092601"/>
                  <a:pt x="976450" y="1117890"/>
                </a:cubicBezTo>
                <a:cubicBezTo>
                  <a:pt x="966760" y="1143179"/>
                  <a:pt x="973314" y="1196912"/>
                  <a:pt x="957635" y="1223253"/>
                </a:cubicBezTo>
                <a:cubicBezTo>
                  <a:pt x="941956" y="1249594"/>
                  <a:pt x="898054" y="1259001"/>
                  <a:pt x="882375" y="1275934"/>
                </a:cubicBezTo>
                <a:cubicBezTo>
                  <a:pt x="866696" y="1292867"/>
                  <a:pt x="878613" y="1317327"/>
                  <a:pt x="863561" y="1324853"/>
                </a:cubicBezTo>
                <a:cubicBezTo>
                  <a:pt x="848509" y="1332379"/>
                  <a:pt x="822168" y="1318581"/>
                  <a:pt x="792064" y="1321090"/>
                </a:cubicBezTo>
                <a:cubicBezTo>
                  <a:pt x="761960" y="1323599"/>
                  <a:pt x="723703" y="1345549"/>
                  <a:pt x="682938" y="1339905"/>
                </a:cubicBezTo>
                <a:cubicBezTo>
                  <a:pt x="642173" y="1334261"/>
                  <a:pt x="578203" y="1301648"/>
                  <a:pt x="547472" y="1287223"/>
                </a:cubicBezTo>
                <a:cubicBezTo>
                  <a:pt x="516741" y="1272798"/>
                  <a:pt x="518622" y="1269035"/>
                  <a:pt x="498553" y="1253356"/>
                </a:cubicBezTo>
                <a:cubicBezTo>
                  <a:pt x="478484" y="1237677"/>
                  <a:pt x="451516" y="1206946"/>
                  <a:pt x="427057" y="1193149"/>
                </a:cubicBezTo>
                <a:cubicBezTo>
                  <a:pt x="402598" y="1179352"/>
                  <a:pt x="366850" y="1181860"/>
                  <a:pt x="351798" y="1170571"/>
                </a:cubicBezTo>
                <a:cubicBezTo>
                  <a:pt x="336746" y="1159282"/>
                  <a:pt x="344272" y="1141095"/>
                  <a:pt x="336746" y="1125416"/>
                </a:cubicBezTo>
                <a:cubicBezTo>
                  <a:pt x="329220" y="1109737"/>
                  <a:pt x="330474" y="1089667"/>
                  <a:pt x="306642" y="1076497"/>
                </a:cubicBezTo>
                <a:cubicBezTo>
                  <a:pt x="282810" y="1063327"/>
                  <a:pt x="221975" y="1062073"/>
                  <a:pt x="193753" y="1046394"/>
                </a:cubicBezTo>
                <a:cubicBezTo>
                  <a:pt x="165531" y="1030715"/>
                  <a:pt x="160514" y="993712"/>
                  <a:pt x="137309" y="982423"/>
                </a:cubicBezTo>
                <a:cubicBezTo>
                  <a:pt x="114104" y="971134"/>
                  <a:pt x="77102" y="990576"/>
                  <a:pt x="54524" y="978660"/>
                </a:cubicBezTo>
                <a:cubicBezTo>
                  <a:pt x="31946" y="966744"/>
                  <a:pt x="8741" y="951065"/>
                  <a:pt x="1842" y="910927"/>
                </a:cubicBezTo>
                <a:cubicBezTo>
                  <a:pt x="-5057" y="870789"/>
                  <a:pt x="9368" y="788631"/>
                  <a:pt x="13131" y="737831"/>
                </a:cubicBezTo>
                <a:cubicBezTo>
                  <a:pt x="16894" y="687031"/>
                  <a:pt x="25674" y="648774"/>
                  <a:pt x="24420" y="606127"/>
                </a:cubicBezTo>
                <a:cubicBezTo>
                  <a:pt x="23166" y="563480"/>
                  <a:pt x="20" y="517905"/>
                  <a:pt x="5605" y="481949"/>
                </a:cubicBezTo>
                <a:cubicBezTo>
                  <a:pt x="11190" y="445993"/>
                  <a:pt x="37592" y="412967"/>
                  <a:pt x="57931" y="390389"/>
                </a:cubicBezTo>
                <a:cubicBezTo>
                  <a:pt x="78270" y="367811"/>
                  <a:pt x="150479" y="364670"/>
                  <a:pt x="174938" y="346482"/>
                </a:cubicBezTo>
                <a:cubicBezTo>
                  <a:pt x="199397" y="328294"/>
                  <a:pt x="202533" y="326414"/>
                  <a:pt x="212568" y="308853"/>
                </a:cubicBezTo>
                <a:cubicBezTo>
                  <a:pt x="222603" y="291293"/>
                  <a:pt x="228247" y="239238"/>
                  <a:pt x="246435" y="222305"/>
                </a:cubicBezTo>
                <a:close/>
              </a:path>
            </a:pathLst>
          </a:cu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Freeform 17"/>
          <p:cNvSpPr/>
          <p:nvPr/>
        </p:nvSpPr>
        <p:spPr>
          <a:xfrm>
            <a:off x="1483500" y="4625225"/>
            <a:ext cx="1065130" cy="975028"/>
          </a:xfrm>
          <a:custGeom>
            <a:avLst/>
            <a:gdLst>
              <a:gd name="connsiteX0" fmla="*/ 193288 w 1043387"/>
              <a:gd name="connsiteY0" fmla="*/ 203621 h 975028"/>
              <a:gd name="connsiteX1" fmla="*/ 249732 w 1043387"/>
              <a:gd name="connsiteY1" fmla="*/ 158465 h 975028"/>
              <a:gd name="connsiteX2" fmla="*/ 268547 w 1043387"/>
              <a:gd name="connsiteY2" fmla="*/ 90732 h 975028"/>
              <a:gd name="connsiteX3" fmla="*/ 332518 w 1043387"/>
              <a:gd name="connsiteY3" fmla="*/ 45576 h 975028"/>
              <a:gd name="connsiteX4" fmla="*/ 385199 w 1043387"/>
              <a:gd name="connsiteY4" fmla="*/ 56865 h 975028"/>
              <a:gd name="connsiteX5" fmla="*/ 475510 w 1043387"/>
              <a:gd name="connsiteY5" fmla="*/ 64391 h 975028"/>
              <a:gd name="connsiteX6" fmla="*/ 547006 w 1043387"/>
              <a:gd name="connsiteY6" fmla="*/ 22999 h 975028"/>
              <a:gd name="connsiteX7" fmla="*/ 614740 w 1043387"/>
              <a:gd name="connsiteY7" fmla="*/ 421 h 975028"/>
              <a:gd name="connsiteX8" fmla="*/ 682473 w 1043387"/>
              <a:gd name="connsiteY8" fmla="*/ 41813 h 975028"/>
              <a:gd name="connsiteX9" fmla="*/ 735155 w 1043387"/>
              <a:gd name="connsiteY9" fmla="*/ 105784 h 975028"/>
              <a:gd name="connsiteX10" fmla="*/ 750206 w 1043387"/>
              <a:gd name="connsiteY10" fmla="*/ 165991 h 975028"/>
              <a:gd name="connsiteX11" fmla="*/ 802888 w 1043387"/>
              <a:gd name="connsiteY11" fmla="*/ 169754 h 975028"/>
              <a:gd name="connsiteX12" fmla="*/ 881910 w 1043387"/>
              <a:gd name="connsiteY12" fmla="*/ 162228 h 975028"/>
              <a:gd name="connsiteX13" fmla="*/ 942118 w 1043387"/>
              <a:gd name="connsiteY13" fmla="*/ 173517 h 975028"/>
              <a:gd name="connsiteX14" fmla="*/ 1002325 w 1043387"/>
              <a:gd name="connsiteY14" fmla="*/ 226199 h 975028"/>
              <a:gd name="connsiteX15" fmla="*/ 1039955 w 1043387"/>
              <a:gd name="connsiteY15" fmla="*/ 282643 h 975028"/>
              <a:gd name="connsiteX16" fmla="*/ 1039955 w 1043387"/>
              <a:gd name="connsiteY16" fmla="*/ 342850 h 975028"/>
              <a:gd name="connsiteX17" fmla="*/ 1024903 w 1043387"/>
              <a:gd name="connsiteY17" fmla="*/ 421873 h 975028"/>
              <a:gd name="connsiteX18" fmla="*/ 945881 w 1043387"/>
              <a:gd name="connsiteY18" fmla="*/ 500895 h 975028"/>
              <a:gd name="connsiteX19" fmla="*/ 919540 w 1043387"/>
              <a:gd name="connsiteY19" fmla="*/ 527236 h 975028"/>
              <a:gd name="connsiteX20" fmla="*/ 844281 w 1043387"/>
              <a:gd name="connsiteY20" fmla="*/ 572391 h 975028"/>
              <a:gd name="connsiteX21" fmla="*/ 829229 w 1043387"/>
              <a:gd name="connsiteY21" fmla="*/ 632599 h 975028"/>
              <a:gd name="connsiteX22" fmla="*/ 799125 w 1043387"/>
              <a:gd name="connsiteY22" fmla="*/ 651413 h 975028"/>
              <a:gd name="connsiteX23" fmla="*/ 810414 w 1043387"/>
              <a:gd name="connsiteY23" fmla="*/ 745487 h 975028"/>
              <a:gd name="connsiteX24" fmla="*/ 795362 w 1043387"/>
              <a:gd name="connsiteY24" fmla="*/ 779354 h 975028"/>
              <a:gd name="connsiteX25" fmla="*/ 735155 w 1043387"/>
              <a:gd name="connsiteY25" fmla="*/ 858376 h 975028"/>
              <a:gd name="connsiteX26" fmla="*/ 697525 w 1043387"/>
              <a:gd name="connsiteY26" fmla="*/ 888480 h 975028"/>
              <a:gd name="connsiteX27" fmla="*/ 641081 w 1043387"/>
              <a:gd name="connsiteY27" fmla="*/ 941161 h 975028"/>
              <a:gd name="connsiteX28" fmla="*/ 588399 w 1043387"/>
              <a:gd name="connsiteY28" fmla="*/ 967502 h 975028"/>
              <a:gd name="connsiteX29" fmla="*/ 475510 w 1043387"/>
              <a:gd name="connsiteY29" fmla="*/ 975028 h 975028"/>
              <a:gd name="connsiteX30" fmla="*/ 434118 w 1043387"/>
              <a:gd name="connsiteY30" fmla="*/ 967502 h 975028"/>
              <a:gd name="connsiteX31" fmla="*/ 415303 w 1043387"/>
              <a:gd name="connsiteY31" fmla="*/ 937399 h 975028"/>
              <a:gd name="connsiteX32" fmla="*/ 377673 w 1043387"/>
              <a:gd name="connsiteY32" fmla="*/ 937399 h 975028"/>
              <a:gd name="connsiteX33" fmla="*/ 324992 w 1043387"/>
              <a:gd name="connsiteY33" fmla="*/ 914821 h 975028"/>
              <a:gd name="connsiteX34" fmla="*/ 283599 w 1043387"/>
              <a:gd name="connsiteY34" fmla="*/ 877191 h 975028"/>
              <a:gd name="connsiteX35" fmla="*/ 276073 w 1043387"/>
              <a:gd name="connsiteY35" fmla="*/ 835799 h 975028"/>
              <a:gd name="connsiteX36" fmla="*/ 249732 w 1043387"/>
              <a:gd name="connsiteY36" fmla="*/ 798169 h 975028"/>
              <a:gd name="connsiteX37" fmla="*/ 212103 w 1043387"/>
              <a:gd name="connsiteY37" fmla="*/ 771828 h 975028"/>
              <a:gd name="connsiteX38" fmla="*/ 189525 w 1043387"/>
              <a:gd name="connsiteY38" fmla="*/ 722910 h 975028"/>
              <a:gd name="connsiteX39" fmla="*/ 185762 w 1043387"/>
              <a:gd name="connsiteY39" fmla="*/ 677754 h 975028"/>
              <a:gd name="connsiteX40" fmla="*/ 136843 w 1043387"/>
              <a:gd name="connsiteY40" fmla="*/ 715384 h 975028"/>
              <a:gd name="connsiteX41" fmla="*/ 54058 w 1043387"/>
              <a:gd name="connsiteY41" fmla="*/ 715384 h 975028"/>
              <a:gd name="connsiteX42" fmla="*/ 1377 w 1043387"/>
              <a:gd name="connsiteY42" fmla="*/ 628836 h 975028"/>
              <a:gd name="connsiteX43" fmla="*/ 16429 w 1043387"/>
              <a:gd name="connsiteY43" fmla="*/ 497132 h 975028"/>
              <a:gd name="connsiteX44" fmla="*/ 27718 w 1043387"/>
              <a:gd name="connsiteY44" fmla="*/ 459502 h 975028"/>
              <a:gd name="connsiteX45" fmla="*/ 39006 w 1043387"/>
              <a:gd name="connsiteY45" fmla="*/ 380480 h 975028"/>
              <a:gd name="connsiteX46" fmla="*/ 20192 w 1043387"/>
              <a:gd name="connsiteY46" fmla="*/ 327799 h 975028"/>
              <a:gd name="connsiteX47" fmla="*/ 39006 w 1043387"/>
              <a:gd name="connsiteY47" fmla="*/ 267591 h 975028"/>
              <a:gd name="connsiteX48" fmla="*/ 84162 w 1043387"/>
              <a:gd name="connsiteY48" fmla="*/ 229961 h 975028"/>
              <a:gd name="connsiteX49" fmla="*/ 193288 w 1043387"/>
              <a:gd name="connsiteY49" fmla="*/ 203621 h 975028"/>
              <a:gd name="connsiteX0" fmla="*/ 193288 w 1043387"/>
              <a:gd name="connsiteY0" fmla="*/ 203621 h 975028"/>
              <a:gd name="connsiteX1" fmla="*/ 249732 w 1043387"/>
              <a:gd name="connsiteY1" fmla="*/ 158465 h 975028"/>
              <a:gd name="connsiteX2" fmla="*/ 268547 w 1043387"/>
              <a:gd name="connsiteY2" fmla="*/ 90732 h 975028"/>
              <a:gd name="connsiteX3" fmla="*/ 332518 w 1043387"/>
              <a:gd name="connsiteY3" fmla="*/ 45576 h 975028"/>
              <a:gd name="connsiteX4" fmla="*/ 385199 w 1043387"/>
              <a:gd name="connsiteY4" fmla="*/ 56865 h 975028"/>
              <a:gd name="connsiteX5" fmla="*/ 475510 w 1043387"/>
              <a:gd name="connsiteY5" fmla="*/ 64391 h 975028"/>
              <a:gd name="connsiteX6" fmla="*/ 547006 w 1043387"/>
              <a:gd name="connsiteY6" fmla="*/ 22999 h 975028"/>
              <a:gd name="connsiteX7" fmla="*/ 614740 w 1043387"/>
              <a:gd name="connsiteY7" fmla="*/ 421 h 975028"/>
              <a:gd name="connsiteX8" fmla="*/ 682473 w 1043387"/>
              <a:gd name="connsiteY8" fmla="*/ 41813 h 975028"/>
              <a:gd name="connsiteX9" fmla="*/ 735155 w 1043387"/>
              <a:gd name="connsiteY9" fmla="*/ 105784 h 975028"/>
              <a:gd name="connsiteX10" fmla="*/ 750206 w 1043387"/>
              <a:gd name="connsiteY10" fmla="*/ 165991 h 975028"/>
              <a:gd name="connsiteX11" fmla="*/ 802888 w 1043387"/>
              <a:gd name="connsiteY11" fmla="*/ 169754 h 975028"/>
              <a:gd name="connsiteX12" fmla="*/ 881910 w 1043387"/>
              <a:gd name="connsiteY12" fmla="*/ 162228 h 975028"/>
              <a:gd name="connsiteX13" fmla="*/ 942118 w 1043387"/>
              <a:gd name="connsiteY13" fmla="*/ 173517 h 975028"/>
              <a:gd name="connsiteX14" fmla="*/ 1002325 w 1043387"/>
              <a:gd name="connsiteY14" fmla="*/ 226199 h 975028"/>
              <a:gd name="connsiteX15" fmla="*/ 1039955 w 1043387"/>
              <a:gd name="connsiteY15" fmla="*/ 282643 h 975028"/>
              <a:gd name="connsiteX16" fmla="*/ 1039955 w 1043387"/>
              <a:gd name="connsiteY16" fmla="*/ 342850 h 975028"/>
              <a:gd name="connsiteX17" fmla="*/ 1024903 w 1043387"/>
              <a:gd name="connsiteY17" fmla="*/ 421873 h 975028"/>
              <a:gd name="connsiteX18" fmla="*/ 945881 w 1043387"/>
              <a:gd name="connsiteY18" fmla="*/ 500895 h 975028"/>
              <a:gd name="connsiteX19" fmla="*/ 919540 w 1043387"/>
              <a:gd name="connsiteY19" fmla="*/ 527236 h 975028"/>
              <a:gd name="connsiteX20" fmla="*/ 844281 w 1043387"/>
              <a:gd name="connsiteY20" fmla="*/ 572391 h 975028"/>
              <a:gd name="connsiteX21" fmla="*/ 829229 w 1043387"/>
              <a:gd name="connsiteY21" fmla="*/ 632599 h 975028"/>
              <a:gd name="connsiteX22" fmla="*/ 799125 w 1043387"/>
              <a:gd name="connsiteY22" fmla="*/ 651413 h 975028"/>
              <a:gd name="connsiteX23" fmla="*/ 810414 w 1043387"/>
              <a:gd name="connsiteY23" fmla="*/ 745487 h 975028"/>
              <a:gd name="connsiteX24" fmla="*/ 795362 w 1043387"/>
              <a:gd name="connsiteY24" fmla="*/ 779354 h 975028"/>
              <a:gd name="connsiteX25" fmla="*/ 735155 w 1043387"/>
              <a:gd name="connsiteY25" fmla="*/ 858376 h 975028"/>
              <a:gd name="connsiteX26" fmla="*/ 697525 w 1043387"/>
              <a:gd name="connsiteY26" fmla="*/ 888480 h 975028"/>
              <a:gd name="connsiteX27" fmla="*/ 641081 w 1043387"/>
              <a:gd name="connsiteY27" fmla="*/ 941161 h 975028"/>
              <a:gd name="connsiteX28" fmla="*/ 588399 w 1043387"/>
              <a:gd name="connsiteY28" fmla="*/ 967502 h 975028"/>
              <a:gd name="connsiteX29" fmla="*/ 475510 w 1043387"/>
              <a:gd name="connsiteY29" fmla="*/ 975028 h 975028"/>
              <a:gd name="connsiteX30" fmla="*/ 434118 w 1043387"/>
              <a:gd name="connsiteY30" fmla="*/ 967502 h 975028"/>
              <a:gd name="connsiteX31" fmla="*/ 415303 w 1043387"/>
              <a:gd name="connsiteY31" fmla="*/ 937399 h 975028"/>
              <a:gd name="connsiteX32" fmla="*/ 377673 w 1043387"/>
              <a:gd name="connsiteY32" fmla="*/ 937399 h 975028"/>
              <a:gd name="connsiteX33" fmla="*/ 324992 w 1043387"/>
              <a:gd name="connsiteY33" fmla="*/ 914821 h 975028"/>
              <a:gd name="connsiteX34" fmla="*/ 283599 w 1043387"/>
              <a:gd name="connsiteY34" fmla="*/ 877191 h 975028"/>
              <a:gd name="connsiteX35" fmla="*/ 276073 w 1043387"/>
              <a:gd name="connsiteY35" fmla="*/ 835799 h 975028"/>
              <a:gd name="connsiteX36" fmla="*/ 249732 w 1043387"/>
              <a:gd name="connsiteY36" fmla="*/ 798169 h 975028"/>
              <a:gd name="connsiteX37" fmla="*/ 212103 w 1043387"/>
              <a:gd name="connsiteY37" fmla="*/ 771828 h 975028"/>
              <a:gd name="connsiteX38" fmla="*/ 189525 w 1043387"/>
              <a:gd name="connsiteY38" fmla="*/ 722910 h 975028"/>
              <a:gd name="connsiteX39" fmla="*/ 181716 w 1043387"/>
              <a:gd name="connsiteY39" fmla="*/ 697984 h 975028"/>
              <a:gd name="connsiteX40" fmla="*/ 136843 w 1043387"/>
              <a:gd name="connsiteY40" fmla="*/ 715384 h 975028"/>
              <a:gd name="connsiteX41" fmla="*/ 54058 w 1043387"/>
              <a:gd name="connsiteY41" fmla="*/ 715384 h 975028"/>
              <a:gd name="connsiteX42" fmla="*/ 1377 w 1043387"/>
              <a:gd name="connsiteY42" fmla="*/ 628836 h 975028"/>
              <a:gd name="connsiteX43" fmla="*/ 16429 w 1043387"/>
              <a:gd name="connsiteY43" fmla="*/ 497132 h 975028"/>
              <a:gd name="connsiteX44" fmla="*/ 27718 w 1043387"/>
              <a:gd name="connsiteY44" fmla="*/ 459502 h 975028"/>
              <a:gd name="connsiteX45" fmla="*/ 39006 w 1043387"/>
              <a:gd name="connsiteY45" fmla="*/ 380480 h 975028"/>
              <a:gd name="connsiteX46" fmla="*/ 20192 w 1043387"/>
              <a:gd name="connsiteY46" fmla="*/ 327799 h 975028"/>
              <a:gd name="connsiteX47" fmla="*/ 39006 w 1043387"/>
              <a:gd name="connsiteY47" fmla="*/ 267591 h 975028"/>
              <a:gd name="connsiteX48" fmla="*/ 84162 w 1043387"/>
              <a:gd name="connsiteY48" fmla="*/ 229961 h 975028"/>
              <a:gd name="connsiteX49" fmla="*/ 193288 w 1043387"/>
              <a:gd name="connsiteY49" fmla="*/ 203621 h 975028"/>
              <a:gd name="connsiteX0" fmla="*/ 212912 w 1063011"/>
              <a:gd name="connsiteY0" fmla="*/ 203621 h 975028"/>
              <a:gd name="connsiteX1" fmla="*/ 269356 w 1063011"/>
              <a:gd name="connsiteY1" fmla="*/ 158465 h 975028"/>
              <a:gd name="connsiteX2" fmla="*/ 288171 w 1063011"/>
              <a:gd name="connsiteY2" fmla="*/ 90732 h 975028"/>
              <a:gd name="connsiteX3" fmla="*/ 352142 w 1063011"/>
              <a:gd name="connsiteY3" fmla="*/ 45576 h 975028"/>
              <a:gd name="connsiteX4" fmla="*/ 404823 w 1063011"/>
              <a:gd name="connsiteY4" fmla="*/ 56865 h 975028"/>
              <a:gd name="connsiteX5" fmla="*/ 495134 w 1063011"/>
              <a:gd name="connsiteY5" fmla="*/ 64391 h 975028"/>
              <a:gd name="connsiteX6" fmla="*/ 566630 w 1063011"/>
              <a:gd name="connsiteY6" fmla="*/ 22999 h 975028"/>
              <a:gd name="connsiteX7" fmla="*/ 634364 w 1063011"/>
              <a:gd name="connsiteY7" fmla="*/ 421 h 975028"/>
              <a:gd name="connsiteX8" fmla="*/ 702097 w 1063011"/>
              <a:gd name="connsiteY8" fmla="*/ 41813 h 975028"/>
              <a:gd name="connsiteX9" fmla="*/ 754779 w 1063011"/>
              <a:gd name="connsiteY9" fmla="*/ 105784 h 975028"/>
              <a:gd name="connsiteX10" fmla="*/ 769830 w 1063011"/>
              <a:gd name="connsiteY10" fmla="*/ 165991 h 975028"/>
              <a:gd name="connsiteX11" fmla="*/ 822512 w 1063011"/>
              <a:gd name="connsiteY11" fmla="*/ 169754 h 975028"/>
              <a:gd name="connsiteX12" fmla="*/ 901534 w 1063011"/>
              <a:gd name="connsiteY12" fmla="*/ 162228 h 975028"/>
              <a:gd name="connsiteX13" fmla="*/ 961742 w 1063011"/>
              <a:gd name="connsiteY13" fmla="*/ 173517 h 975028"/>
              <a:gd name="connsiteX14" fmla="*/ 1021949 w 1063011"/>
              <a:gd name="connsiteY14" fmla="*/ 226199 h 975028"/>
              <a:gd name="connsiteX15" fmla="*/ 1059579 w 1063011"/>
              <a:gd name="connsiteY15" fmla="*/ 282643 h 975028"/>
              <a:gd name="connsiteX16" fmla="*/ 1059579 w 1063011"/>
              <a:gd name="connsiteY16" fmla="*/ 342850 h 975028"/>
              <a:gd name="connsiteX17" fmla="*/ 1044527 w 1063011"/>
              <a:gd name="connsiteY17" fmla="*/ 421873 h 975028"/>
              <a:gd name="connsiteX18" fmla="*/ 965505 w 1063011"/>
              <a:gd name="connsiteY18" fmla="*/ 500895 h 975028"/>
              <a:gd name="connsiteX19" fmla="*/ 939164 w 1063011"/>
              <a:gd name="connsiteY19" fmla="*/ 527236 h 975028"/>
              <a:gd name="connsiteX20" fmla="*/ 863905 w 1063011"/>
              <a:gd name="connsiteY20" fmla="*/ 572391 h 975028"/>
              <a:gd name="connsiteX21" fmla="*/ 848853 w 1063011"/>
              <a:gd name="connsiteY21" fmla="*/ 632599 h 975028"/>
              <a:gd name="connsiteX22" fmla="*/ 818749 w 1063011"/>
              <a:gd name="connsiteY22" fmla="*/ 651413 h 975028"/>
              <a:gd name="connsiteX23" fmla="*/ 830038 w 1063011"/>
              <a:gd name="connsiteY23" fmla="*/ 745487 h 975028"/>
              <a:gd name="connsiteX24" fmla="*/ 814986 w 1063011"/>
              <a:gd name="connsiteY24" fmla="*/ 779354 h 975028"/>
              <a:gd name="connsiteX25" fmla="*/ 754779 w 1063011"/>
              <a:gd name="connsiteY25" fmla="*/ 858376 h 975028"/>
              <a:gd name="connsiteX26" fmla="*/ 717149 w 1063011"/>
              <a:gd name="connsiteY26" fmla="*/ 888480 h 975028"/>
              <a:gd name="connsiteX27" fmla="*/ 660705 w 1063011"/>
              <a:gd name="connsiteY27" fmla="*/ 941161 h 975028"/>
              <a:gd name="connsiteX28" fmla="*/ 608023 w 1063011"/>
              <a:gd name="connsiteY28" fmla="*/ 967502 h 975028"/>
              <a:gd name="connsiteX29" fmla="*/ 495134 w 1063011"/>
              <a:gd name="connsiteY29" fmla="*/ 975028 h 975028"/>
              <a:gd name="connsiteX30" fmla="*/ 453742 w 1063011"/>
              <a:gd name="connsiteY30" fmla="*/ 967502 h 975028"/>
              <a:gd name="connsiteX31" fmla="*/ 434927 w 1063011"/>
              <a:gd name="connsiteY31" fmla="*/ 937399 h 975028"/>
              <a:gd name="connsiteX32" fmla="*/ 397297 w 1063011"/>
              <a:gd name="connsiteY32" fmla="*/ 937399 h 975028"/>
              <a:gd name="connsiteX33" fmla="*/ 344616 w 1063011"/>
              <a:gd name="connsiteY33" fmla="*/ 914821 h 975028"/>
              <a:gd name="connsiteX34" fmla="*/ 303223 w 1063011"/>
              <a:gd name="connsiteY34" fmla="*/ 877191 h 975028"/>
              <a:gd name="connsiteX35" fmla="*/ 295697 w 1063011"/>
              <a:gd name="connsiteY35" fmla="*/ 835799 h 975028"/>
              <a:gd name="connsiteX36" fmla="*/ 269356 w 1063011"/>
              <a:gd name="connsiteY36" fmla="*/ 798169 h 975028"/>
              <a:gd name="connsiteX37" fmla="*/ 231727 w 1063011"/>
              <a:gd name="connsiteY37" fmla="*/ 771828 h 975028"/>
              <a:gd name="connsiteX38" fmla="*/ 209149 w 1063011"/>
              <a:gd name="connsiteY38" fmla="*/ 722910 h 975028"/>
              <a:gd name="connsiteX39" fmla="*/ 201340 w 1063011"/>
              <a:gd name="connsiteY39" fmla="*/ 697984 h 975028"/>
              <a:gd name="connsiteX40" fmla="*/ 156467 w 1063011"/>
              <a:gd name="connsiteY40" fmla="*/ 715384 h 975028"/>
              <a:gd name="connsiteX41" fmla="*/ 73682 w 1063011"/>
              <a:gd name="connsiteY41" fmla="*/ 715384 h 975028"/>
              <a:gd name="connsiteX42" fmla="*/ 771 w 1063011"/>
              <a:gd name="connsiteY42" fmla="*/ 636928 h 975028"/>
              <a:gd name="connsiteX43" fmla="*/ 36053 w 1063011"/>
              <a:gd name="connsiteY43" fmla="*/ 497132 h 975028"/>
              <a:gd name="connsiteX44" fmla="*/ 47342 w 1063011"/>
              <a:gd name="connsiteY44" fmla="*/ 459502 h 975028"/>
              <a:gd name="connsiteX45" fmla="*/ 58630 w 1063011"/>
              <a:gd name="connsiteY45" fmla="*/ 380480 h 975028"/>
              <a:gd name="connsiteX46" fmla="*/ 39816 w 1063011"/>
              <a:gd name="connsiteY46" fmla="*/ 327799 h 975028"/>
              <a:gd name="connsiteX47" fmla="*/ 58630 w 1063011"/>
              <a:gd name="connsiteY47" fmla="*/ 267591 h 975028"/>
              <a:gd name="connsiteX48" fmla="*/ 103786 w 1063011"/>
              <a:gd name="connsiteY48" fmla="*/ 229961 h 975028"/>
              <a:gd name="connsiteX49" fmla="*/ 212912 w 1063011"/>
              <a:gd name="connsiteY49" fmla="*/ 203621 h 975028"/>
              <a:gd name="connsiteX0" fmla="*/ 215031 w 1065130"/>
              <a:gd name="connsiteY0" fmla="*/ 203621 h 975028"/>
              <a:gd name="connsiteX1" fmla="*/ 271475 w 1065130"/>
              <a:gd name="connsiteY1" fmla="*/ 158465 h 975028"/>
              <a:gd name="connsiteX2" fmla="*/ 290290 w 1065130"/>
              <a:gd name="connsiteY2" fmla="*/ 90732 h 975028"/>
              <a:gd name="connsiteX3" fmla="*/ 354261 w 1065130"/>
              <a:gd name="connsiteY3" fmla="*/ 45576 h 975028"/>
              <a:gd name="connsiteX4" fmla="*/ 406942 w 1065130"/>
              <a:gd name="connsiteY4" fmla="*/ 56865 h 975028"/>
              <a:gd name="connsiteX5" fmla="*/ 497253 w 1065130"/>
              <a:gd name="connsiteY5" fmla="*/ 64391 h 975028"/>
              <a:gd name="connsiteX6" fmla="*/ 568749 w 1065130"/>
              <a:gd name="connsiteY6" fmla="*/ 22999 h 975028"/>
              <a:gd name="connsiteX7" fmla="*/ 636483 w 1065130"/>
              <a:gd name="connsiteY7" fmla="*/ 421 h 975028"/>
              <a:gd name="connsiteX8" fmla="*/ 704216 w 1065130"/>
              <a:gd name="connsiteY8" fmla="*/ 41813 h 975028"/>
              <a:gd name="connsiteX9" fmla="*/ 756898 w 1065130"/>
              <a:gd name="connsiteY9" fmla="*/ 105784 h 975028"/>
              <a:gd name="connsiteX10" fmla="*/ 771949 w 1065130"/>
              <a:gd name="connsiteY10" fmla="*/ 165991 h 975028"/>
              <a:gd name="connsiteX11" fmla="*/ 824631 w 1065130"/>
              <a:gd name="connsiteY11" fmla="*/ 169754 h 975028"/>
              <a:gd name="connsiteX12" fmla="*/ 903653 w 1065130"/>
              <a:gd name="connsiteY12" fmla="*/ 162228 h 975028"/>
              <a:gd name="connsiteX13" fmla="*/ 963861 w 1065130"/>
              <a:gd name="connsiteY13" fmla="*/ 173517 h 975028"/>
              <a:gd name="connsiteX14" fmla="*/ 1024068 w 1065130"/>
              <a:gd name="connsiteY14" fmla="*/ 226199 h 975028"/>
              <a:gd name="connsiteX15" fmla="*/ 1061698 w 1065130"/>
              <a:gd name="connsiteY15" fmla="*/ 282643 h 975028"/>
              <a:gd name="connsiteX16" fmla="*/ 1061698 w 1065130"/>
              <a:gd name="connsiteY16" fmla="*/ 342850 h 975028"/>
              <a:gd name="connsiteX17" fmla="*/ 1046646 w 1065130"/>
              <a:gd name="connsiteY17" fmla="*/ 421873 h 975028"/>
              <a:gd name="connsiteX18" fmla="*/ 967624 w 1065130"/>
              <a:gd name="connsiteY18" fmla="*/ 500895 h 975028"/>
              <a:gd name="connsiteX19" fmla="*/ 941283 w 1065130"/>
              <a:gd name="connsiteY19" fmla="*/ 527236 h 975028"/>
              <a:gd name="connsiteX20" fmla="*/ 866024 w 1065130"/>
              <a:gd name="connsiteY20" fmla="*/ 572391 h 975028"/>
              <a:gd name="connsiteX21" fmla="*/ 850972 w 1065130"/>
              <a:gd name="connsiteY21" fmla="*/ 632599 h 975028"/>
              <a:gd name="connsiteX22" fmla="*/ 820868 w 1065130"/>
              <a:gd name="connsiteY22" fmla="*/ 651413 h 975028"/>
              <a:gd name="connsiteX23" fmla="*/ 832157 w 1065130"/>
              <a:gd name="connsiteY23" fmla="*/ 745487 h 975028"/>
              <a:gd name="connsiteX24" fmla="*/ 817105 w 1065130"/>
              <a:gd name="connsiteY24" fmla="*/ 779354 h 975028"/>
              <a:gd name="connsiteX25" fmla="*/ 756898 w 1065130"/>
              <a:gd name="connsiteY25" fmla="*/ 858376 h 975028"/>
              <a:gd name="connsiteX26" fmla="*/ 719268 w 1065130"/>
              <a:gd name="connsiteY26" fmla="*/ 888480 h 975028"/>
              <a:gd name="connsiteX27" fmla="*/ 662824 w 1065130"/>
              <a:gd name="connsiteY27" fmla="*/ 941161 h 975028"/>
              <a:gd name="connsiteX28" fmla="*/ 610142 w 1065130"/>
              <a:gd name="connsiteY28" fmla="*/ 967502 h 975028"/>
              <a:gd name="connsiteX29" fmla="*/ 497253 w 1065130"/>
              <a:gd name="connsiteY29" fmla="*/ 975028 h 975028"/>
              <a:gd name="connsiteX30" fmla="*/ 455861 w 1065130"/>
              <a:gd name="connsiteY30" fmla="*/ 967502 h 975028"/>
              <a:gd name="connsiteX31" fmla="*/ 437046 w 1065130"/>
              <a:gd name="connsiteY31" fmla="*/ 937399 h 975028"/>
              <a:gd name="connsiteX32" fmla="*/ 399416 w 1065130"/>
              <a:gd name="connsiteY32" fmla="*/ 937399 h 975028"/>
              <a:gd name="connsiteX33" fmla="*/ 346735 w 1065130"/>
              <a:gd name="connsiteY33" fmla="*/ 914821 h 975028"/>
              <a:gd name="connsiteX34" fmla="*/ 305342 w 1065130"/>
              <a:gd name="connsiteY34" fmla="*/ 877191 h 975028"/>
              <a:gd name="connsiteX35" fmla="*/ 297816 w 1065130"/>
              <a:gd name="connsiteY35" fmla="*/ 835799 h 975028"/>
              <a:gd name="connsiteX36" fmla="*/ 271475 w 1065130"/>
              <a:gd name="connsiteY36" fmla="*/ 798169 h 975028"/>
              <a:gd name="connsiteX37" fmla="*/ 233846 w 1065130"/>
              <a:gd name="connsiteY37" fmla="*/ 771828 h 975028"/>
              <a:gd name="connsiteX38" fmla="*/ 211268 w 1065130"/>
              <a:gd name="connsiteY38" fmla="*/ 722910 h 975028"/>
              <a:gd name="connsiteX39" fmla="*/ 203459 w 1065130"/>
              <a:gd name="connsiteY39" fmla="*/ 697984 h 975028"/>
              <a:gd name="connsiteX40" fmla="*/ 158586 w 1065130"/>
              <a:gd name="connsiteY40" fmla="*/ 715384 h 975028"/>
              <a:gd name="connsiteX41" fmla="*/ 75801 w 1065130"/>
              <a:gd name="connsiteY41" fmla="*/ 715384 h 975028"/>
              <a:gd name="connsiteX42" fmla="*/ 2890 w 1065130"/>
              <a:gd name="connsiteY42" fmla="*/ 636928 h 975028"/>
              <a:gd name="connsiteX43" fmla="*/ 17942 w 1065130"/>
              <a:gd name="connsiteY43" fmla="*/ 505224 h 975028"/>
              <a:gd name="connsiteX44" fmla="*/ 49461 w 1065130"/>
              <a:gd name="connsiteY44" fmla="*/ 459502 h 975028"/>
              <a:gd name="connsiteX45" fmla="*/ 60749 w 1065130"/>
              <a:gd name="connsiteY45" fmla="*/ 380480 h 975028"/>
              <a:gd name="connsiteX46" fmla="*/ 41935 w 1065130"/>
              <a:gd name="connsiteY46" fmla="*/ 327799 h 975028"/>
              <a:gd name="connsiteX47" fmla="*/ 60749 w 1065130"/>
              <a:gd name="connsiteY47" fmla="*/ 267591 h 975028"/>
              <a:gd name="connsiteX48" fmla="*/ 105905 w 1065130"/>
              <a:gd name="connsiteY48" fmla="*/ 229961 h 975028"/>
              <a:gd name="connsiteX49" fmla="*/ 215031 w 1065130"/>
              <a:gd name="connsiteY49" fmla="*/ 203621 h 975028"/>
              <a:gd name="connsiteX0" fmla="*/ 215031 w 1065130"/>
              <a:gd name="connsiteY0" fmla="*/ 203621 h 975028"/>
              <a:gd name="connsiteX1" fmla="*/ 271475 w 1065130"/>
              <a:gd name="connsiteY1" fmla="*/ 158465 h 975028"/>
              <a:gd name="connsiteX2" fmla="*/ 290290 w 1065130"/>
              <a:gd name="connsiteY2" fmla="*/ 90732 h 975028"/>
              <a:gd name="connsiteX3" fmla="*/ 354261 w 1065130"/>
              <a:gd name="connsiteY3" fmla="*/ 45576 h 975028"/>
              <a:gd name="connsiteX4" fmla="*/ 406942 w 1065130"/>
              <a:gd name="connsiteY4" fmla="*/ 56865 h 975028"/>
              <a:gd name="connsiteX5" fmla="*/ 497253 w 1065130"/>
              <a:gd name="connsiteY5" fmla="*/ 64391 h 975028"/>
              <a:gd name="connsiteX6" fmla="*/ 568749 w 1065130"/>
              <a:gd name="connsiteY6" fmla="*/ 22999 h 975028"/>
              <a:gd name="connsiteX7" fmla="*/ 636483 w 1065130"/>
              <a:gd name="connsiteY7" fmla="*/ 421 h 975028"/>
              <a:gd name="connsiteX8" fmla="*/ 704216 w 1065130"/>
              <a:gd name="connsiteY8" fmla="*/ 41813 h 975028"/>
              <a:gd name="connsiteX9" fmla="*/ 756898 w 1065130"/>
              <a:gd name="connsiteY9" fmla="*/ 105784 h 975028"/>
              <a:gd name="connsiteX10" fmla="*/ 771949 w 1065130"/>
              <a:gd name="connsiteY10" fmla="*/ 165991 h 975028"/>
              <a:gd name="connsiteX11" fmla="*/ 824631 w 1065130"/>
              <a:gd name="connsiteY11" fmla="*/ 194030 h 975028"/>
              <a:gd name="connsiteX12" fmla="*/ 903653 w 1065130"/>
              <a:gd name="connsiteY12" fmla="*/ 162228 h 975028"/>
              <a:gd name="connsiteX13" fmla="*/ 963861 w 1065130"/>
              <a:gd name="connsiteY13" fmla="*/ 173517 h 975028"/>
              <a:gd name="connsiteX14" fmla="*/ 1024068 w 1065130"/>
              <a:gd name="connsiteY14" fmla="*/ 226199 h 975028"/>
              <a:gd name="connsiteX15" fmla="*/ 1061698 w 1065130"/>
              <a:gd name="connsiteY15" fmla="*/ 282643 h 975028"/>
              <a:gd name="connsiteX16" fmla="*/ 1061698 w 1065130"/>
              <a:gd name="connsiteY16" fmla="*/ 342850 h 975028"/>
              <a:gd name="connsiteX17" fmla="*/ 1046646 w 1065130"/>
              <a:gd name="connsiteY17" fmla="*/ 421873 h 975028"/>
              <a:gd name="connsiteX18" fmla="*/ 967624 w 1065130"/>
              <a:gd name="connsiteY18" fmla="*/ 500895 h 975028"/>
              <a:gd name="connsiteX19" fmla="*/ 941283 w 1065130"/>
              <a:gd name="connsiteY19" fmla="*/ 527236 h 975028"/>
              <a:gd name="connsiteX20" fmla="*/ 866024 w 1065130"/>
              <a:gd name="connsiteY20" fmla="*/ 572391 h 975028"/>
              <a:gd name="connsiteX21" fmla="*/ 850972 w 1065130"/>
              <a:gd name="connsiteY21" fmla="*/ 632599 h 975028"/>
              <a:gd name="connsiteX22" fmla="*/ 820868 w 1065130"/>
              <a:gd name="connsiteY22" fmla="*/ 651413 h 975028"/>
              <a:gd name="connsiteX23" fmla="*/ 832157 w 1065130"/>
              <a:gd name="connsiteY23" fmla="*/ 745487 h 975028"/>
              <a:gd name="connsiteX24" fmla="*/ 817105 w 1065130"/>
              <a:gd name="connsiteY24" fmla="*/ 779354 h 975028"/>
              <a:gd name="connsiteX25" fmla="*/ 756898 w 1065130"/>
              <a:gd name="connsiteY25" fmla="*/ 858376 h 975028"/>
              <a:gd name="connsiteX26" fmla="*/ 719268 w 1065130"/>
              <a:gd name="connsiteY26" fmla="*/ 888480 h 975028"/>
              <a:gd name="connsiteX27" fmla="*/ 662824 w 1065130"/>
              <a:gd name="connsiteY27" fmla="*/ 941161 h 975028"/>
              <a:gd name="connsiteX28" fmla="*/ 610142 w 1065130"/>
              <a:gd name="connsiteY28" fmla="*/ 967502 h 975028"/>
              <a:gd name="connsiteX29" fmla="*/ 497253 w 1065130"/>
              <a:gd name="connsiteY29" fmla="*/ 975028 h 975028"/>
              <a:gd name="connsiteX30" fmla="*/ 455861 w 1065130"/>
              <a:gd name="connsiteY30" fmla="*/ 967502 h 975028"/>
              <a:gd name="connsiteX31" fmla="*/ 437046 w 1065130"/>
              <a:gd name="connsiteY31" fmla="*/ 937399 h 975028"/>
              <a:gd name="connsiteX32" fmla="*/ 399416 w 1065130"/>
              <a:gd name="connsiteY32" fmla="*/ 937399 h 975028"/>
              <a:gd name="connsiteX33" fmla="*/ 346735 w 1065130"/>
              <a:gd name="connsiteY33" fmla="*/ 914821 h 975028"/>
              <a:gd name="connsiteX34" fmla="*/ 305342 w 1065130"/>
              <a:gd name="connsiteY34" fmla="*/ 877191 h 975028"/>
              <a:gd name="connsiteX35" fmla="*/ 297816 w 1065130"/>
              <a:gd name="connsiteY35" fmla="*/ 835799 h 975028"/>
              <a:gd name="connsiteX36" fmla="*/ 271475 w 1065130"/>
              <a:gd name="connsiteY36" fmla="*/ 798169 h 975028"/>
              <a:gd name="connsiteX37" fmla="*/ 233846 w 1065130"/>
              <a:gd name="connsiteY37" fmla="*/ 771828 h 975028"/>
              <a:gd name="connsiteX38" fmla="*/ 211268 w 1065130"/>
              <a:gd name="connsiteY38" fmla="*/ 722910 h 975028"/>
              <a:gd name="connsiteX39" fmla="*/ 203459 w 1065130"/>
              <a:gd name="connsiteY39" fmla="*/ 697984 h 975028"/>
              <a:gd name="connsiteX40" fmla="*/ 158586 w 1065130"/>
              <a:gd name="connsiteY40" fmla="*/ 715384 h 975028"/>
              <a:gd name="connsiteX41" fmla="*/ 75801 w 1065130"/>
              <a:gd name="connsiteY41" fmla="*/ 715384 h 975028"/>
              <a:gd name="connsiteX42" fmla="*/ 2890 w 1065130"/>
              <a:gd name="connsiteY42" fmla="*/ 636928 h 975028"/>
              <a:gd name="connsiteX43" fmla="*/ 17942 w 1065130"/>
              <a:gd name="connsiteY43" fmla="*/ 505224 h 975028"/>
              <a:gd name="connsiteX44" fmla="*/ 49461 w 1065130"/>
              <a:gd name="connsiteY44" fmla="*/ 459502 h 975028"/>
              <a:gd name="connsiteX45" fmla="*/ 60749 w 1065130"/>
              <a:gd name="connsiteY45" fmla="*/ 380480 h 975028"/>
              <a:gd name="connsiteX46" fmla="*/ 41935 w 1065130"/>
              <a:gd name="connsiteY46" fmla="*/ 327799 h 975028"/>
              <a:gd name="connsiteX47" fmla="*/ 60749 w 1065130"/>
              <a:gd name="connsiteY47" fmla="*/ 267591 h 975028"/>
              <a:gd name="connsiteX48" fmla="*/ 105905 w 1065130"/>
              <a:gd name="connsiteY48" fmla="*/ 229961 h 975028"/>
              <a:gd name="connsiteX49" fmla="*/ 215031 w 1065130"/>
              <a:gd name="connsiteY49" fmla="*/ 203621 h 975028"/>
              <a:gd name="connsiteX0" fmla="*/ 215031 w 1065130"/>
              <a:gd name="connsiteY0" fmla="*/ 203621 h 975028"/>
              <a:gd name="connsiteX1" fmla="*/ 271475 w 1065130"/>
              <a:gd name="connsiteY1" fmla="*/ 158465 h 975028"/>
              <a:gd name="connsiteX2" fmla="*/ 290290 w 1065130"/>
              <a:gd name="connsiteY2" fmla="*/ 90732 h 975028"/>
              <a:gd name="connsiteX3" fmla="*/ 354261 w 1065130"/>
              <a:gd name="connsiteY3" fmla="*/ 45576 h 975028"/>
              <a:gd name="connsiteX4" fmla="*/ 406942 w 1065130"/>
              <a:gd name="connsiteY4" fmla="*/ 56865 h 975028"/>
              <a:gd name="connsiteX5" fmla="*/ 497253 w 1065130"/>
              <a:gd name="connsiteY5" fmla="*/ 64391 h 975028"/>
              <a:gd name="connsiteX6" fmla="*/ 568749 w 1065130"/>
              <a:gd name="connsiteY6" fmla="*/ 22999 h 975028"/>
              <a:gd name="connsiteX7" fmla="*/ 636483 w 1065130"/>
              <a:gd name="connsiteY7" fmla="*/ 421 h 975028"/>
              <a:gd name="connsiteX8" fmla="*/ 704216 w 1065130"/>
              <a:gd name="connsiteY8" fmla="*/ 41813 h 975028"/>
              <a:gd name="connsiteX9" fmla="*/ 756898 w 1065130"/>
              <a:gd name="connsiteY9" fmla="*/ 105784 h 975028"/>
              <a:gd name="connsiteX10" fmla="*/ 771949 w 1065130"/>
              <a:gd name="connsiteY10" fmla="*/ 165991 h 975028"/>
              <a:gd name="connsiteX11" fmla="*/ 824631 w 1065130"/>
              <a:gd name="connsiteY11" fmla="*/ 194030 h 975028"/>
              <a:gd name="connsiteX12" fmla="*/ 903653 w 1065130"/>
              <a:gd name="connsiteY12" fmla="*/ 162228 h 975028"/>
              <a:gd name="connsiteX13" fmla="*/ 963861 w 1065130"/>
              <a:gd name="connsiteY13" fmla="*/ 173517 h 975028"/>
              <a:gd name="connsiteX14" fmla="*/ 1024068 w 1065130"/>
              <a:gd name="connsiteY14" fmla="*/ 226199 h 975028"/>
              <a:gd name="connsiteX15" fmla="*/ 1061698 w 1065130"/>
              <a:gd name="connsiteY15" fmla="*/ 282643 h 975028"/>
              <a:gd name="connsiteX16" fmla="*/ 1061698 w 1065130"/>
              <a:gd name="connsiteY16" fmla="*/ 342850 h 975028"/>
              <a:gd name="connsiteX17" fmla="*/ 1046646 w 1065130"/>
              <a:gd name="connsiteY17" fmla="*/ 421873 h 975028"/>
              <a:gd name="connsiteX18" fmla="*/ 967624 w 1065130"/>
              <a:gd name="connsiteY18" fmla="*/ 500895 h 975028"/>
              <a:gd name="connsiteX19" fmla="*/ 941283 w 1065130"/>
              <a:gd name="connsiteY19" fmla="*/ 527236 h 975028"/>
              <a:gd name="connsiteX20" fmla="*/ 866024 w 1065130"/>
              <a:gd name="connsiteY20" fmla="*/ 572391 h 975028"/>
              <a:gd name="connsiteX21" fmla="*/ 850972 w 1065130"/>
              <a:gd name="connsiteY21" fmla="*/ 632599 h 975028"/>
              <a:gd name="connsiteX22" fmla="*/ 820868 w 1065130"/>
              <a:gd name="connsiteY22" fmla="*/ 651413 h 975028"/>
              <a:gd name="connsiteX23" fmla="*/ 832157 w 1065130"/>
              <a:gd name="connsiteY23" fmla="*/ 745487 h 975028"/>
              <a:gd name="connsiteX24" fmla="*/ 817105 w 1065130"/>
              <a:gd name="connsiteY24" fmla="*/ 779354 h 975028"/>
              <a:gd name="connsiteX25" fmla="*/ 756898 w 1065130"/>
              <a:gd name="connsiteY25" fmla="*/ 858376 h 975028"/>
              <a:gd name="connsiteX26" fmla="*/ 719268 w 1065130"/>
              <a:gd name="connsiteY26" fmla="*/ 888480 h 975028"/>
              <a:gd name="connsiteX27" fmla="*/ 662824 w 1065130"/>
              <a:gd name="connsiteY27" fmla="*/ 941161 h 975028"/>
              <a:gd name="connsiteX28" fmla="*/ 610142 w 1065130"/>
              <a:gd name="connsiteY28" fmla="*/ 967502 h 975028"/>
              <a:gd name="connsiteX29" fmla="*/ 497253 w 1065130"/>
              <a:gd name="connsiteY29" fmla="*/ 975028 h 975028"/>
              <a:gd name="connsiteX30" fmla="*/ 455861 w 1065130"/>
              <a:gd name="connsiteY30" fmla="*/ 967502 h 975028"/>
              <a:gd name="connsiteX31" fmla="*/ 437046 w 1065130"/>
              <a:gd name="connsiteY31" fmla="*/ 937399 h 975028"/>
              <a:gd name="connsiteX32" fmla="*/ 399416 w 1065130"/>
              <a:gd name="connsiteY32" fmla="*/ 937399 h 975028"/>
              <a:gd name="connsiteX33" fmla="*/ 346735 w 1065130"/>
              <a:gd name="connsiteY33" fmla="*/ 914821 h 975028"/>
              <a:gd name="connsiteX34" fmla="*/ 305342 w 1065130"/>
              <a:gd name="connsiteY34" fmla="*/ 877191 h 975028"/>
              <a:gd name="connsiteX35" fmla="*/ 297816 w 1065130"/>
              <a:gd name="connsiteY35" fmla="*/ 835799 h 975028"/>
              <a:gd name="connsiteX36" fmla="*/ 271475 w 1065130"/>
              <a:gd name="connsiteY36" fmla="*/ 798169 h 975028"/>
              <a:gd name="connsiteX37" fmla="*/ 233846 w 1065130"/>
              <a:gd name="connsiteY37" fmla="*/ 771828 h 975028"/>
              <a:gd name="connsiteX38" fmla="*/ 211268 w 1065130"/>
              <a:gd name="connsiteY38" fmla="*/ 722910 h 975028"/>
              <a:gd name="connsiteX39" fmla="*/ 203459 w 1065130"/>
              <a:gd name="connsiteY39" fmla="*/ 697984 h 975028"/>
              <a:gd name="connsiteX40" fmla="*/ 158586 w 1065130"/>
              <a:gd name="connsiteY40" fmla="*/ 715384 h 975028"/>
              <a:gd name="connsiteX41" fmla="*/ 75801 w 1065130"/>
              <a:gd name="connsiteY41" fmla="*/ 715384 h 975028"/>
              <a:gd name="connsiteX42" fmla="*/ 2890 w 1065130"/>
              <a:gd name="connsiteY42" fmla="*/ 636928 h 975028"/>
              <a:gd name="connsiteX43" fmla="*/ 17942 w 1065130"/>
              <a:gd name="connsiteY43" fmla="*/ 505224 h 975028"/>
              <a:gd name="connsiteX44" fmla="*/ 49461 w 1065130"/>
              <a:gd name="connsiteY44" fmla="*/ 459502 h 975028"/>
              <a:gd name="connsiteX45" fmla="*/ 93117 w 1065130"/>
              <a:gd name="connsiteY45" fmla="*/ 380480 h 975028"/>
              <a:gd name="connsiteX46" fmla="*/ 41935 w 1065130"/>
              <a:gd name="connsiteY46" fmla="*/ 327799 h 975028"/>
              <a:gd name="connsiteX47" fmla="*/ 60749 w 1065130"/>
              <a:gd name="connsiteY47" fmla="*/ 267591 h 975028"/>
              <a:gd name="connsiteX48" fmla="*/ 105905 w 1065130"/>
              <a:gd name="connsiteY48" fmla="*/ 229961 h 975028"/>
              <a:gd name="connsiteX49" fmla="*/ 215031 w 1065130"/>
              <a:gd name="connsiteY49" fmla="*/ 203621 h 975028"/>
              <a:gd name="connsiteX0" fmla="*/ 215031 w 1065130"/>
              <a:gd name="connsiteY0" fmla="*/ 203621 h 975028"/>
              <a:gd name="connsiteX1" fmla="*/ 271475 w 1065130"/>
              <a:gd name="connsiteY1" fmla="*/ 158465 h 975028"/>
              <a:gd name="connsiteX2" fmla="*/ 290290 w 1065130"/>
              <a:gd name="connsiteY2" fmla="*/ 90732 h 975028"/>
              <a:gd name="connsiteX3" fmla="*/ 354261 w 1065130"/>
              <a:gd name="connsiteY3" fmla="*/ 45576 h 975028"/>
              <a:gd name="connsiteX4" fmla="*/ 406942 w 1065130"/>
              <a:gd name="connsiteY4" fmla="*/ 56865 h 975028"/>
              <a:gd name="connsiteX5" fmla="*/ 497253 w 1065130"/>
              <a:gd name="connsiteY5" fmla="*/ 64391 h 975028"/>
              <a:gd name="connsiteX6" fmla="*/ 568749 w 1065130"/>
              <a:gd name="connsiteY6" fmla="*/ 22999 h 975028"/>
              <a:gd name="connsiteX7" fmla="*/ 636483 w 1065130"/>
              <a:gd name="connsiteY7" fmla="*/ 421 h 975028"/>
              <a:gd name="connsiteX8" fmla="*/ 704216 w 1065130"/>
              <a:gd name="connsiteY8" fmla="*/ 41813 h 975028"/>
              <a:gd name="connsiteX9" fmla="*/ 756898 w 1065130"/>
              <a:gd name="connsiteY9" fmla="*/ 105784 h 975028"/>
              <a:gd name="connsiteX10" fmla="*/ 771949 w 1065130"/>
              <a:gd name="connsiteY10" fmla="*/ 165991 h 975028"/>
              <a:gd name="connsiteX11" fmla="*/ 824631 w 1065130"/>
              <a:gd name="connsiteY11" fmla="*/ 194030 h 975028"/>
              <a:gd name="connsiteX12" fmla="*/ 903653 w 1065130"/>
              <a:gd name="connsiteY12" fmla="*/ 162228 h 975028"/>
              <a:gd name="connsiteX13" fmla="*/ 963861 w 1065130"/>
              <a:gd name="connsiteY13" fmla="*/ 173517 h 975028"/>
              <a:gd name="connsiteX14" fmla="*/ 1024068 w 1065130"/>
              <a:gd name="connsiteY14" fmla="*/ 226199 h 975028"/>
              <a:gd name="connsiteX15" fmla="*/ 1061698 w 1065130"/>
              <a:gd name="connsiteY15" fmla="*/ 282643 h 975028"/>
              <a:gd name="connsiteX16" fmla="*/ 1061698 w 1065130"/>
              <a:gd name="connsiteY16" fmla="*/ 342850 h 975028"/>
              <a:gd name="connsiteX17" fmla="*/ 1046646 w 1065130"/>
              <a:gd name="connsiteY17" fmla="*/ 421873 h 975028"/>
              <a:gd name="connsiteX18" fmla="*/ 967624 w 1065130"/>
              <a:gd name="connsiteY18" fmla="*/ 500895 h 975028"/>
              <a:gd name="connsiteX19" fmla="*/ 941283 w 1065130"/>
              <a:gd name="connsiteY19" fmla="*/ 527236 h 975028"/>
              <a:gd name="connsiteX20" fmla="*/ 866024 w 1065130"/>
              <a:gd name="connsiteY20" fmla="*/ 572391 h 975028"/>
              <a:gd name="connsiteX21" fmla="*/ 850972 w 1065130"/>
              <a:gd name="connsiteY21" fmla="*/ 632599 h 975028"/>
              <a:gd name="connsiteX22" fmla="*/ 820868 w 1065130"/>
              <a:gd name="connsiteY22" fmla="*/ 651413 h 975028"/>
              <a:gd name="connsiteX23" fmla="*/ 832157 w 1065130"/>
              <a:gd name="connsiteY23" fmla="*/ 745487 h 975028"/>
              <a:gd name="connsiteX24" fmla="*/ 817105 w 1065130"/>
              <a:gd name="connsiteY24" fmla="*/ 779354 h 975028"/>
              <a:gd name="connsiteX25" fmla="*/ 756898 w 1065130"/>
              <a:gd name="connsiteY25" fmla="*/ 858376 h 975028"/>
              <a:gd name="connsiteX26" fmla="*/ 719268 w 1065130"/>
              <a:gd name="connsiteY26" fmla="*/ 888480 h 975028"/>
              <a:gd name="connsiteX27" fmla="*/ 662824 w 1065130"/>
              <a:gd name="connsiteY27" fmla="*/ 941161 h 975028"/>
              <a:gd name="connsiteX28" fmla="*/ 610142 w 1065130"/>
              <a:gd name="connsiteY28" fmla="*/ 967502 h 975028"/>
              <a:gd name="connsiteX29" fmla="*/ 497253 w 1065130"/>
              <a:gd name="connsiteY29" fmla="*/ 975028 h 975028"/>
              <a:gd name="connsiteX30" fmla="*/ 455861 w 1065130"/>
              <a:gd name="connsiteY30" fmla="*/ 967502 h 975028"/>
              <a:gd name="connsiteX31" fmla="*/ 437046 w 1065130"/>
              <a:gd name="connsiteY31" fmla="*/ 937399 h 975028"/>
              <a:gd name="connsiteX32" fmla="*/ 399416 w 1065130"/>
              <a:gd name="connsiteY32" fmla="*/ 937399 h 975028"/>
              <a:gd name="connsiteX33" fmla="*/ 346735 w 1065130"/>
              <a:gd name="connsiteY33" fmla="*/ 914821 h 975028"/>
              <a:gd name="connsiteX34" fmla="*/ 305342 w 1065130"/>
              <a:gd name="connsiteY34" fmla="*/ 877191 h 975028"/>
              <a:gd name="connsiteX35" fmla="*/ 297816 w 1065130"/>
              <a:gd name="connsiteY35" fmla="*/ 835799 h 975028"/>
              <a:gd name="connsiteX36" fmla="*/ 271475 w 1065130"/>
              <a:gd name="connsiteY36" fmla="*/ 798169 h 975028"/>
              <a:gd name="connsiteX37" fmla="*/ 233846 w 1065130"/>
              <a:gd name="connsiteY37" fmla="*/ 771828 h 975028"/>
              <a:gd name="connsiteX38" fmla="*/ 211268 w 1065130"/>
              <a:gd name="connsiteY38" fmla="*/ 722910 h 975028"/>
              <a:gd name="connsiteX39" fmla="*/ 203459 w 1065130"/>
              <a:gd name="connsiteY39" fmla="*/ 697984 h 975028"/>
              <a:gd name="connsiteX40" fmla="*/ 158586 w 1065130"/>
              <a:gd name="connsiteY40" fmla="*/ 715384 h 975028"/>
              <a:gd name="connsiteX41" fmla="*/ 75801 w 1065130"/>
              <a:gd name="connsiteY41" fmla="*/ 715384 h 975028"/>
              <a:gd name="connsiteX42" fmla="*/ 2890 w 1065130"/>
              <a:gd name="connsiteY42" fmla="*/ 636928 h 975028"/>
              <a:gd name="connsiteX43" fmla="*/ 17942 w 1065130"/>
              <a:gd name="connsiteY43" fmla="*/ 505224 h 975028"/>
              <a:gd name="connsiteX44" fmla="*/ 49461 w 1065130"/>
              <a:gd name="connsiteY44" fmla="*/ 459502 h 975028"/>
              <a:gd name="connsiteX45" fmla="*/ 93117 w 1065130"/>
              <a:gd name="connsiteY45" fmla="*/ 380480 h 975028"/>
              <a:gd name="connsiteX46" fmla="*/ 70257 w 1065130"/>
              <a:gd name="connsiteY46" fmla="*/ 327799 h 975028"/>
              <a:gd name="connsiteX47" fmla="*/ 60749 w 1065130"/>
              <a:gd name="connsiteY47" fmla="*/ 267591 h 975028"/>
              <a:gd name="connsiteX48" fmla="*/ 105905 w 1065130"/>
              <a:gd name="connsiteY48" fmla="*/ 229961 h 975028"/>
              <a:gd name="connsiteX49" fmla="*/ 215031 w 1065130"/>
              <a:gd name="connsiteY49" fmla="*/ 203621 h 975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</a:cxnLst>
            <a:rect l="l" t="t" r="r" b="b"/>
            <a:pathLst>
              <a:path w="1065130" h="975028">
                <a:moveTo>
                  <a:pt x="215031" y="203621"/>
                </a:moveTo>
                <a:cubicBezTo>
                  <a:pt x="242626" y="191705"/>
                  <a:pt x="258932" y="177280"/>
                  <a:pt x="271475" y="158465"/>
                </a:cubicBezTo>
                <a:cubicBezTo>
                  <a:pt x="284018" y="139650"/>
                  <a:pt x="276492" y="109547"/>
                  <a:pt x="290290" y="90732"/>
                </a:cubicBezTo>
                <a:cubicBezTo>
                  <a:pt x="304088" y="71917"/>
                  <a:pt x="334819" y="51220"/>
                  <a:pt x="354261" y="45576"/>
                </a:cubicBezTo>
                <a:cubicBezTo>
                  <a:pt x="373703" y="39932"/>
                  <a:pt x="383110" y="53729"/>
                  <a:pt x="406942" y="56865"/>
                </a:cubicBezTo>
                <a:cubicBezTo>
                  <a:pt x="430774" y="60001"/>
                  <a:pt x="470285" y="70035"/>
                  <a:pt x="497253" y="64391"/>
                </a:cubicBezTo>
                <a:cubicBezTo>
                  <a:pt x="524221" y="58747"/>
                  <a:pt x="545544" y="33661"/>
                  <a:pt x="568749" y="22999"/>
                </a:cubicBezTo>
                <a:cubicBezTo>
                  <a:pt x="591954" y="12337"/>
                  <a:pt x="613905" y="-2715"/>
                  <a:pt x="636483" y="421"/>
                </a:cubicBezTo>
                <a:cubicBezTo>
                  <a:pt x="659061" y="3557"/>
                  <a:pt x="684147" y="24253"/>
                  <a:pt x="704216" y="41813"/>
                </a:cubicBezTo>
                <a:cubicBezTo>
                  <a:pt x="724285" y="59373"/>
                  <a:pt x="745609" y="85088"/>
                  <a:pt x="756898" y="105784"/>
                </a:cubicBezTo>
                <a:cubicBezTo>
                  <a:pt x="768187" y="126480"/>
                  <a:pt x="760660" y="151283"/>
                  <a:pt x="771949" y="165991"/>
                </a:cubicBezTo>
                <a:cubicBezTo>
                  <a:pt x="783238" y="180699"/>
                  <a:pt x="802680" y="194657"/>
                  <a:pt x="824631" y="194030"/>
                </a:cubicBezTo>
                <a:cubicBezTo>
                  <a:pt x="846582" y="193403"/>
                  <a:pt x="880448" y="165647"/>
                  <a:pt x="903653" y="162228"/>
                </a:cubicBezTo>
                <a:cubicBezTo>
                  <a:pt x="926858" y="158809"/>
                  <a:pt x="943792" y="162855"/>
                  <a:pt x="963861" y="173517"/>
                </a:cubicBezTo>
                <a:cubicBezTo>
                  <a:pt x="983930" y="184179"/>
                  <a:pt x="1007762" y="208011"/>
                  <a:pt x="1024068" y="226199"/>
                </a:cubicBezTo>
                <a:cubicBezTo>
                  <a:pt x="1040374" y="244387"/>
                  <a:pt x="1055426" y="263201"/>
                  <a:pt x="1061698" y="282643"/>
                </a:cubicBezTo>
                <a:cubicBezTo>
                  <a:pt x="1067970" y="302085"/>
                  <a:pt x="1064207" y="319645"/>
                  <a:pt x="1061698" y="342850"/>
                </a:cubicBezTo>
                <a:cubicBezTo>
                  <a:pt x="1059189" y="366055"/>
                  <a:pt x="1062325" y="395532"/>
                  <a:pt x="1046646" y="421873"/>
                </a:cubicBezTo>
                <a:cubicBezTo>
                  <a:pt x="1030967" y="448214"/>
                  <a:pt x="967624" y="500895"/>
                  <a:pt x="967624" y="500895"/>
                </a:cubicBezTo>
                <a:cubicBezTo>
                  <a:pt x="950064" y="518455"/>
                  <a:pt x="958216" y="515320"/>
                  <a:pt x="941283" y="527236"/>
                </a:cubicBezTo>
                <a:cubicBezTo>
                  <a:pt x="924350" y="539152"/>
                  <a:pt x="881076" y="554831"/>
                  <a:pt x="866024" y="572391"/>
                </a:cubicBezTo>
                <a:cubicBezTo>
                  <a:pt x="850972" y="589951"/>
                  <a:pt x="858498" y="619429"/>
                  <a:pt x="850972" y="632599"/>
                </a:cubicBezTo>
                <a:cubicBezTo>
                  <a:pt x="843446" y="645769"/>
                  <a:pt x="824004" y="632598"/>
                  <a:pt x="820868" y="651413"/>
                </a:cubicBezTo>
                <a:cubicBezTo>
                  <a:pt x="817732" y="670228"/>
                  <a:pt x="832784" y="724164"/>
                  <a:pt x="832157" y="745487"/>
                </a:cubicBezTo>
                <a:cubicBezTo>
                  <a:pt x="831530" y="766810"/>
                  <a:pt x="829648" y="760539"/>
                  <a:pt x="817105" y="779354"/>
                </a:cubicBezTo>
                <a:cubicBezTo>
                  <a:pt x="804562" y="798169"/>
                  <a:pt x="773204" y="840188"/>
                  <a:pt x="756898" y="858376"/>
                </a:cubicBezTo>
                <a:cubicBezTo>
                  <a:pt x="740592" y="876564"/>
                  <a:pt x="734947" y="874683"/>
                  <a:pt x="719268" y="888480"/>
                </a:cubicBezTo>
                <a:cubicBezTo>
                  <a:pt x="703589" y="902277"/>
                  <a:pt x="681012" y="927991"/>
                  <a:pt x="662824" y="941161"/>
                </a:cubicBezTo>
                <a:cubicBezTo>
                  <a:pt x="644636" y="954331"/>
                  <a:pt x="637737" y="961857"/>
                  <a:pt x="610142" y="967502"/>
                </a:cubicBezTo>
                <a:cubicBezTo>
                  <a:pt x="582547" y="973147"/>
                  <a:pt x="522966" y="975028"/>
                  <a:pt x="497253" y="975028"/>
                </a:cubicBezTo>
                <a:cubicBezTo>
                  <a:pt x="471540" y="975028"/>
                  <a:pt x="465895" y="973773"/>
                  <a:pt x="455861" y="967502"/>
                </a:cubicBezTo>
                <a:cubicBezTo>
                  <a:pt x="445827" y="961231"/>
                  <a:pt x="446454" y="942416"/>
                  <a:pt x="437046" y="937399"/>
                </a:cubicBezTo>
                <a:cubicBezTo>
                  <a:pt x="427639" y="932382"/>
                  <a:pt x="414468" y="941162"/>
                  <a:pt x="399416" y="937399"/>
                </a:cubicBezTo>
                <a:cubicBezTo>
                  <a:pt x="384364" y="933636"/>
                  <a:pt x="362414" y="924856"/>
                  <a:pt x="346735" y="914821"/>
                </a:cubicBezTo>
                <a:cubicBezTo>
                  <a:pt x="331056" y="904786"/>
                  <a:pt x="313495" y="890361"/>
                  <a:pt x="305342" y="877191"/>
                </a:cubicBezTo>
                <a:cubicBezTo>
                  <a:pt x="297189" y="864021"/>
                  <a:pt x="303460" y="848969"/>
                  <a:pt x="297816" y="835799"/>
                </a:cubicBezTo>
                <a:cubicBezTo>
                  <a:pt x="292172" y="822629"/>
                  <a:pt x="282137" y="808831"/>
                  <a:pt x="271475" y="798169"/>
                </a:cubicBezTo>
                <a:cubicBezTo>
                  <a:pt x="260813" y="787507"/>
                  <a:pt x="243881" y="784371"/>
                  <a:pt x="233846" y="771828"/>
                </a:cubicBezTo>
                <a:cubicBezTo>
                  <a:pt x="223812" y="759285"/>
                  <a:pt x="216333" y="735217"/>
                  <a:pt x="211268" y="722910"/>
                </a:cubicBezTo>
                <a:cubicBezTo>
                  <a:pt x="206204" y="710603"/>
                  <a:pt x="212239" y="699238"/>
                  <a:pt x="203459" y="697984"/>
                </a:cubicBezTo>
                <a:cubicBezTo>
                  <a:pt x="194679" y="696730"/>
                  <a:pt x="179862" y="712484"/>
                  <a:pt x="158586" y="715384"/>
                </a:cubicBezTo>
                <a:cubicBezTo>
                  <a:pt x="137310" y="718284"/>
                  <a:pt x="101750" y="728460"/>
                  <a:pt x="75801" y="715384"/>
                </a:cubicBezTo>
                <a:cubicBezTo>
                  <a:pt x="49852" y="702308"/>
                  <a:pt x="12533" y="671955"/>
                  <a:pt x="2890" y="636928"/>
                </a:cubicBezTo>
                <a:cubicBezTo>
                  <a:pt x="-6753" y="601901"/>
                  <a:pt x="10180" y="534795"/>
                  <a:pt x="17942" y="505224"/>
                </a:cubicBezTo>
                <a:cubicBezTo>
                  <a:pt x="25704" y="475653"/>
                  <a:pt x="36932" y="480293"/>
                  <a:pt x="49461" y="459502"/>
                </a:cubicBezTo>
                <a:cubicBezTo>
                  <a:pt x="61990" y="438711"/>
                  <a:pt x="89651" y="402431"/>
                  <a:pt x="93117" y="380480"/>
                </a:cubicBezTo>
                <a:cubicBezTo>
                  <a:pt x="96583" y="358530"/>
                  <a:pt x="75652" y="346614"/>
                  <a:pt x="70257" y="327799"/>
                </a:cubicBezTo>
                <a:cubicBezTo>
                  <a:pt x="64862" y="308984"/>
                  <a:pt x="50087" y="283897"/>
                  <a:pt x="60749" y="267591"/>
                </a:cubicBezTo>
                <a:cubicBezTo>
                  <a:pt x="71411" y="251285"/>
                  <a:pt x="87090" y="243131"/>
                  <a:pt x="105905" y="229961"/>
                </a:cubicBezTo>
                <a:cubicBezTo>
                  <a:pt x="124720" y="216791"/>
                  <a:pt x="187436" y="215537"/>
                  <a:pt x="215031" y="203621"/>
                </a:cubicBezTo>
                <a:close/>
              </a:path>
            </a:pathLst>
          </a:cu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749394" y="4393604"/>
            <a:ext cx="4763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S</a:t>
            </a:r>
            <a:endParaRPr lang="en-US" sz="16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Freeform 19"/>
          <p:cNvSpPr/>
          <p:nvPr/>
        </p:nvSpPr>
        <p:spPr>
          <a:xfrm>
            <a:off x="1612639" y="4805178"/>
            <a:ext cx="797867" cy="540014"/>
          </a:xfrm>
          <a:custGeom>
            <a:avLst/>
            <a:gdLst>
              <a:gd name="connsiteX0" fmla="*/ 982 w 725380"/>
              <a:gd name="connsiteY0" fmla="*/ 419640 h 540014"/>
              <a:gd name="connsiteX1" fmla="*/ 78100 w 725380"/>
              <a:gd name="connsiteY1" fmla="*/ 397607 h 540014"/>
              <a:gd name="connsiteX2" fmla="*/ 114823 w 725380"/>
              <a:gd name="connsiteY2" fmla="*/ 335178 h 540014"/>
              <a:gd name="connsiteX3" fmla="*/ 122167 w 725380"/>
              <a:gd name="connsiteY3" fmla="*/ 254387 h 540014"/>
              <a:gd name="connsiteX4" fmla="*/ 74427 w 725380"/>
              <a:gd name="connsiteY4" fmla="*/ 210320 h 540014"/>
              <a:gd name="connsiteX5" fmla="*/ 982 w 725380"/>
              <a:gd name="connsiteY5" fmla="*/ 191958 h 540014"/>
              <a:gd name="connsiteX6" fmla="*/ 63411 w 725380"/>
              <a:gd name="connsiteY6" fmla="*/ 188286 h 540014"/>
              <a:gd name="connsiteX7" fmla="*/ 122167 w 725380"/>
              <a:gd name="connsiteY7" fmla="*/ 155235 h 540014"/>
              <a:gd name="connsiteX8" fmla="*/ 122167 w 725380"/>
              <a:gd name="connsiteY8" fmla="*/ 89134 h 540014"/>
              <a:gd name="connsiteX9" fmla="*/ 74427 w 725380"/>
              <a:gd name="connsiteY9" fmla="*/ 26705 h 540014"/>
              <a:gd name="connsiteX10" fmla="*/ 70755 w 725380"/>
              <a:gd name="connsiteY10" fmla="*/ 19361 h 540014"/>
              <a:gd name="connsiteX11" fmla="*/ 100133 w 725380"/>
              <a:gd name="connsiteY11" fmla="*/ 52411 h 540014"/>
              <a:gd name="connsiteX12" fmla="*/ 166235 w 725380"/>
              <a:gd name="connsiteY12" fmla="*/ 85462 h 540014"/>
              <a:gd name="connsiteX13" fmla="*/ 232336 w 725380"/>
              <a:gd name="connsiteY13" fmla="*/ 96479 h 540014"/>
              <a:gd name="connsiteX14" fmla="*/ 313126 w 725380"/>
              <a:gd name="connsiteY14" fmla="*/ 92807 h 540014"/>
              <a:gd name="connsiteX15" fmla="*/ 419623 w 725380"/>
              <a:gd name="connsiteY15" fmla="*/ 81790 h 540014"/>
              <a:gd name="connsiteX16" fmla="*/ 493068 w 725380"/>
              <a:gd name="connsiteY16" fmla="*/ 37722 h 540014"/>
              <a:gd name="connsiteX17" fmla="*/ 537136 w 725380"/>
              <a:gd name="connsiteY17" fmla="*/ 4672 h 540014"/>
              <a:gd name="connsiteX18" fmla="*/ 551825 w 725380"/>
              <a:gd name="connsiteY18" fmla="*/ 999 h 540014"/>
              <a:gd name="connsiteX19" fmla="*/ 588548 w 725380"/>
              <a:gd name="connsiteY19" fmla="*/ 12016 h 540014"/>
              <a:gd name="connsiteX20" fmla="*/ 566514 w 725380"/>
              <a:gd name="connsiteY20" fmla="*/ 78117 h 540014"/>
              <a:gd name="connsiteX21" fmla="*/ 562842 w 725380"/>
              <a:gd name="connsiteY21" fmla="*/ 162580 h 540014"/>
              <a:gd name="connsiteX22" fmla="*/ 562842 w 725380"/>
              <a:gd name="connsiteY22" fmla="*/ 228681 h 540014"/>
              <a:gd name="connsiteX23" fmla="*/ 588548 w 725380"/>
              <a:gd name="connsiteY23" fmla="*/ 280093 h 540014"/>
              <a:gd name="connsiteX24" fmla="*/ 628943 w 725380"/>
              <a:gd name="connsiteY24" fmla="*/ 305799 h 540014"/>
              <a:gd name="connsiteX25" fmla="*/ 698717 w 725380"/>
              <a:gd name="connsiteY25" fmla="*/ 335178 h 540014"/>
              <a:gd name="connsiteX26" fmla="*/ 724423 w 725380"/>
              <a:gd name="connsiteY26" fmla="*/ 342522 h 540014"/>
              <a:gd name="connsiteX27" fmla="*/ 669338 w 725380"/>
              <a:gd name="connsiteY27" fmla="*/ 371900 h 540014"/>
              <a:gd name="connsiteX28" fmla="*/ 650977 w 725380"/>
              <a:gd name="connsiteY28" fmla="*/ 375573 h 540014"/>
              <a:gd name="connsiteX29" fmla="*/ 625271 w 725380"/>
              <a:gd name="connsiteY29" fmla="*/ 397607 h 540014"/>
              <a:gd name="connsiteX30" fmla="*/ 610582 w 725380"/>
              <a:gd name="connsiteY30" fmla="*/ 408623 h 540014"/>
              <a:gd name="connsiteX31" fmla="*/ 581203 w 725380"/>
              <a:gd name="connsiteY31" fmla="*/ 386590 h 540014"/>
              <a:gd name="connsiteX32" fmla="*/ 544480 w 725380"/>
              <a:gd name="connsiteY32" fmla="*/ 346194 h 540014"/>
              <a:gd name="connsiteX33" fmla="*/ 489396 w 725380"/>
              <a:gd name="connsiteY33" fmla="*/ 331505 h 540014"/>
              <a:gd name="connsiteX34" fmla="*/ 423295 w 725380"/>
              <a:gd name="connsiteY34" fmla="*/ 313144 h 540014"/>
              <a:gd name="connsiteX35" fmla="*/ 316798 w 725380"/>
              <a:gd name="connsiteY35" fmla="*/ 335178 h 540014"/>
              <a:gd name="connsiteX36" fmla="*/ 280076 w 725380"/>
              <a:gd name="connsiteY36" fmla="*/ 364556 h 540014"/>
              <a:gd name="connsiteX37" fmla="*/ 206630 w 725380"/>
              <a:gd name="connsiteY37" fmla="*/ 386590 h 540014"/>
              <a:gd name="connsiteX38" fmla="*/ 184596 w 725380"/>
              <a:gd name="connsiteY38" fmla="*/ 393934 h 540014"/>
              <a:gd name="connsiteX39" fmla="*/ 114823 w 725380"/>
              <a:gd name="connsiteY39" fmla="*/ 463708 h 540014"/>
              <a:gd name="connsiteX40" fmla="*/ 103806 w 725380"/>
              <a:gd name="connsiteY40" fmla="*/ 482069 h 540014"/>
              <a:gd name="connsiteX41" fmla="*/ 52394 w 725380"/>
              <a:gd name="connsiteY41" fmla="*/ 529809 h 540014"/>
              <a:gd name="connsiteX42" fmla="*/ 34032 w 725380"/>
              <a:gd name="connsiteY42" fmla="*/ 537154 h 540014"/>
              <a:gd name="connsiteX43" fmla="*/ 34032 w 725380"/>
              <a:gd name="connsiteY43" fmla="*/ 493086 h 540014"/>
              <a:gd name="connsiteX44" fmla="*/ 982 w 725380"/>
              <a:gd name="connsiteY44" fmla="*/ 419640 h 540014"/>
              <a:gd name="connsiteX0" fmla="*/ 73469 w 797867"/>
              <a:gd name="connsiteY0" fmla="*/ 419640 h 540014"/>
              <a:gd name="connsiteX1" fmla="*/ 150587 w 797867"/>
              <a:gd name="connsiteY1" fmla="*/ 397607 h 540014"/>
              <a:gd name="connsiteX2" fmla="*/ 187310 w 797867"/>
              <a:gd name="connsiteY2" fmla="*/ 335178 h 540014"/>
              <a:gd name="connsiteX3" fmla="*/ 194654 w 797867"/>
              <a:gd name="connsiteY3" fmla="*/ 254387 h 540014"/>
              <a:gd name="connsiteX4" fmla="*/ 146914 w 797867"/>
              <a:gd name="connsiteY4" fmla="*/ 210320 h 540014"/>
              <a:gd name="connsiteX5" fmla="*/ 23 w 797867"/>
              <a:gd name="connsiteY5" fmla="*/ 191958 h 540014"/>
              <a:gd name="connsiteX6" fmla="*/ 135898 w 797867"/>
              <a:gd name="connsiteY6" fmla="*/ 188286 h 540014"/>
              <a:gd name="connsiteX7" fmla="*/ 194654 w 797867"/>
              <a:gd name="connsiteY7" fmla="*/ 155235 h 540014"/>
              <a:gd name="connsiteX8" fmla="*/ 194654 w 797867"/>
              <a:gd name="connsiteY8" fmla="*/ 89134 h 540014"/>
              <a:gd name="connsiteX9" fmla="*/ 146914 w 797867"/>
              <a:gd name="connsiteY9" fmla="*/ 26705 h 540014"/>
              <a:gd name="connsiteX10" fmla="*/ 143242 w 797867"/>
              <a:gd name="connsiteY10" fmla="*/ 19361 h 540014"/>
              <a:gd name="connsiteX11" fmla="*/ 172620 w 797867"/>
              <a:gd name="connsiteY11" fmla="*/ 52411 h 540014"/>
              <a:gd name="connsiteX12" fmla="*/ 238722 w 797867"/>
              <a:gd name="connsiteY12" fmla="*/ 85462 h 540014"/>
              <a:gd name="connsiteX13" fmla="*/ 304823 w 797867"/>
              <a:gd name="connsiteY13" fmla="*/ 96479 h 540014"/>
              <a:gd name="connsiteX14" fmla="*/ 385613 w 797867"/>
              <a:gd name="connsiteY14" fmla="*/ 92807 h 540014"/>
              <a:gd name="connsiteX15" fmla="*/ 492110 w 797867"/>
              <a:gd name="connsiteY15" fmla="*/ 81790 h 540014"/>
              <a:gd name="connsiteX16" fmla="*/ 565555 w 797867"/>
              <a:gd name="connsiteY16" fmla="*/ 37722 h 540014"/>
              <a:gd name="connsiteX17" fmla="*/ 609623 w 797867"/>
              <a:gd name="connsiteY17" fmla="*/ 4672 h 540014"/>
              <a:gd name="connsiteX18" fmla="*/ 624312 w 797867"/>
              <a:gd name="connsiteY18" fmla="*/ 999 h 540014"/>
              <a:gd name="connsiteX19" fmla="*/ 661035 w 797867"/>
              <a:gd name="connsiteY19" fmla="*/ 12016 h 540014"/>
              <a:gd name="connsiteX20" fmla="*/ 639001 w 797867"/>
              <a:gd name="connsiteY20" fmla="*/ 78117 h 540014"/>
              <a:gd name="connsiteX21" fmla="*/ 635329 w 797867"/>
              <a:gd name="connsiteY21" fmla="*/ 162580 h 540014"/>
              <a:gd name="connsiteX22" fmla="*/ 635329 w 797867"/>
              <a:gd name="connsiteY22" fmla="*/ 228681 h 540014"/>
              <a:gd name="connsiteX23" fmla="*/ 661035 w 797867"/>
              <a:gd name="connsiteY23" fmla="*/ 280093 h 540014"/>
              <a:gd name="connsiteX24" fmla="*/ 701430 w 797867"/>
              <a:gd name="connsiteY24" fmla="*/ 305799 h 540014"/>
              <a:gd name="connsiteX25" fmla="*/ 771204 w 797867"/>
              <a:gd name="connsiteY25" fmla="*/ 335178 h 540014"/>
              <a:gd name="connsiteX26" fmla="*/ 796910 w 797867"/>
              <a:gd name="connsiteY26" fmla="*/ 342522 h 540014"/>
              <a:gd name="connsiteX27" fmla="*/ 741825 w 797867"/>
              <a:gd name="connsiteY27" fmla="*/ 371900 h 540014"/>
              <a:gd name="connsiteX28" fmla="*/ 723464 w 797867"/>
              <a:gd name="connsiteY28" fmla="*/ 375573 h 540014"/>
              <a:gd name="connsiteX29" fmla="*/ 697758 w 797867"/>
              <a:gd name="connsiteY29" fmla="*/ 397607 h 540014"/>
              <a:gd name="connsiteX30" fmla="*/ 683069 w 797867"/>
              <a:gd name="connsiteY30" fmla="*/ 408623 h 540014"/>
              <a:gd name="connsiteX31" fmla="*/ 653690 w 797867"/>
              <a:gd name="connsiteY31" fmla="*/ 386590 h 540014"/>
              <a:gd name="connsiteX32" fmla="*/ 616967 w 797867"/>
              <a:gd name="connsiteY32" fmla="*/ 346194 h 540014"/>
              <a:gd name="connsiteX33" fmla="*/ 561883 w 797867"/>
              <a:gd name="connsiteY33" fmla="*/ 331505 h 540014"/>
              <a:gd name="connsiteX34" fmla="*/ 495782 w 797867"/>
              <a:gd name="connsiteY34" fmla="*/ 313144 h 540014"/>
              <a:gd name="connsiteX35" fmla="*/ 389285 w 797867"/>
              <a:gd name="connsiteY35" fmla="*/ 335178 h 540014"/>
              <a:gd name="connsiteX36" fmla="*/ 352563 w 797867"/>
              <a:gd name="connsiteY36" fmla="*/ 364556 h 540014"/>
              <a:gd name="connsiteX37" fmla="*/ 279117 w 797867"/>
              <a:gd name="connsiteY37" fmla="*/ 386590 h 540014"/>
              <a:gd name="connsiteX38" fmla="*/ 257083 w 797867"/>
              <a:gd name="connsiteY38" fmla="*/ 393934 h 540014"/>
              <a:gd name="connsiteX39" fmla="*/ 187310 w 797867"/>
              <a:gd name="connsiteY39" fmla="*/ 463708 h 540014"/>
              <a:gd name="connsiteX40" fmla="*/ 176293 w 797867"/>
              <a:gd name="connsiteY40" fmla="*/ 482069 h 540014"/>
              <a:gd name="connsiteX41" fmla="*/ 124881 w 797867"/>
              <a:gd name="connsiteY41" fmla="*/ 529809 h 540014"/>
              <a:gd name="connsiteX42" fmla="*/ 106519 w 797867"/>
              <a:gd name="connsiteY42" fmla="*/ 537154 h 540014"/>
              <a:gd name="connsiteX43" fmla="*/ 106519 w 797867"/>
              <a:gd name="connsiteY43" fmla="*/ 493086 h 540014"/>
              <a:gd name="connsiteX44" fmla="*/ 73469 w 797867"/>
              <a:gd name="connsiteY44" fmla="*/ 419640 h 54001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</a:cxnLst>
            <a:rect l="l" t="t" r="r" b="b"/>
            <a:pathLst>
              <a:path w="797867" h="540014">
                <a:moveTo>
                  <a:pt x="73469" y="419640"/>
                </a:moveTo>
                <a:cubicBezTo>
                  <a:pt x="80814" y="403727"/>
                  <a:pt x="131614" y="411684"/>
                  <a:pt x="150587" y="397607"/>
                </a:cubicBezTo>
                <a:cubicBezTo>
                  <a:pt x="169561" y="383530"/>
                  <a:pt x="179966" y="359048"/>
                  <a:pt x="187310" y="335178"/>
                </a:cubicBezTo>
                <a:cubicBezTo>
                  <a:pt x="194654" y="311308"/>
                  <a:pt x="201387" y="275197"/>
                  <a:pt x="194654" y="254387"/>
                </a:cubicBezTo>
                <a:cubicBezTo>
                  <a:pt x="187921" y="233577"/>
                  <a:pt x="179352" y="220725"/>
                  <a:pt x="146914" y="210320"/>
                </a:cubicBezTo>
                <a:cubicBezTo>
                  <a:pt x="114476" y="199915"/>
                  <a:pt x="1859" y="195630"/>
                  <a:pt x="23" y="191958"/>
                </a:cubicBezTo>
                <a:cubicBezTo>
                  <a:pt x="-1813" y="188286"/>
                  <a:pt x="103459" y="194407"/>
                  <a:pt x="135898" y="188286"/>
                </a:cubicBezTo>
                <a:cubicBezTo>
                  <a:pt x="168337" y="182165"/>
                  <a:pt x="184861" y="171760"/>
                  <a:pt x="194654" y="155235"/>
                </a:cubicBezTo>
                <a:cubicBezTo>
                  <a:pt x="204447" y="138710"/>
                  <a:pt x="202611" y="110556"/>
                  <a:pt x="194654" y="89134"/>
                </a:cubicBezTo>
                <a:cubicBezTo>
                  <a:pt x="186697" y="67712"/>
                  <a:pt x="155483" y="38334"/>
                  <a:pt x="146914" y="26705"/>
                </a:cubicBezTo>
                <a:cubicBezTo>
                  <a:pt x="138345" y="15076"/>
                  <a:pt x="138958" y="15077"/>
                  <a:pt x="143242" y="19361"/>
                </a:cubicBezTo>
                <a:cubicBezTo>
                  <a:pt x="147526" y="23645"/>
                  <a:pt x="156707" y="41394"/>
                  <a:pt x="172620" y="52411"/>
                </a:cubicBezTo>
                <a:cubicBezTo>
                  <a:pt x="188533" y="63428"/>
                  <a:pt x="216688" y="78117"/>
                  <a:pt x="238722" y="85462"/>
                </a:cubicBezTo>
                <a:cubicBezTo>
                  <a:pt x="260756" y="92807"/>
                  <a:pt x="280341" y="95255"/>
                  <a:pt x="304823" y="96479"/>
                </a:cubicBezTo>
                <a:cubicBezTo>
                  <a:pt x="329305" y="97703"/>
                  <a:pt x="354399" y="95255"/>
                  <a:pt x="385613" y="92807"/>
                </a:cubicBezTo>
                <a:cubicBezTo>
                  <a:pt x="416828" y="90359"/>
                  <a:pt x="462120" y="90971"/>
                  <a:pt x="492110" y="81790"/>
                </a:cubicBezTo>
                <a:cubicBezTo>
                  <a:pt x="522100" y="72609"/>
                  <a:pt x="545970" y="50575"/>
                  <a:pt x="565555" y="37722"/>
                </a:cubicBezTo>
                <a:cubicBezTo>
                  <a:pt x="585140" y="24869"/>
                  <a:pt x="599830" y="10792"/>
                  <a:pt x="609623" y="4672"/>
                </a:cubicBezTo>
                <a:cubicBezTo>
                  <a:pt x="619416" y="-1449"/>
                  <a:pt x="615743" y="-225"/>
                  <a:pt x="624312" y="999"/>
                </a:cubicBezTo>
                <a:cubicBezTo>
                  <a:pt x="632881" y="2223"/>
                  <a:pt x="658587" y="-837"/>
                  <a:pt x="661035" y="12016"/>
                </a:cubicBezTo>
                <a:cubicBezTo>
                  <a:pt x="663483" y="24869"/>
                  <a:pt x="643285" y="53023"/>
                  <a:pt x="639001" y="78117"/>
                </a:cubicBezTo>
                <a:cubicBezTo>
                  <a:pt x="634717" y="103211"/>
                  <a:pt x="635941" y="137486"/>
                  <a:pt x="635329" y="162580"/>
                </a:cubicBezTo>
                <a:cubicBezTo>
                  <a:pt x="634717" y="187674"/>
                  <a:pt x="631045" y="209096"/>
                  <a:pt x="635329" y="228681"/>
                </a:cubicBezTo>
                <a:cubicBezTo>
                  <a:pt x="639613" y="248266"/>
                  <a:pt x="650018" y="267240"/>
                  <a:pt x="661035" y="280093"/>
                </a:cubicBezTo>
                <a:cubicBezTo>
                  <a:pt x="672052" y="292946"/>
                  <a:pt x="683069" y="296618"/>
                  <a:pt x="701430" y="305799"/>
                </a:cubicBezTo>
                <a:cubicBezTo>
                  <a:pt x="719791" y="314980"/>
                  <a:pt x="755291" y="329058"/>
                  <a:pt x="771204" y="335178"/>
                </a:cubicBezTo>
                <a:cubicBezTo>
                  <a:pt x="787117" y="341298"/>
                  <a:pt x="801806" y="336402"/>
                  <a:pt x="796910" y="342522"/>
                </a:cubicBezTo>
                <a:cubicBezTo>
                  <a:pt x="792014" y="348642"/>
                  <a:pt x="754066" y="366391"/>
                  <a:pt x="741825" y="371900"/>
                </a:cubicBezTo>
                <a:cubicBezTo>
                  <a:pt x="729584" y="377409"/>
                  <a:pt x="730809" y="371288"/>
                  <a:pt x="723464" y="375573"/>
                </a:cubicBezTo>
                <a:cubicBezTo>
                  <a:pt x="716120" y="379857"/>
                  <a:pt x="704491" y="392099"/>
                  <a:pt x="697758" y="397607"/>
                </a:cubicBezTo>
                <a:cubicBezTo>
                  <a:pt x="691025" y="403115"/>
                  <a:pt x="690414" y="410459"/>
                  <a:pt x="683069" y="408623"/>
                </a:cubicBezTo>
                <a:cubicBezTo>
                  <a:pt x="675724" y="406787"/>
                  <a:pt x="664707" y="396995"/>
                  <a:pt x="653690" y="386590"/>
                </a:cubicBezTo>
                <a:cubicBezTo>
                  <a:pt x="642673" y="376185"/>
                  <a:pt x="632268" y="355375"/>
                  <a:pt x="616967" y="346194"/>
                </a:cubicBezTo>
                <a:cubicBezTo>
                  <a:pt x="601666" y="337013"/>
                  <a:pt x="561883" y="331505"/>
                  <a:pt x="561883" y="331505"/>
                </a:cubicBezTo>
                <a:cubicBezTo>
                  <a:pt x="541686" y="325997"/>
                  <a:pt x="524548" y="312532"/>
                  <a:pt x="495782" y="313144"/>
                </a:cubicBezTo>
                <a:cubicBezTo>
                  <a:pt x="467016" y="313756"/>
                  <a:pt x="413155" y="326609"/>
                  <a:pt x="389285" y="335178"/>
                </a:cubicBezTo>
                <a:cubicBezTo>
                  <a:pt x="365415" y="343747"/>
                  <a:pt x="370924" y="355987"/>
                  <a:pt x="352563" y="364556"/>
                </a:cubicBezTo>
                <a:cubicBezTo>
                  <a:pt x="334202" y="373125"/>
                  <a:pt x="295030" y="381694"/>
                  <a:pt x="279117" y="386590"/>
                </a:cubicBezTo>
                <a:cubicBezTo>
                  <a:pt x="263204" y="391486"/>
                  <a:pt x="272384" y="381081"/>
                  <a:pt x="257083" y="393934"/>
                </a:cubicBezTo>
                <a:cubicBezTo>
                  <a:pt x="241782" y="406787"/>
                  <a:pt x="200775" y="449019"/>
                  <a:pt x="187310" y="463708"/>
                </a:cubicBezTo>
                <a:cubicBezTo>
                  <a:pt x="173845" y="478397"/>
                  <a:pt x="186698" y="471052"/>
                  <a:pt x="176293" y="482069"/>
                </a:cubicBezTo>
                <a:cubicBezTo>
                  <a:pt x="165888" y="493086"/>
                  <a:pt x="136510" y="520628"/>
                  <a:pt x="124881" y="529809"/>
                </a:cubicBezTo>
                <a:cubicBezTo>
                  <a:pt x="113252" y="538990"/>
                  <a:pt x="109579" y="543275"/>
                  <a:pt x="106519" y="537154"/>
                </a:cubicBezTo>
                <a:cubicBezTo>
                  <a:pt x="103459" y="531034"/>
                  <a:pt x="110803" y="507775"/>
                  <a:pt x="106519" y="493086"/>
                </a:cubicBezTo>
                <a:cubicBezTo>
                  <a:pt x="102235" y="478397"/>
                  <a:pt x="66124" y="435553"/>
                  <a:pt x="73469" y="419640"/>
                </a:cubicBezTo>
                <a:close/>
              </a:path>
            </a:pathLst>
          </a:custGeom>
          <a:noFill/>
          <a:ln w="28575">
            <a:solidFill>
              <a:srgbClr val="E89418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Straight Arrow Connector 21"/>
          <p:cNvCxnSpPr/>
          <p:nvPr/>
        </p:nvCxnSpPr>
        <p:spPr>
          <a:xfrm flipH="1">
            <a:off x="4493652" y="1741608"/>
            <a:ext cx="323882" cy="2213316"/>
          </a:xfrm>
          <a:prstGeom prst="straightConnector1">
            <a:avLst/>
          </a:prstGeom>
          <a:ln>
            <a:solidFill>
              <a:schemeClr val="accent6">
                <a:lumMod val="20000"/>
                <a:lumOff val="8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/>
          <p:cNvCxnSpPr/>
          <p:nvPr/>
        </p:nvCxnSpPr>
        <p:spPr>
          <a:xfrm>
            <a:off x="4225640" y="2956979"/>
            <a:ext cx="176481" cy="1888015"/>
          </a:xfrm>
          <a:prstGeom prst="straightConnector1">
            <a:avLst/>
          </a:prstGeom>
          <a:ln>
            <a:solidFill>
              <a:schemeClr val="accent6">
                <a:lumMod val="20000"/>
                <a:lumOff val="8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Rectangle 23"/>
          <p:cNvSpPr/>
          <p:nvPr/>
        </p:nvSpPr>
        <p:spPr>
          <a:xfrm>
            <a:off x="3333341" y="2587647"/>
            <a:ext cx="17178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renchyma cell</a:t>
            </a:r>
            <a:endParaRPr lang="en-US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5" name="Straight Arrow Connector 24"/>
          <p:cNvCxnSpPr/>
          <p:nvPr/>
        </p:nvCxnSpPr>
        <p:spPr>
          <a:xfrm flipH="1" flipV="1">
            <a:off x="2909940" y="4867424"/>
            <a:ext cx="89186" cy="71221"/>
          </a:xfrm>
          <a:prstGeom prst="straightConnector1">
            <a:avLst/>
          </a:prstGeom>
          <a:ln>
            <a:solidFill>
              <a:schemeClr val="accent6">
                <a:lumMod val="20000"/>
                <a:lumOff val="8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2979033" y="4326255"/>
            <a:ext cx="9090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400" baseline="300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d</a:t>
            </a:r>
            <a:r>
              <a:rPr lang="en-US" sz="14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CW</a:t>
            </a:r>
            <a:endParaRPr lang="en-US" sz="14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7" name="Straight Arrow Connector 26"/>
          <p:cNvCxnSpPr/>
          <p:nvPr/>
        </p:nvCxnSpPr>
        <p:spPr>
          <a:xfrm flipH="1">
            <a:off x="2941744" y="4484459"/>
            <a:ext cx="26102" cy="17635"/>
          </a:xfrm>
          <a:prstGeom prst="straightConnector1">
            <a:avLst/>
          </a:prstGeom>
          <a:ln>
            <a:solidFill>
              <a:schemeClr val="accent6">
                <a:lumMod val="20000"/>
                <a:lumOff val="8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/>
          <p:cNvCxnSpPr/>
          <p:nvPr/>
        </p:nvCxnSpPr>
        <p:spPr>
          <a:xfrm flipH="1" flipV="1">
            <a:off x="3036994" y="4292544"/>
            <a:ext cx="8872" cy="60277"/>
          </a:xfrm>
          <a:prstGeom prst="straightConnector1">
            <a:avLst/>
          </a:prstGeom>
          <a:ln>
            <a:solidFill>
              <a:schemeClr val="accent6">
                <a:lumMod val="20000"/>
                <a:lumOff val="8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2836158" y="4897755"/>
            <a:ext cx="9090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sz="1600" baseline="300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</a:t>
            </a:r>
            <a:r>
              <a:rPr lang="en-US" sz="16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CW</a:t>
            </a:r>
            <a:endParaRPr lang="en-US" sz="1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Rectangle 29"/>
          <p:cNvSpPr/>
          <p:nvPr/>
        </p:nvSpPr>
        <p:spPr>
          <a:xfrm>
            <a:off x="4478412" y="1710251"/>
            <a:ext cx="196310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lerenchyma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ber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135630" y="3231109"/>
            <a:ext cx="3230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2" name="Straight Arrow Connector 31"/>
          <p:cNvCxnSpPr/>
          <p:nvPr/>
        </p:nvCxnSpPr>
        <p:spPr>
          <a:xfrm flipH="1">
            <a:off x="4478747" y="1978461"/>
            <a:ext cx="380283" cy="1976463"/>
          </a:xfrm>
          <a:prstGeom prst="straightConnector1">
            <a:avLst/>
          </a:prstGeom>
          <a:ln>
            <a:solidFill>
              <a:schemeClr val="accent6">
                <a:lumMod val="20000"/>
                <a:lumOff val="8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32"/>
          <p:cNvCxnSpPr/>
          <p:nvPr/>
        </p:nvCxnSpPr>
        <p:spPr>
          <a:xfrm flipH="1">
            <a:off x="3074283" y="3445986"/>
            <a:ext cx="91440" cy="91440"/>
          </a:xfrm>
          <a:prstGeom prst="straightConnector1">
            <a:avLst/>
          </a:prstGeom>
          <a:ln>
            <a:solidFill>
              <a:schemeClr val="accent6">
                <a:lumMod val="20000"/>
                <a:lumOff val="8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/>
          <p:cNvCxnSpPr/>
          <p:nvPr/>
        </p:nvCxnSpPr>
        <p:spPr>
          <a:xfrm>
            <a:off x="3420595" y="3425300"/>
            <a:ext cx="91440" cy="91440"/>
          </a:xfrm>
          <a:prstGeom prst="straightConnector1">
            <a:avLst/>
          </a:prstGeom>
          <a:ln>
            <a:solidFill>
              <a:schemeClr val="accent6">
                <a:lumMod val="20000"/>
                <a:lumOff val="8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189982" y="7548359"/>
            <a:ext cx="6532092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.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istological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ining for lignin deposition. C: cortex ; CW: cell wall;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phloem; X: xylem; VS: vascular sheath cell; XP: xylem parenchyma cell; XT: xylem tracheid; XV: xylem vessels.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cale bar: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µm.  </a:t>
            </a:r>
          </a:p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dirty="0">
              <a:latin typeface="Times New Roman" panose="02020603050405020304" pitchFamily="18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cxnSp>
        <p:nvCxnSpPr>
          <p:cNvPr id="36" name="Straight Connector 35"/>
          <p:cNvCxnSpPr/>
          <p:nvPr/>
        </p:nvCxnSpPr>
        <p:spPr>
          <a:xfrm>
            <a:off x="595592" y="6515871"/>
            <a:ext cx="4572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263737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eme1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Theme1" id="{DE44A51C-D1B0-482C-B324-D50EC1267CD6}" vid="{E0F5F23E-BF44-4198-A1CE-F44931E0B072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Theme1</Template>
  <TotalTime>4660</TotalTime>
  <Words>638</Words>
  <Application>Microsoft Macintosh PowerPoint</Application>
  <PresentationFormat>On-screen Show (4:3)</PresentationFormat>
  <Paragraphs>74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Theme1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The Samuel Roberts Noble Foundatio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rk, Jongjin</dc:creator>
  <cp:lastModifiedBy>Zengyu Wang</cp:lastModifiedBy>
  <cp:revision>158</cp:revision>
  <cp:lastPrinted>2017-06-12T23:54:06Z</cp:lastPrinted>
  <dcterms:created xsi:type="dcterms:W3CDTF">2016-07-07T14:22:10Z</dcterms:created>
  <dcterms:modified xsi:type="dcterms:W3CDTF">2017-06-13T11:56:09Z</dcterms:modified>
</cp:coreProperties>
</file>